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7" d="100"/>
          <a:sy n="87" d="100"/>
        </p:scale>
        <p:origin x="1476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FD86A60-47D7-48CA-8446-CC3F8FB262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6254C527-636D-4F09-8E3A-69830EBC36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77EAD01-DFA0-4B83-9C1B-8E18A8549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D71ECE8-0A6D-4838-95EF-1A37B77EA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EA0CBE2-6A35-407E-BC1B-7F96C3C86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568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660D516-EB71-4F9C-A99A-53B09B606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2629921-0A85-4936-AD56-60066B97C8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FF5E32B-490C-4270-908A-5E978C8C5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B06A7CE-EAB1-492D-9265-A11C442A1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51B3D3-ED78-47B8-9584-2E317DC49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294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4B4AA758-01BE-4DA0-A7C3-60D2492215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AD324551-1E40-4FF7-B6C5-9E5524E771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FD43956-9B6C-4011-8837-A4F9CB9A0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36D05BF-43FF-4BAE-9B78-3183A5889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0D3529B-3117-4E95-92D2-9E842AA00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51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CDA7388-F9E3-4037-BC58-E7751422E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A0B6B09-F1DA-4D85-A02D-FC6D266CA5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42E6A35-37DF-4E12-9D5B-D76B6DFF9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3A8FE6C-90C9-44BA-8BB3-4BBBFE650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D3AF03D-408B-4634-92A7-AC1459CBC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255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8592736-3D22-428B-BB2D-B9E0862C3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B4AC747-DFF4-4503-A0B4-933650099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38027BA-C21E-4BC9-A7E9-2806DAB0C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3DF46EC-3325-43EF-AD09-71B4862C9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6461311-C032-4BAE-A350-D1FCFCE32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4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3DC4C3A-713B-4F4C-9075-DFA525EAF2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2FF7A93-18B3-455B-BB28-A12A46849C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639E79DA-032C-4831-84F6-99B71DCA80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3EF4BDD-9A48-4B15-9F04-0A2EB7D61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16C6E55-204D-4757-A811-E9A5673B2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7B569AD-1510-4BDA-8597-47F36D1B1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924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D3993A8-1E4E-4458-8C19-F7AB86499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5094C62-7410-4E59-B6E9-CA95F21D8B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1FC2EF9-CED5-4514-AB63-20C7251FCA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FA516B2A-17F1-4884-AE8D-39EFC80EAC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F5365771-053D-4400-8192-85C3249BCD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2AAE421F-789B-47FC-B5AB-243821C92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41F9C741-7D63-42D6-9876-82577A698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9F39B987-9547-460D-87CC-42A61683B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097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D43A768-35ED-4E45-A4C4-B622C103E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910838D0-1FAA-40F9-9A60-D7FC38734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121F30E4-1F15-4781-896C-594C55DFF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F3D96E58-9D1B-4B15-A147-4F42733E8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325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4576F9BD-F849-478E-9565-A2BCBB827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10722B3F-D12C-4047-B125-CDEDBBD5F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BBEDC8A2-4C53-47E7-8714-4488C5412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661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E8EF655-72C9-4501-9190-37B715F4D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7C25436-604C-4275-8C5E-EF41F66577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37722E48-301E-44CF-A0D4-2BDC6C3473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A1E2341-5558-4134-97EB-0F910D1FC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BAF2382-4BFA-46CB-9890-9DF688FF5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FE2DB8E8-29D3-4B39-8D5E-50B1EE4E2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555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6F3AED6-1703-4BFD-8391-94385F112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32CDC6E1-104E-4BCB-A4F4-0981917A07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7DBDB29-FE82-4A6C-8830-EC372FB9A6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FE1E184-D1AB-4A87-8D15-5DE8389EF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450EAD9-7E94-41C6-A80F-152CA0A77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D01BE79F-402D-43F3-AE20-1CFE28ECD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647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7663E448-F3B4-4E7B-8947-8DCD0A24C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5907378-15F0-4E02-9FB4-5D4923038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E6322F6-C0F8-48F4-9803-0A7BE5F78B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60919-96A1-4066-9998-9BE43F448F6A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5A83E00-1706-487E-A0AE-7D85A5914C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94293C5-E11D-4F86-A390-33E0FE349C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97065-BF1A-4F07-A4F4-1DCB9A8095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545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11" Type="http://schemas.openxmlformats.org/officeDocument/2006/relationships/oleObject" Target="../embeddings/oleObject1.bin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="" xmlns:a16="http://schemas.microsoft.com/office/drawing/2014/main" id="{8712A4F4-1B1E-483E-AEE9-AF158C0BAA6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7593" y="1253686"/>
            <a:ext cx="1950719" cy="14630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ABFA082D-9823-483E-B764-B9B0BBEC528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653" y="1249160"/>
            <a:ext cx="1950720" cy="14630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B39AA4A9-E297-4FAB-8F74-E18506A2214B}"/>
              </a:ext>
            </a:extLst>
          </p:cNvPr>
          <p:cNvSpPr txBox="1"/>
          <p:nvPr/>
        </p:nvSpPr>
        <p:spPr>
          <a:xfrm>
            <a:off x="642099" y="511580"/>
            <a:ext cx="1747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 vehicl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27672CAE-F606-428E-8808-E938FA99EF6D}"/>
              </a:ext>
            </a:extLst>
          </p:cNvPr>
          <p:cNvSpPr txBox="1"/>
          <p:nvPr/>
        </p:nvSpPr>
        <p:spPr>
          <a:xfrm rot="16200000">
            <a:off x="-58786" y="1643479"/>
            <a:ext cx="7285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BF926BF2-B318-48EA-8CFD-D42AACC31D1A}"/>
              </a:ext>
            </a:extLst>
          </p:cNvPr>
          <p:cNvSpPr txBox="1"/>
          <p:nvPr/>
        </p:nvSpPr>
        <p:spPr>
          <a:xfrm rot="16200000">
            <a:off x="-113918" y="3232872"/>
            <a:ext cx="8173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8 h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="" xmlns:a16="http://schemas.microsoft.com/office/drawing/2014/main" id="{29B7F0D5-6EFA-4952-9838-A5575C9EE4A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1236" y="1249161"/>
            <a:ext cx="1950720" cy="146304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7DAF91DD-4054-446E-BBE2-24D50122F8A2}"/>
              </a:ext>
            </a:extLst>
          </p:cNvPr>
          <p:cNvSpPr txBox="1"/>
          <p:nvPr/>
        </p:nvSpPr>
        <p:spPr>
          <a:xfrm>
            <a:off x="2490442" y="514281"/>
            <a:ext cx="2111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bbistat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0656F4B1-C620-469C-BE7E-F138361FF136}"/>
              </a:ext>
            </a:extLst>
          </p:cNvPr>
          <p:cNvSpPr txBox="1"/>
          <p:nvPr/>
        </p:nvSpPr>
        <p:spPr>
          <a:xfrm>
            <a:off x="6247412" y="522852"/>
            <a:ext cx="24307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1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bbistat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="" xmlns:a16="http://schemas.microsoft.com/office/drawing/2014/main" id="{9BF02C83-39E4-4DE2-8B78-C2CA65210E2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0278" y="2821770"/>
            <a:ext cx="1950720" cy="14630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="" xmlns:a16="http://schemas.microsoft.com/office/drawing/2014/main" id="{EBD396AB-F786-47E1-8FDB-EF136DD3998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526" y="2823201"/>
            <a:ext cx="1950720" cy="146304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="" xmlns:a16="http://schemas.microsoft.com/office/drawing/2014/main" id="{C3497C1C-7005-4F02-9395-C616D20DBD3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3016" y="2811482"/>
            <a:ext cx="1950719" cy="146304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="" xmlns:a16="http://schemas.microsoft.com/office/drawing/2014/main" id="{F630E7F2-0D72-4B42-8212-CF220BB8A164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3704" y="2811480"/>
            <a:ext cx="1950719" cy="146304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4B1B9706-269D-4DE1-AD24-794C9F9BC775}"/>
              </a:ext>
            </a:extLst>
          </p:cNvPr>
          <p:cNvSpPr txBox="1"/>
          <p:nvPr/>
        </p:nvSpPr>
        <p:spPr>
          <a:xfrm>
            <a:off x="4544576" y="511580"/>
            <a:ext cx="18883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1, vehicl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="" xmlns:a16="http://schemas.microsoft.com/office/drawing/2014/main" id="{36F5C155-FCAE-472E-B812-1DC67D48916A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4570" y="1249688"/>
            <a:ext cx="1950720" cy="1463040"/>
          </a:xfrm>
          <a:prstGeom prst="rect">
            <a:avLst/>
          </a:prstGeom>
        </p:spPr>
      </p:pic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AAC251BA-348D-43BE-BF6F-E2FF60874C7C}"/>
              </a:ext>
            </a:extLst>
          </p:cNvPr>
          <p:cNvCxnSpPr>
            <a:cxnSpLocks/>
          </p:cNvCxnSpPr>
          <p:nvPr/>
        </p:nvCxnSpPr>
        <p:spPr>
          <a:xfrm>
            <a:off x="819888" y="1270234"/>
            <a:ext cx="0" cy="1427134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28AA9A0E-2D73-46B8-B4BD-82F3D0F70331}"/>
              </a:ext>
            </a:extLst>
          </p:cNvPr>
          <p:cNvCxnSpPr>
            <a:cxnSpLocks/>
          </p:cNvCxnSpPr>
          <p:nvPr/>
        </p:nvCxnSpPr>
        <p:spPr>
          <a:xfrm>
            <a:off x="2154332" y="1275233"/>
            <a:ext cx="5807" cy="1441193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0069BD48-9853-41F2-9114-F712F1226F38}"/>
              </a:ext>
            </a:extLst>
          </p:cNvPr>
          <p:cNvCxnSpPr>
            <a:cxnSpLocks/>
          </p:cNvCxnSpPr>
          <p:nvPr/>
        </p:nvCxnSpPr>
        <p:spPr>
          <a:xfrm>
            <a:off x="2714949" y="1275211"/>
            <a:ext cx="0" cy="1427134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6368DCCD-AE2B-4549-A0DC-0F70165AFB42}"/>
              </a:ext>
            </a:extLst>
          </p:cNvPr>
          <p:cNvCxnSpPr>
            <a:cxnSpLocks/>
          </p:cNvCxnSpPr>
          <p:nvPr/>
        </p:nvCxnSpPr>
        <p:spPr>
          <a:xfrm>
            <a:off x="4180963" y="1267048"/>
            <a:ext cx="4799" cy="1441193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DD39C3A2-D798-4ECE-B130-C65CE4FBAD04}"/>
              </a:ext>
            </a:extLst>
          </p:cNvPr>
          <p:cNvCxnSpPr>
            <a:cxnSpLocks/>
          </p:cNvCxnSpPr>
          <p:nvPr/>
        </p:nvCxnSpPr>
        <p:spPr>
          <a:xfrm>
            <a:off x="4763724" y="1268933"/>
            <a:ext cx="0" cy="1427134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2ACA66FD-3F60-4E71-81BA-AD83EF225E8D}"/>
              </a:ext>
            </a:extLst>
          </p:cNvPr>
          <p:cNvCxnSpPr>
            <a:cxnSpLocks/>
          </p:cNvCxnSpPr>
          <p:nvPr/>
        </p:nvCxnSpPr>
        <p:spPr>
          <a:xfrm>
            <a:off x="6197335" y="1246794"/>
            <a:ext cx="4799" cy="1441193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16310681-AA8F-4CDE-A9B0-066F035740F1}"/>
              </a:ext>
            </a:extLst>
          </p:cNvPr>
          <p:cNvCxnSpPr>
            <a:cxnSpLocks/>
          </p:cNvCxnSpPr>
          <p:nvPr/>
        </p:nvCxnSpPr>
        <p:spPr>
          <a:xfrm>
            <a:off x="6644846" y="1267048"/>
            <a:ext cx="0" cy="1427134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251049F9-B4CA-4409-A825-31759541D52A}"/>
              </a:ext>
            </a:extLst>
          </p:cNvPr>
          <p:cNvCxnSpPr>
            <a:cxnSpLocks/>
          </p:cNvCxnSpPr>
          <p:nvPr/>
        </p:nvCxnSpPr>
        <p:spPr>
          <a:xfrm>
            <a:off x="8293461" y="1258345"/>
            <a:ext cx="4799" cy="1441193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Freeform: Shape 38">
            <a:extLst>
              <a:ext uri="{FF2B5EF4-FFF2-40B4-BE49-F238E27FC236}">
                <a16:creationId xmlns="" xmlns:a16="http://schemas.microsoft.com/office/drawing/2014/main" id="{1641D617-AD99-4946-84D6-0A54CD9DE6B6}"/>
              </a:ext>
            </a:extLst>
          </p:cNvPr>
          <p:cNvSpPr/>
          <p:nvPr/>
        </p:nvSpPr>
        <p:spPr>
          <a:xfrm>
            <a:off x="1182849" y="2853629"/>
            <a:ext cx="304800" cy="1431181"/>
          </a:xfrm>
          <a:custGeom>
            <a:avLst/>
            <a:gdLst>
              <a:gd name="connsiteX0" fmla="*/ 118783 w 304800"/>
              <a:gd name="connsiteY0" fmla="*/ 0 h 2075329"/>
              <a:gd name="connsiteX1" fmla="*/ 105336 w 304800"/>
              <a:gd name="connsiteY1" fmla="*/ 20171 h 2075329"/>
              <a:gd name="connsiteX2" fmla="*/ 91889 w 304800"/>
              <a:gd name="connsiteY2" fmla="*/ 38100 h 2075329"/>
              <a:gd name="connsiteX3" fmla="*/ 85165 w 304800"/>
              <a:gd name="connsiteY3" fmla="*/ 47065 h 2075329"/>
              <a:gd name="connsiteX4" fmla="*/ 76200 w 304800"/>
              <a:gd name="connsiteY4" fmla="*/ 58271 h 2075329"/>
              <a:gd name="connsiteX5" fmla="*/ 71718 w 304800"/>
              <a:gd name="connsiteY5" fmla="*/ 64994 h 2075329"/>
              <a:gd name="connsiteX6" fmla="*/ 62753 w 304800"/>
              <a:gd name="connsiteY6" fmla="*/ 80682 h 2075329"/>
              <a:gd name="connsiteX7" fmla="*/ 51547 w 304800"/>
              <a:gd name="connsiteY7" fmla="*/ 96371 h 2075329"/>
              <a:gd name="connsiteX8" fmla="*/ 51547 w 304800"/>
              <a:gd name="connsiteY8" fmla="*/ 179294 h 2075329"/>
              <a:gd name="connsiteX9" fmla="*/ 58271 w 304800"/>
              <a:gd name="connsiteY9" fmla="*/ 188259 h 2075329"/>
              <a:gd name="connsiteX10" fmla="*/ 80683 w 304800"/>
              <a:gd name="connsiteY10" fmla="*/ 221876 h 2075329"/>
              <a:gd name="connsiteX11" fmla="*/ 116541 w 304800"/>
              <a:gd name="connsiteY11" fmla="*/ 262218 h 2075329"/>
              <a:gd name="connsiteX12" fmla="*/ 121024 w 304800"/>
              <a:gd name="connsiteY12" fmla="*/ 277906 h 2075329"/>
              <a:gd name="connsiteX13" fmla="*/ 127747 w 304800"/>
              <a:gd name="connsiteY13" fmla="*/ 293594 h 2075329"/>
              <a:gd name="connsiteX14" fmla="*/ 132230 w 304800"/>
              <a:gd name="connsiteY14" fmla="*/ 320488 h 2075329"/>
              <a:gd name="connsiteX15" fmla="*/ 136712 w 304800"/>
              <a:gd name="connsiteY15" fmla="*/ 333935 h 2075329"/>
              <a:gd name="connsiteX16" fmla="*/ 141194 w 304800"/>
              <a:gd name="connsiteY16" fmla="*/ 374276 h 2075329"/>
              <a:gd name="connsiteX17" fmla="*/ 125506 w 304800"/>
              <a:gd name="connsiteY17" fmla="*/ 506506 h 2075329"/>
              <a:gd name="connsiteX18" fmla="*/ 107577 w 304800"/>
              <a:gd name="connsiteY18" fmla="*/ 537882 h 2075329"/>
              <a:gd name="connsiteX19" fmla="*/ 103094 w 304800"/>
              <a:gd name="connsiteY19" fmla="*/ 544606 h 2075329"/>
              <a:gd name="connsiteX20" fmla="*/ 100853 w 304800"/>
              <a:gd name="connsiteY20" fmla="*/ 560294 h 2075329"/>
              <a:gd name="connsiteX21" fmla="*/ 94130 w 304800"/>
              <a:gd name="connsiteY21" fmla="*/ 573741 h 2075329"/>
              <a:gd name="connsiteX22" fmla="*/ 87406 w 304800"/>
              <a:gd name="connsiteY22" fmla="*/ 589429 h 2075329"/>
              <a:gd name="connsiteX23" fmla="*/ 85165 w 304800"/>
              <a:gd name="connsiteY23" fmla="*/ 598394 h 2075329"/>
              <a:gd name="connsiteX24" fmla="*/ 73959 w 304800"/>
              <a:gd name="connsiteY24" fmla="*/ 640976 h 2075329"/>
              <a:gd name="connsiteX25" fmla="*/ 71718 w 304800"/>
              <a:gd name="connsiteY25" fmla="*/ 822512 h 2075329"/>
              <a:gd name="connsiteX26" fmla="*/ 80683 w 304800"/>
              <a:gd name="connsiteY26" fmla="*/ 833718 h 2075329"/>
              <a:gd name="connsiteX27" fmla="*/ 87406 w 304800"/>
              <a:gd name="connsiteY27" fmla="*/ 851647 h 2075329"/>
              <a:gd name="connsiteX28" fmla="*/ 112059 w 304800"/>
              <a:gd name="connsiteY28" fmla="*/ 880782 h 2075329"/>
              <a:gd name="connsiteX29" fmla="*/ 123265 w 304800"/>
              <a:gd name="connsiteY29" fmla="*/ 887506 h 2075329"/>
              <a:gd name="connsiteX30" fmla="*/ 156883 w 304800"/>
              <a:gd name="connsiteY30" fmla="*/ 905435 h 2075329"/>
              <a:gd name="connsiteX31" fmla="*/ 190500 w 304800"/>
              <a:gd name="connsiteY31" fmla="*/ 943535 h 2075329"/>
              <a:gd name="connsiteX32" fmla="*/ 206189 w 304800"/>
              <a:gd name="connsiteY32" fmla="*/ 965947 h 2075329"/>
              <a:gd name="connsiteX33" fmla="*/ 224118 w 304800"/>
              <a:gd name="connsiteY33" fmla="*/ 986118 h 2075329"/>
              <a:gd name="connsiteX34" fmla="*/ 248771 w 304800"/>
              <a:gd name="connsiteY34" fmla="*/ 1013012 h 2075329"/>
              <a:gd name="connsiteX35" fmla="*/ 262218 w 304800"/>
              <a:gd name="connsiteY35" fmla="*/ 1035424 h 2075329"/>
              <a:gd name="connsiteX36" fmla="*/ 275665 w 304800"/>
              <a:gd name="connsiteY36" fmla="*/ 1060076 h 2075329"/>
              <a:gd name="connsiteX37" fmla="*/ 289112 w 304800"/>
              <a:gd name="connsiteY37" fmla="*/ 1100418 h 2075329"/>
              <a:gd name="connsiteX38" fmla="*/ 300318 w 304800"/>
              <a:gd name="connsiteY38" fmla="*/ 1143000 h 2075329"/>
              <a:gd name="connsiteX39" fmla="*/ 304800 w 304800"/>
              <a:gd name="connsiteY39" fmla="*/ 1158688 h 2075329"/>
              <a:gd name="connsiteX40" fmla="*/ 300318 w 304800"/>
              <a:gd name="connsiteY40" fmla="*/ 1239371 h 2075329"/>
              <a:gd name="connsiteX41" fmla="*/ 291353 w 304800"/>
              <a:gd name="connsiteY41" fmla="*/ 1257300 h 2075329"/>
              <a:gd name="connsiteX42" fmla="*/ 289112 w 304800"/>
              <a:gd name="connsiteY42" fmla="*/ 1266265 h 2075329"/>
              <a:gd name="connsiteX43" fmla="*/ 282389 w 304800"/>
              <a:gd name="connsiteY43" fmla="*/ 1279712 h 2075329"/>
              <a:gd name="connsiteX44" fmla="*/ 275665 w 304800"/>
              <a:gd name="connsiteY44" fmla="*/ 1295400 h 2075329"/>
              <a:gd name="connsiteX45" fmla="*/ 264459 w 304800"/>
              <a:gd name="connsiteY45" fmla="*/ 1308847 h 2075329"/>
              <a:gd name="connsiteX46" fmla="*/ 255494 w 304800"/>
              <a:gd name="connsiteY46" fmla="*/ 1324535 h 2075329"/>
              <a:gd name="connsiteX47" fmla="*/ 248771 w 304800"/>
              <a:gd name="connsiteY47" fmla="*/ 1333500 h 2075329"/>
              <a:gd name="connsiteX48" fmla="*/ 230841 w 304800"/>
              <a:gd name="connsiteY48" fmla="*/ 1360394 h 2075329"/>
              <a:gd name="connsiteX49" fmla="*/ 210671 w 304800"/>
              <a:gd name="connsiteY49" fmla="*/ 1385047 h 2075329"/>
              <a:gd name="connsiteX50" fmla="*/ 192741 w 304800"/>
              <a:gd name="connsiteY50" fmla="*/ 1414182 h 2075329"/>
              <a:gd name="connsiteX51" fmla="*/ 183777 w 304800"/>
              <a:gd name="connsiteY51" fmla="*/ 1420906 h 2075329"/>
              <a:gd name="connsiteX52" fmla="*/ 168089 w 304800"/>
              <a:gd name="connsiteY52" fmla="*/ 1441076 h 2075329"/>
              <a:gd name="connsiteX53" fmla="*/ 156883 w 304800"/>
              <a:gd name="connsiteY53" fmla="*/ 1454524 h 2075329"/>
              <a:gd name="connsiteX54" fmla="*/ 152400 w 304800"/>
              <a:gd name="connsiteY54" fmla="*/ 1459006 h 2075329"/>
              <a:gd name="connsiteX55" fmla="*/ 136712 w 304800"/>
              <a:gd name="connsiteY55" fmla="*/ 1479176 h 2075329"/>
              <a:gd name="connsiteX56" fmla="*/ 125506 w 304800"/>
              <a:gd name="connsiteY56" fmla="*/ 1494865 h 2075329"/>
              <a:gd name="connsiteX57" fmla="*/ 116541 w 304800"/>
              <a:gd name="connsiteY57" fmla="*/ 1510553 h 2075329"/>
              <a:gd name="connsiteX58" fmla="*/ 100853 w 304800"/>
              <a:gd name="connsiteY58" fmla="*/ 1539688 h 2075329"/>
              <a:gd name="connsiteX59" fmla="*/ 94130 w 304800"/>
              <a:gd name="connsiteY59" fmla="*/ 1557618 h 2075329"/>
              <a:gd name="connsiteX60" fmla="*/ 85165 w 304800"/>
              <a:gd name="connsiteY60" fmla="*/ 1584512 h 2075329"/>
              <a:gd name="connsiteX61" fmla="*/ 80683 w 304800"/>
              <a:gd name="connsiteY61" fmla="*/ 1606924 h 2075329"/>
              <a:gd name="connsiteX62" fmla="*/ 69477 w 304800"/>
              <a:gd name="connsiteY62" fmla="*/ 1622612 h 2075329"/>
              <a:gd name="connsiteX63" fmla="*/ 49306 w 304800"/>
              <a:gd name="connsiteY63" fmla="*/ 1662953 h 2075329"/>
              <a:gd name="connsiteX64" fmla="*/ 44824 w 304800"/>
              <a:gd name="connsiteY64" fmla="*/ 1678641 h 2075329"/>
              <a:gd name="connsiteX65" fmla="*/ 33618 w 304800"/>
              <a:gd name="connsiteY65" fmla="*/ 1698812 h 2075329"/>
              <a:gd name="connsiteX66" fmla="*/ 26894 w 304800"/>
              <a:gd name="connsiteY66" fmla="*/ 1721224 h 2075329"/>
              <a:gd name="connsiteX67" fmla="*/ 20171 w 304800"/>
              <a:gd name="connsiteY67" fmla="*/ 1754841 h 2075329"/>
              <a:gd name="connsiteX68" fmla="*/ 13447 w 304800"/>
              <a:gd name="connsiteY68" fmla="*/ 1770529 h 2075329"/>
              <a:gd name="connsiteX69" fmla="*/ 11206 w 304800"/>
              <a:gd name="connsiteY69" fmla="*/ 1779494 h 2075329"/>
              <a:gd name="connsiteX70" fmla="*/ 4483 w 304800"/>
              <a:gd name="connsiteY70" fmla="*/ 1799665 h 2075329"/>
              <a:gd name="connsiteX71" fmla="*/ 0 w 304800"/>
              <a:gd name="connsiteY71" fmla="*/ 1831041 h 2075329"/>
              <a:gd name="connsiteX72" fmla="*/ 4483 w 304800"/>
              <a:gd name="connsiteY72" fmla="*/ 2012576 h 2075329"/>
              <a:gd name="connsiteX73" fmla="*/ 13447 w 304800"/>
              <a:gd name="connsiteY73" fmla="*/ 2034988 h 2075329"/>
              <a:gd name="connsiteX74" fmla="*/ 22412 w 304800"/>
              <a:gd name="connsiteY74" fmla="*/ 2048435 h 2075329"/>
              <a:gd name="connsiteX75" fmla="*/ 31377 w 304800"/>
              <a:gd name="connsiteY75" fmla="*/ 2061882 h 2075329"/>
              <a:gd name="connsiteX76" fmla="*/ 42583 w 304800"/>
              <a:gd name="connsiteY76" fmla="*/ 2075329 h 20753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</a:cxnLst>
            <a:rect l="l" t="t" r="r" b="b"/>
            <a:pathLst>
              <a:path w="304800" h="2075329">
                <a:moveTo>
                  <a:pt x="118783" y="0"/>
                </a:moveTo>
                <a:cubicBezTo>
                  <a:pt x="88768" y="37518"/>
                  <a:pt x="125202" y="-9628"/>
                  <a:pt x="105336" y="20171"/>
                </a:cubicBezTo>
                <a:cubicBezTo>
                  <a:pt x="101192" y="26387"/>
                  <a:pt x="96371" y="32124"/>
                  <a:pt x="91889" y="38100"/>
                </a:cubicBezTo>
                <a:cubicBezTo>
                  <a:pt x="89648" y="41088"/>
                  <a:pt x="87458" y="44116"/>
                  <a:pt x="85165" y="47065"/>
                </a:cubicBezTo>
                <a:cubicBezTo>
                  <a:pt x="82228" y="50841"/>
                  <a:pt x="78853" y="54291"/>
                  <a:pt x="76200" y="58271"/>
                </a:cubicBezTo>
                <a:cubicBezTo>
                  <a:pt x="74706" y="60512"/>
                  <a:pt x="73104" y="62684"/>
                  <a:pt x="71718" y="64994"/>
                </a:cubicBezTo>
                <a:cubicBezTo>
                  <a:pt x="68619" y="70159"/>
                  <a:pt x="66010" y="75616"/>
                  <a:pt x="62753" y="80682"/>
                </a:cubicBezTo>
                <a:cubicBezTo>
                  <a:pt x="59278" y="86088"/>
                  <a:pt x="55282" y="91141"/>
                  <a:pt x="51547" y="96371"/>
                </a:cubicBezTo>
                <a:cubicBezTo>
                  <a:pt x="41829" y="130388"/>
                  <a:pt x="42847" y="120132"/>
                  <a:pt x="51547" y="179294"/>
                </a:cubicBezTo>
                <a:cubicBezTo>
                  <a:pt x="52090" y="182990"/>
                  <a:pt x="56162" y="185176"/>
                  <a:pt x="58271" y="188259"/>
                </a:cubicBezTo>
                <a:cubicBezTo>
                  <a:pt x="65876" y="199374"/>
                  <a:pt x="71984" y="211595"/>
                  <a:pt x="80683" y="221876"/>
                </a:cubicBezTo>
                <a:cubicBezTo>
                  <a:pt x="108748" y="255044"/>
                  <a:pt x="96340" y="242016"/>
                  <a:pt x="116541" y="262218"/>
                </a:cubicBezTo>
                <a:cubicBezTo>
                  <a:pt x="118035" y="267447"/>
                  <a:pt x="119195" y="272784"/>
                  <a:pt x="121024" y="277906"/>
                </a:cubicBezTo>
                <a:cubicBezTo>
                  <a:pt x="122938" y="283264"/>
                  <a:pt x="126299" y="288092"/>
                  <a:pt x="127747" y="293594"/>
                </a:cubicBezTo>
                <a:cubicBezTo>
                  <a:pt x="130060" y="302383"/>
                  <a:pt x="129356" y="311866"/>
                  <a:pt x="132230" y="320488"/>
                </a:cubicBezTo>
                <a:cubicBezTo>
                  <a:pt x="133724" y="324970"/>
                  <a:pt x="135566" y="329351"/>
                  <a:pt x="136712" y="333935"/>
                </a:cubicBezTo>
                <a:cubicBezTo>
                  <a:pt x="139502" y="345095"/>
                  <a:pt x="140417" y="364947"/>
                  <a:pt x="141194" y="374276"/>
                </a:cubicBezTo>
                <a:cubicBezTo>
                  <a:pt x="135965" y="418353"/>
                  <a:pt x="132255" y="462636"/>
                  <a:pt x="125506" y="506506"/>
                </a:cubicBezTo>
                <a:cubicBezTo>
                  <a:pt x="124704" y="511718"/>
                  <a:pt x="108680" y="536149"/>
                  <a:pt x="107577" y="537882"/>
                </a:cubicBezTo>
                <a:cubicBezTo>
                  <a:pt x="106131" y="540155"/>
                  <a:pt x="103094" y="544606"/>
                  <a:pt x="103094" y="544606"/>
                </a:cubicBezTo>
                <a:cubicBezTo>
                  <a:pt x="102347" y="549835"/>
                  <a:pt x="102406" y="555245"/>
                  <a:pt x="100853" y="560294"/>
                </a:cubicBezTo>
                <a:cubicBezTo>
                  <a:pt x="99379" y="565084"/>
                  <a:pt x="96230" y="569191"/>
                  <a:pt x="94130" y="573741"/>
                </a:cubicBezTo>
                <a:cubicBezTo>
                  <a:pt x="91746" y="578907"/>
                  <a:pt x="89350" y="584082"/>
                  <a:pt x="87406" y="589429"/>
                </a:cubicBezTo>
                <a:cubicBezTo>
                  <a:pt x="86353" y="592324"/>
                  <a:pt x="85975" y="595422"/>
                  <a:pt x="85165" y="598394"/>
                </a:cubicBezTo>
                <a:cubicBezTo>
                  <a:pt x="74626" y="637038"/>
                  <a:pt x="87980" y="584898"/>
                  <a:pt x="73959" y="640976"/>
                </a:cubicBezTo>
                <a:cubicBezTo>
                  <a:pt x="68684" y="712199"/>
                  <a:pt x="64740" y="740169"/>
                  <a:pt x="71718" y="822512"/>
                </a:cubicBezTo>
                <a:cubicBezTo>
                  <a:pt x="72122" y="827279"/>
                  <a:pt x="77695" y="829983"/>
                  <a:pt x="80683" y="833718"/>
                </a:cubicBezTo>
                <a:cubicBezTo>
                  <a:pt x="82924" y="839694"/>
                  <a:pt x="83866" y="846336"/>
                  <a:pt x="87406" y="851647"/>
                </a:cubicBezTo>
                <a:cubicBezTo>
                  <a:pt x="94463" y="862232"/>
                  <a:pt x="101150" y="874236"/>
                  <a:pt x="112059" y="880782"/>
                </a:cubicBezTo>
                <a:cubicBezTo>
                  <a:pt x="115794" y="883023"/>
                  <a:pt x="119421" y="885456"/>
                  <a:pt x="123265" y="887506"/>
                </a:cubicBezTo>
                <a:cubicBezTo>
                  <a:pt x="162745" y="908562"/>
                  <a:pt x="131645" y="890294"/>
                  <a:pt x="156883" y="905435"/>
                </a:cubicBezTo>
                <a:cubicBezTo>
                  <a:pt x="201729" y="965231"/>
                  <a:pt x="157419" y="910454"/>
                  <a:pt x="190500" y="943535"/>
                </a:cubicBezTo>
                <a:cubicBezTo>
                  <a:pt x="194834" y="947869"/>
                  <a:pt x="203260" y="962285"/>
                  <a:pt x="206189" y="965947"/>
                </a:cubicBezTo>
                <a:cubicBezTo>
                  <a:pt x="211809" y="972972"/>
                  <a:pt x="217980" y="979542"/>
                  <a:pt x="224118" y="986118"/>
                </a:cubicBezTo>
                <a:cubicBezTo>
                  <a:pt x="233949" y="996651"/>
                  <a:pt x="240633" y="1001175"/>
                  <a:pt x="248771" y="1013012"/>
                </a:cubicBezTo>
                <a:cubicBezTo>
                  <a:pt x="253707" y="1020191"/>
                  <a:pt x="257736" y="1027953"/>
                  <a:pt x="262218" y="1035424"/>
                </a:cubicBezTo>
                <a:cubicBezTo>
                  <a:pt x="271520" y="1050927"/>
                  <a:pt x="266992" y="1042732"/>
                  <a:pt x="275665" y="1060076"/>
                </a:cubicBezTo>
                <a:cubicBezTo>
                  <a:pt x="290093" y="1117795"/>
                  <a:pt x="267417" y="1030513"/>
                  <a:pt x="289112" y="1100418"/>
                </a:cubicBezTo>
                <a:cubicBezTo>
                  <a:pt x="293462" y="1114436"/>
                  <a:pt x="296286" y="1128887"/>
                  <a:pt x="300318" y="1143000"/>
                </a:cubicBezTo>
                <a:lnTo>
                  <a:pt x="304800" y="1158688"/>
                </a:lnTo>
                <a:cubicBezTo>
                  <a:pt x="303306" y="1185582"/>
                  <a:pt x="303957" y="1212682"/>
                  <a:pt x="300318" y="1239371"/>
                </a:cubicBezTo>
                <a:cubicBezTo>
                  <a:pt x="299415" y="1245992"/>
                  <a:pt x="293923" y="1251132"/>
                  <a:pt x="291353" y="1257300"/>
                </a:cubicBezTo>
                <a:cubicBezTo>
                  <a:pt x="290168" y="1260143"/>
                  <a:pt x="290256" y="1263405"/>
                  <a:pt x="289112" y="1266265"/>
                </a:cubicBezTo>
                <a:cubicBezTo>
                  <a:pt x="287251" y="1270918"/>
                  <a:pt x="284489" y="1275162"/>
                  <a:pt x="282389" y="1279712"/>
                </a:cubicBezTo>
                <a:cubicBezTo>
                  <a:pt x="280005" y="1284878"/>
                  <a:pt x="278647" y="1290555"/>
                  <a:pt x="275665" y="1295400"/>
                </a:cubicBezTo>
                <a:cubicBezTo>
                  <a:pt x="272607" y="1300369"/>
                  <a:pt x="267780" y="1304050"/>
                  <a:pt x="264459" y="1308847"/>
                </a:cubicBezTo>
                <a:cubicBezTo>
                  <a:pt x="261031" y="1313799"/>
                  <a:pt x="258728" y="1319454"/>
                  <a:pt x="255494" y="1324535"/>
                </a:cubicBezTo>
                <a:cubicBezTo>
                  <a:pt x="253489" y="1327686"/>
                  <a:pt x="250887" y="1330422"/>
                  <a:pt x="248771" y="1333500"/>
                </a:cubicBezTo>
                <a:cubicBezTo>
                  <a:pt x="242667" y="1342378"/>
                  <a:pt x="237664" y="1352055"/>
                  <a:pt x="230841" y="1360394"/>
                </a:cubicBezTo>
                <a:cubicBezTo>
                  <a:pt x="224118" y="1368612"/>
                  <a:pt x="215827" y="1375766"/>
                  <a:pt x="210671" y="1385047"/>
                </a:cubicBezTo>
                <a:cubicBezTo>
                  <a:pt x="207374" y="1390981"/>
                  <a:pt x="199359" y="1407564"/>
                  <a:pt x="192741" y="1414182"/>
                </a:cubicBezTo>
                <a:cubicBezTo>
                  <a:pt x="190100" y="1416823"/>
                  <a:pt x="186301" y="1418153"/>
                  <a:pt x="183777" y="1420906"/>
                </a:cubicBezTo>
                <a:cubicBezTo>
                  <a:pt x="178022" y="1427185"/>
                  <a:pt x="173410" y="1434425"/>
                  <a:pt x="168089" y="1441076"/>
                </a:cubicBezTo>
                <a:cubicBezTo>
                  <a:pt x="164444" y="1445632"/>
                  <a:pt x="161009" y="1450399"/>
                  <a:pt x="156883" y="1454524"/>
                </a:cubicBezTo>
                <a:cubicBezTo>
                  <a:pt x="155389" y="1456018"/>
                  <a:pt x="153738" y="1457371"/>
                  <a:pt x="152400" y="1459006"/>
                </a:cubicBezTo>
                <a:cubicBezTo>
                  <a:pt x="147006" y="1465598"/>
                  <a:pt x="141823" y="1472362"/>
                  <a:pt x="136712" y="1479176"/>
                </a:cubicBezTo>
                <a:cubicBezTo>
                  <a:pt x="132856" y="1484317"/>
                  <a:pt x="128695" y="1489285"/>
                  <a:pt x="125506" y="1494865"/>
                </a:cubicBezTo>
                <a:cubicBezTo>
                  <a:pt x="122518" y="1500094"/>
                  <a:pt x="119640" y="1505388"/>
                  <a:pt x="116541" y="1510553"/>
                </a:cubicBezTo>
                <a:cubicBezTo>
                  <a:pt x="109289" y="1522639"/>
                  <a:pt x="107486" y="1519786"/>
                  <a:pt x="100853" y="1539688"/>
                </a:cubicBezTo>
                <a:cubicBezTo>
                  <a:pt x="97340" y="1550229"/>
                  <a:pt x="99489" y="1544218"/>
                  <a:pt x="94130" y="1557618"/>
                </a:cubicBezTo>
                <a:cubicBezTo>
                  <a:pt x="87663" y="1596425"/>
                  <a:pt x="97674" y="1544484"/>
                  <a:pt x="85165" y="1584512"/>
                </a:cubicBezTo>
                <a:cubicBezTo>
                  <a:pt x="82893" y="1591784"/>
                  <a:pt x="83584" y="1599879"/>
                  <a:pt x="80683" y="1606924"/>
                </a:cubicBezTo>
                <a:cubicBezTo>
                  <a:pt x="78236" y="1612866"/>
                  <a:pt x="72470" y="1616925"/>
                  <a:pt x="69477" y="1622612"/>
                </a:cubicBezTo>
                <a:cubicBezTo>
                  <a:pt x="39602" y="1679373"/>
                  <a:pt x="72865" y="1627617"/>
                  <a:pt x="49306" y="1662953"/>
                </a:cubicBezTo>
                <a:cubicBezTo>
                  <a:pt x="47812" y="1668182"/>
                  <a:pt x="46916" y="1673621"/>
                  <a:pt x="44824" y="1678641"/>
                </a:cubicBezTo>
                <a:cubicBezTo>
                  <a:pt x="37664" y="1695825"/>
                  <a:pt x="39064" y="1683563"/>
                  <a:pt x="33618" y="1698812"/>
                </a:cubicBezTo>
                <a:cubicBezTo>
                  <a:pt x="30995" y="1706157"/>
                  <a:pt x="29135" y="1713753"/>
                  <a:pt x="26894" y="1721224"/>
                </a:cubicBezTo>
                <a:cubicBezTo>
                  <a:pt x="25018" y="1734360"/>
                  <a:pt x="24493" y="1741875"/>
                  <a:pt x="20171" y="1754841"/>
                </a:cubicBezTo>
                <a:cubicBezTo>
                  <a:pt x="18372" y="1760238"/>
                  <a:pt x="15391" y="1765182"/>
                  <a:pt x="13447" y="1770529"/>
                </a:cubicBezTo>
                <a:cubicBezTo>
                  <a:pt x="12394" y="1773424"/>
                  <a:pt x="12112" y="1776550"/>
                  <a:pt x="11206" y="1779494"/>
                </a:cubicBezTo>
                <a:cubicBezTo>
                  <a:pt x="9122" y="1786268"/>
                  <a:pt x="5873" y="1792715"/>
                  <a:pt x="4483" y="1799665"/>
                </a:cubicBezTo>
                <a:cubicBezTo>
                  <a:pt x="914" y="1817504"/>
                  <a:pt x="2662" y="1807085"/>
                  <a:pt x="0" y="1831041"/>
                </a:cubicBezTo>
                <a:cubicBezTo>
                  <a:pt x="1494" y="1891553"/>
                  <a:pt x="2421" y="1952081"/>
                  <a:pt x="4483" y="2012576"/>
                </a:cubicBezTo>
                <a:cubicBezTo>
                  <a:pt x="5053" y="2029283"/>
                  <a:pt x="4260" y="2025801"/>
                  <a:pt x="13447" y="2034988"/>
                </a:cubicBezTo>
                <a:cubicBezTo>
                  <a:pt x="18113" y="2053647"/>
                  <a:pt x="11578" y="2036053"/>
                  <a:pt x="22412" y="2048435"/>
                </a:cubicBezTo>
                <a:cubicBezTo>
                  <a:pt x="25959" y="2052489"/>
                  <a:pt x="27568" y="2058073"/>
                  <a:pt x="31377" y="2061882"/>
                </a:cubicBezTo>
                <a:cubicBezTo>
                  <a:pt x="43111" y="2073616"/>
                  <a:pt x="42583" y="2067805"/>
                  <a:pt x="42583" y="2075329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Freeform: Shape 39">
            <a:extLst>
              <a:ext uri="{FF2B5EF4-FFF2-40B4-BE49-F238E27FC236}">
                <a16:creationId xmlns="" xmlns:a16="http://schemas.microsoft.com/office/drawing/2014/main" id="{3134A4AD-1818-4BE7-A350-1429AE2643FD}"/>
              </a:ext>
            </a:extLst>
          </p:cNvPr>
          <p:cNvSpPr/>
          <p:nvPr/>
        </p:nvSpPr>
        <p:spPr>
          <a:xfrm>
            <a:off x="1674861" y="2811002"/>
            <a:ext cx="267000" cy="1483947"/>
          </a:xfrm>
          <a:custGeom>
            <a:avLst/>
            <a:gdLst>
              <a:gd name="connsiteX0" fmla="*/ 63053 w 267000"/>
              <a:gd name="connsiteY0" fmla="*/ 0 h 2066364"/>
              <a:gd name="connsiteX1" fmla="*/ 76500 w 267000"/>
              <a:gd name="connsiteY1" fmla="*/ 17929 h 2066364"/>
              <a:gd name="connsiteX2" fmla="*/ 83224 w 267000"/>
              <a:gd name="connsiteY2" fmla="*/ 29135 h 2066364"/>
              <a:gd name="connsiteX3" fmla="*/ 92188 w 267000"/>
              <a:gd name="connsiteY3" fmla="*/ 49305 h 2066364"/>
              <a:gd name="connsiteX4" fmla="*/ 96671 w 267000"/>
              <a:gd name="connsiteY4" fmla="*/ 194982 h 2066364"/>
              <a:gd name="connsiteX5" fmla="*/ 105635 w 267000"/>
              <a:gd name="connsiteY5" fmla="*/ 253253 h 2066364"/>
              <a:gd name="connsiteX6" fmla="*/ 112359 w 267000"/>
              <a:gd name="connsiteY6" fmla="*/ 304800 h 2066364"/>
              <a:gd name="connsiteX7" fmla="*/ 125806 w 267000"/>
              <a:gd name="connsiteY7" fmla="*/ 345141 h 2066364"/>
              <a:gd name="connsiteX8" fmla="*/ 132529 w 267000"/>
              <a:gd name="connsiteY8" fmla="*/ 367553 h 2066364"/>
              <a:gd name="connsiteX9" fmla="*/ 134771 w 267000"/>
              <a:gd name="connsiteY9" fmla="*/ 385482 h 2066364"/>
              <a:gd name="connsiteX10" fmla="*/ 141494 w 267000"/>
              <a:gd name="connsiteY10" fmla="*/ 533400 h 2066364"/>
              <a:gd name="connsiteX11" fmla="*/ 148218 w 267000"/>
              <a:gd name="connsiteY11" fmla="*/ 540123 h 2066364"/>
              <a:gd name="connsiteX12" fmla="*/ 163906 w 267000"/>
              <a:gd name="connsiteY12" fmla="*/ 560294 h 2066364"/>
              <a:gd name="connsiteX13" fmla="*/ 175112 w 267000"/>
              <a:gd name="connsiteY13" fmla="*/ 573741 h 2066364"/>
              <a:gd name="connsiteX14" fmla="*/ 188559 w 267000"/>
              <a:gd name="connsiteY14" fmla="*/ 600635 h 2066364"/>
              <a:gd name="connsiteX15" fmla="*/ 197524 w 267000"/>
              <a:gd name="connsiteY15" fmla="*/ 620805 h 2066364"/>
              <a:gd name="connsiteX16" fmla="*/ 204247 w 267000"/>
              <a:gd name="connsiteY16" fmla="*/ 647700 h 2066364"/>
              <a:gd name="connsiteX17" fmla="*/ 206488 w 267000"/>
              <a:gd name="connsiteY17" fmla="*/ 656664 h 2066364"/>
              <a:gd name="connsiteX18" fmla="*/ 213212 w 267000"/>
              <a:gd name="connsiteY18" fmla="*/ 670111 h 2066364"/>
              <a:gd name="connsiteX19" fmla="*/ 222177 w 267000"/>
              <a:gd name="connsiteY19" fmla="*/ 703729 h 2066364"/>
              <a:gd name="connsiteX20" fmla="*/ 224418 w 267000"/>
              <a:gd name="connsiteY20" fmla="*/ 717176 h 2066364"/>
              <a:gd name="connsiteX21" fmla="*/ 233382 w 267000"/>
              <a:gd name="connsiteY21" fmla="*/ 744070 h 2066364"/>
              <a:gd name="connsiteX22" fmla="*/ 244588 w 267000"/>
              <a:gd name="connsiteY22" fmla="*/ 822511 h 2066364"/>
              <a:gd name="connsiteX23" fmla="*/ 253553 w 267000"/>
              <a:gd name="connsiteY23" fmla="*/ 869576 h 2066364"/>
              <a:gd name="connsiteX24" fmla="*/ 264759 w 267000"/>
              <a:gd name="connsiteY24" fmla="*/ 909917 h 2066364"/>
              <a:gd name="connsiteX25" fmla="*/ 267000 w 267000"/>
              <a:gd name="connsiteY25" fmla="*/ 921123 h 2066364"/>
              <a:gd name="connsiteX26" fmla="*/ 262518 w 267000"/>
              <a:gd name="connsiteY26" fmla="*/ 1008529 h 2066364"/>
              <a:gd name="connsiteX27" fmla="*/ 249071 w 267000"/>
              <a:gd name="connsiteY27" fmla="*/ 1035423 h 2066364"/>
              <a:gd name="connsiteX28" fmla="*/ 224418 w 267000"/>
              <a:gd name="connsiteY28" fmla="*/ 1069041 h 2066364"/>
              <a:gd name="connsiteX29" fmla="*/ 213212 w 267000"/>
              <a:gd name="connsiteY29" fmla="*/ 1084729 h 2066364"/>
              <a:gd name="connsiteX30" fmla="*/ 208729 w 267000"/>
              <a:gd name="connsiteY30" fmla="*/ 1089211 h 2066364"/>
              <a:gd name="connsiteX31" fmla="*/ 190800 w 267000"/>
              <a:gd name="connsiteY31" fmla="*/ 1118347 h 2066364"/>
              <a:gd name="connsiteX32" fmla="*/ 175112 w 267000"/>
              <a:gd name="connsiteY32" fmla="*/ 1145241 h 2066364"/>
              <a:gd name="connsiteX33" fmla="*/ 172871 w 267000"/>
              <a:gd name="connsiteY33" fmla="*/ 1160929 h 2066364"/>
              <a:gd name="connsiteX34" fmla="*/ 168388 w 267000"/>
              <a:gd name="connsiteY34" fmla="*/ 1183341 h 2066364"/>
              <a:gd name="connsiteX35" fmla="*/ 166147 w 267000"/>
              <a:gd name="connsiteY35" fmla="*/ 1315570 h 2066364"/>
              <a:gd name="connsiteX36" fmla="*/ 161665 w 267000"/>
              <a:gd name="connsiteY36" fmla="*/ 1342464 h 2066364"/>
              <a:gd name="connsiteX37" fmla="*/ 163906 w 267000"/>
              <a:gd name="connsiteY37" fmla="*/ 1450041 h 2066364"/>
              <a:gd name="connsiteX38" fmla="*/ 168388 w 267000"/>
              <a:gd name="connsiteY38" fmla="*/ 1508311 h 2066364"/>
              <a:gd name="connsiteX39" fmla="*/ 170629 w 267000"/>
              <a:gd name="connsiteY39" fmla="*/ 1526241 h 2066364"/>
              <a:gd name="connsiteX40" fmla="*/ 175112 w 267000"/>
              <a:gd name="connsiteY40" fmla="*/ 1537447 h 2066364"/>
              <a:gd name="connsiteX41" fmla="*/ 181835 w 267000"/>
              <a:gd name="connsiteY41" fmla="*/ 1566582 h 2066364"/>
              <a:gd name="connsiteX42" fmla="*/ 175112 w 267000"/>
              <a:gd name="connsiteY42" fmla="*/ 1653988 h 2066364"/>
              <a:gd name="connsiteX43" fmla="*/ 159424 w 267000"/>
              <a:gd name="connsiteY43" fmla="*/ 1669676 h 2066364"/>
              <a:gd name="connsiteX44" fmla="*/ 139253 w 267000"/>
              <a:gd name="connsiteY44" fmla="*/ 1687605 h 2066364"/>
              <a:gd name="connsiteX45" fmla="*/ 132529 w 267000"/>
              <a:gd name="connsiteY45" fmla="*/ 1689847 h 2066364"/>
              <a:gd name="connsiteX46" fmla="*/ 121324 w 267000"/>
              <a:gd name="connsiteY46" fmla="*/ 1701053 h 2066364"/>
              <a:gd name="connsiteX47" fmla="*/ 110118 w 267000"/>
              <a:gd name="connsiteY47" fmla="*/ 1707776 h 2066364"/>
              <a:gd name="connsiteX48" fmla="*/ 89947 w 267000"/>
              <a:gd name="connsiteY48" fmla="*/ 1727947 h 2066364"/>
              <a:gd name="connsiteX49" fmla="*/ 83224 w 267000"/>
              <a:gd name="connsiteY49" fmla="*/ 1734670 h 2066364"/>
              <a:gd name="connsiteX50" fmla="*/ 72018 w 267000"/>
              <a:gd name="connsiteY50" fmla="*/ 1752600 h 2066364"/>
              <a:gd name="connsiteX51" fmla="*/ 63053 w 267000"/>
              <a:gd name="connsiteY51" fmla="*/ 1770529 h 2066364"/>
              <a:gd name="connsiteX52" fmla="*/ 51847 w 267000"/>
              <a:gd name="connsiteY52" fmla="*/ 1786217 h 2066364"/>
              <a:gd name="connsiteX53" fmla="*/ 42882 w 267000"/>
              <a:gd name="connsiteY53" fmla="*/ 1801905 h 2066364"/>
              <a:gd name="connsiteX54" fmla="*/ 40641 w 267000"/>
              <a:gd name="connsiteY54" fmla="*/ 1813111 h 2066364"/>
              <a:gd name="connsiteX55" fmla="*/ 36159 w 267000"/>
              <a:gd name="connsiteY55" fmla="*/ 1824317 h 2066364"/>
              <a:gd name="connsiteX56" fmla="*/ 33918 w 267000"/>
              <a:gd name="connsiteY56" fmla="*/ 1833282 h 2066364"/>
              <a:gd name="connsiteX57" fmla="*/ 31677 w 267000"/>
              <a:gd name="connsiteY57" fmla="*/ 1853453 h 2066364"/>
              <a:gd name="connsiteX58" fmla="*/ 24953 w 267000"/>
              <a:gd name="connsiteY58" fmla="*/ 1871382 h 2066364"/>
              <a:gd name="connsiteX59" fmla="*/ 18229 w 267000"/>
              <a:gd name="connsiteY59" fmla="*/ 1891553 h 2066364"/>
              <a:gd name="connsiteX60" fmla="*/ 13747 w 267000"/>
              <a:gd name="connsiteY60" fmla="*/ 1902758 h 2066364"/>
              <a:gd name="connsiteX61" fmla="*/ 11506 w 267000"/>
              <a:gd name="connsiteY61" fmla="*/ 1911723 h 2066364"/>
              <a:gd name="connsiteX62" fmla="*/ 7024 w 267000"/>
              <a:gd name="connsiteY62" fmla="*/ 1929653 h 2066364"/>
              <a:gd name="connsiteX63" fmla="*/ 2541 w 267000"/>
              <a:gd name="connsiteY63" fmla="*/ 1949823 h 2066364"/>
              <a:gd name="connsiteX64" fmla="*/ 300 w 267000"/>
              <a:gd name="connsiteY64" fmla="*/ 1961029 h 2066364"/>
              <a:gd name="connsiteX65" fmla="*/ 300 w 267000"/>
              <a:gd name="connsiteY65" fmla="*/ 2066364 h 2066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</a:cxnLst>
            <a:rect l="l" t="t" r="r" b="b"/>
            <a:pathLst>
              <a:path w="267000" h="2066364">
                <a:moveTo>
                  <a:pt x="63053" y="0"/>
                </a:moveTo>
                <a:cubicBezTo>
                  <a:pt x="70089" y="8794"/>
                  <a:pt x="71399" y="9767"/>
                  <a:pt x="76500" y="17929"/>
                </a:cubicBezTo>
                <a:cubicBezTo>
                  <a:pt x="78809" y="21623"/>
                  <a:pt x="81421" y="25169"/>
                  <a:pt x="83224" y="29135"/>
                </a:cubicBezTo>
                <a:cubicBezTo>
                  <a:pt x="94655" y="54284"/>
                  <a:pt x="81609" y="33437"/>
                  <a:pt x="92188" y="49305"/>
                </a:cubicBezTo>
                <a:cubicBezTo>
                  <a:pt x="98972" y="117150"/>
                  <a:pt x="91807" y="39352"/>
                  <a:pt x="96671" y="194982"/>
                </a:cubicBezTo>
                <a:cubicBezTo>
                  <a:pt x="97172" y="211020"/>
                  <a:pt x="103767" y="240803"/>
                  <a:pt x="105635" y="253253"/>
                </a:cubicBezTo>
                <a:cubicBezTo>
                  <a:pt x="108205" y="270389"/>
                  <a:pt x="108156" y="287989"/>
                  <a:pt x="112359" y="304800"/>
                </a:cubicBezTo>
                <a:cubicBezTo>
                  <a:pt x="120012" y="335413"/>
                  <a:pt x="103761" y="271651"/>
                  <a:pt x="125806" y="345141"/>
                </a:cubicBezTo>
                <a:lnTo>
                  <a:pt x="132529" y="367553"/>
                </a:lnTo>
                <a:cubicBezTo>
                  <a:pt x="133276" y="373529"/>
                  <a:pt x="134446" y="379468"/>
                  <a:pt x="134771" y="385482"/>
                </a:cubicBezTo>
                <a:cubicBezTo>
                  <a:pt x="137435" y="434767"/>
                  <a:pt x="137218" y="484229"/>
                  <a:pt x="141494" y="533400"/>
                </a:cubicBezTo>
                <a:cubicBezTo>
                  <a:pt x="141769" y="536558"/>
                  <a:pt x="146189" y="537688"/>
                  <a:pt x="148218" y="540123"/>
                </a:cubicBezTo>
                <a:cubicBezTo>
                  <a:pt x="153671" y="546667"/>
                  <a:pt x="158585" y="553643"/>
                  <a:pt x="163906" y="560294"/>
                </a:cubicBezTo>
                <a:cubicBezTo>
                  <a:pt x="167551" y="564850"/>
                  <a:pt x="175112" y="573741"/>
                  <a:pt x="175112" y="573741"/>
                </a:cubicBezTo>
                <a:cubicBezTo>
                  <a:pt x="185489" y="599685"/>
                  <a:pt x="172122" y="567762"/>
                  <a:pt x="188559" y="600635"/>
                </a:cubicBezTo>
                <a:cubicBezTo>
                  <a:pt x="191850" y="607216"/>
                  <a:pt x="194536" y="614082"/>
                  <a:pt x="197524" y="620805"/>
                </a:cubicBezTo>
                <a:cubicBezTo>
                  <a:pt x="201253" y="643182"/>
                  <a:pt x="197589" y="625504"/>
                  <a:pt x="204247" y="647700"/>
                </a:cubicBezTo>
                <a:cubicBezTo>
                  <a:pt x="205132" y="650650"/>
                  <a:pt x="205344" y="653804"/>
                  <a:pt x="206488" y="656664"/>
                </a:cubicBezTo>
                <a:cubicBezTo>
                  <a:pt x="208349" y="661317"/>
                  <a:pt x="210971" y="665629"/>
                  <a:pt x="213212" y="670111"/>
                </a:cubicBezTo>
                <a:cubicBezTo>
                  <a:pt x="218362" y="701013"/>
                  <a:pt x="211296" y="662926"/>
                  <a:pt x="222177" y="703729"/>
                </a:cubicBezTo>
                <a:cubicBezTo>
                  <a:pt x="223348" y="708120"/>
                  <a:pt x="223202" y="712798"/>
                  <a:pt x="224418" y="717176"/>
                </a:cubicBezTo>
                <a:cubicBezTo>
                  <a:pt x="226947" y="726281"/>
                  <a:pt x="233382" y="744070"/>
                  <a:pt x="233382" y="744070"/>
                </a:cubicBezTo>
                <a:cubicBezTo>
                  <a:pt x="239534" y="799426"/>
                  <a:pt x="235281" y="768992"/>
                  <a:pt x="244588" y="822511"/>
                </a:cubicBezTo>
                <a:cubicBezTo>
                  <a:pt x="247147" y="837228"/>
                  <a:pt x="249862" y="856657"/>
                  <a:pt x="253553" y="869576"/>
                </a:cubicBezTo>
                <a:cubicBezTo>
                  <a:pt x="254747" y="873754"/>
                  <a:pt x="262320" y="898940"/>
                  <a:pt x="264759" y="909917"/>
                </a:cubicBezTo>
                <a:cubicBezTo>
                  <a:pt x="265585" y="913636"/>
                  <a:pt x="266253" y="917388"/>
                  <a:pt x="267000" y="921123"/>
                </a:cubicBezTo>
                <a:cubicBezTo>
                  <a:pt x="265506" y="950258"/>
                  <a:pt x="267039" y="979708"/>
                  <a:pt x="262518" y="1008529"/>
                </a:cubicBezTo>
                <a:cubicBezTo>
                  <a:pt x="260965" y="1018431"/>
                  <a:pt x="254819" y="1027212"/>
                  <a:pt x="249071" y="1035423"/>
                </a:cubicBezTo>
                <a:cubicBezTo>
                  <a:pt x="206184" y="1096688"/>
                  <a:pt x="251906" y="1032389"/>
                  <a:pt x="224418" y="1069041"/>
                </a:cubicBezTo>
                <a:cubicBezTo>
                  <a:pt x="220562" y="1074182"/>
                  <a:pt x="217158" y="1079656"/>
                  <a:pt x="213212" y="1084729"/>
                </a:cubicBezTo>
                <a:cubicBezTo>
                  <a:pt x="211915" y="1086397"/>
                  <a:pt x="209901" y="1087453"/>
                  <a:pt x="208729" y="1089211"/>
                </a:cubicBezTo>
                <a:cubicBezTo>
                  <a:pt x="202403" y="1098699"/>
                  <a:pt x="195900" y="1108148"/>
                  <a:pt x="190800" y="1118347"/>
                </a:cubicBezTo>
                <a:cubicBezTo>
                  <a:pt x="180164" y="1139617"/>
                  <a:pt x="185844" y="1130930"/>
                  <a:pt x="175112" y="1145241"/>
                </a:cubicBezTo>
                <a:cubicBezTo>
                  <a:pt x="174365" y="1150470"/>
                  <a:pt x="173789" y="1155727"/>
                  <a:pt x="172871" y="1160929"/>
                </a:cubicBezTo>
                <a:cubicBezTo>
                  <a:pt x="171547" y="1168432"/>
                  <a:pt x="168388" y="1183341"/>
                  <a:pt x="168388" y="1183341"/>
                </a:cubicBezTo>
                <a:cubicBezTo>
                  <a:pt x="167641" y="1227417"/>
                  <a:pt x="168008" y="1271527"/>
                  <a:pt x="166147" y="1315570"/>
                </a:cubicBezTo>
                <a:cubicBezTo>
                  <a:pt x="165763" y="1324650"/>
                  <a:pt x="161816" y="1333377"/>
                  <a:pt x="161665" y="1342464"/>
                </a:cubicBezTo>
                <a:cubicBezTo>
                  <a:pt x="161067" y="1378326"/>
                  <a:pt x="162453" y="1414204"/>
                  <a:pt x="163906" y="1450041"/>
                </a:cubicBezTo>
                <a:cubicBezTo>
                  <a:pt x="164695" y="1469506"/>
                  <a:pt x="165972" y="1488981"/>
                  <a:pt x="168388" y="1508311"/>
                </a:cubicBezTo>
                <a:cubicBezTo>
                  <a:pt x="169135" y="1514288"/>
                  <a:pt x="169275" y="1520372"/>
                  <a:pt x="170629" y="1526241"/>
                </a:cubicBezTo>
                <a:cubicBezTo>
                  <a:pt x="171534" y="1530161"/>
                  <a:pt x="174035" y="1533571"/>
                  <a:pt x="175112" y="1537447"/>
                </a:cubicBezTo>
                <a:cubicBezTo>
                  <a:pt x="177780" y="1547050"/>
                  <a:pt x="179594" y="1556870"/>
                  <a:pt x="181835" y="1566582"/>
                </a:cubicBezTo>
                <a:cubicBezTo>
                  <a:pt x="184925" y="1600562"/>
                  <a:pt x="187972" y="1613069"/>
                  <a:pt x="175112" y="1653988"/>
                </a:cubicBezTo>
                <a:cubicBezTo>
                  <a:pt x="172895" y="1661043"/>
                  <a:pt x="164653" y="1664447"/>
                  <a:pt x="159424" y="1669676"/>
                </a:cubicBezTo>
                <a:cubicBezTo>
                  <a:pt x="153055" y="1676045"/>
                  <a:pt x="146992" y="1682768"/>
                  <a:pt x="139253" y="1687605"/>
                </a:cubicBezTo>
                <a:cubicBezTo>
                  <a:pt x="137249" y="1688857"/>
                  <a:pt x="134770" y="1689100"/>
                  <a:pt x="132529" y="1689847"/>
                </a:cubicBezTo>
                <a:cubicBezTo>
                  <a:pt x="128794" y="1693582"/>
                  <a:pt x="125449" y="1697753"/>
                  <a:pt x="121324" y="1701053"/>
                </a:cubicBezTo>
                <a:cubicBezTo>
                  <a:pt x="117923" y="1703774"/>
                  <a:pt x="113425" y="1704941"/>
                  <a:pt x="110118" y="1707776"/>
                </a:cubicBezTo>
                <a:cubicBezTo>
                  <a:pt x="102898" y="1713964"/>
                  <a:pt x="96671" y="1721223"/>
                  <a:pt x="89947" y="1727947"/>
                </a:cubicBezTo>
                <a:cubicBezTo>
                  <a:pt x="87706" y="1730188"/>
                  <a:pt x="84904" y="1731982"/>
                  <a:pt x="83224" y="1734670"/>
                </a:cubicBezTo>
                <a:cubicBezTo>
                  <a:pt x="79489" y="1740647"/>
                  <a:pt x="75473" y="1746457"/>
                  <a:pt x="72018" y="1752600"/>
                </a:cubicBezTo>
                <a:cubicBezTo>
                  <a:pt x="68742" y="1758424"/>
                  <a:pt x="66491" y="1764799"/>
                  <a:pt x="63053" y="1770529"/>
                </a:cubicBezTo>
                <a:cubicBezTo>
                  <a:pt x="59747" y="1776040"/>
                  <a:pt x="55322" y="1780811"/>
                  <a:pt x="51847" y="1786217"/>
                </a:cubicBezTo>
                <a:cubicBezTo>
                  <a:pt x="48590" y="1791283"/>
                  <a:pt x="45870" y="1796676"/>
                  <a:pt x="42882" y="1801905"/>
                </a:cubicBezTo>
                <a:cubicBezTo>
                  <a:pt x="42135" y="1805640"/>
                  <a:pt x="41736" y="1809462"/>
                  <a:pt x="40641" y="1813111"/>
                </a:cubicBezTo>
                <a:cubicBezTo>
                  <a:pt x="39485" y="1816964"/>
                  <a:pt x="37431" y="1820500"/>
                  <a:pt x="36159" y="1824317"/>
                </a:cubicBezTo>
                <a:cubicBezTo>
                  <a:pt x="35185" y="1827239"/>
                  <a:pt x="34665" y="1830294"/>
                  <a:pt x="33918" y="1833282"/>
                </a:cubicBezTo>
                <a:cubicBezTo>
                  <a:pt x="33171" y="1840006"/>
                  <a:pt x="33227" y="1846868"/>
                  <a:pt x="31677" y="1853453"/>
                </a:cubicBezTo>
                <a:cubicBezTo>
                  <a:pt x="30215" y="1859666"/>
                  <a:pt x="27077" y="1865363"/>
                  <a:pt x="24953" y="1871382"/>
                </a:cubicBezTo>
                <a:cubicBezTo>
                  <a:pt x="22594" y="1878065"/>
                  <a:pt x="20613" y="1884879"/>
                  <a:pt x="18229" y="1891553"/>
                </a:cubicBezTo>
                <a:cubicBezTo>
                  <a:pt x="16876" y="1895341"/>
                  <a:pt x="15019" y="1898942"/>
                  <a:pt x="13747" y="1902758"/>
                </a:cubicBezTo>
                <a:cubicBezTo>
                  <a:pt x="12773" y="1905680"/>
                  <a:pt x="12352" y="1908761"/>
                  <a:pt x="11506" y="1911723"/>
                </a:cubicBezTo>
                <a:cubicBezTo>
                  <a:pt x="6102" y="1930639"/>
                  <a:pt x="12886" y="1902299"/>
                  <a:pt x="7024" y="1929653"/>
                </a:cubicBezTo>
                <a:cubicBezTo>
                  <a:pt x="5581" y="1936387"/>
                  <a:pt x="3984" y="1943089"/>
                  <a:pt x="2541" y="1949823"/>
                </a:cubicBezTo>
                <a:cubicBezTo>
                  <a:pt x="1743" y="1953548"/>
                  <a:pt x="373" y="1957220"/>
                  <a:pt x="300" y="1961029"/>
                </a:cubicBezTo>
                <a:cubicBezTo>
                  <a:pt x="-375" y="1996134"/>
                  <a:pt x="300" y="2031252"/>
                  <a:pt x="300" y="2066364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Freeform: Shape 40">
            <a:extLst>
              <a:ext uri="{FF2B5EF4-FFF2-40B4-BE49-F238E27FC236}">
                <a16:creationId xmlns="" xmlns:a16="http://schemas.microsoft.com/office/drawing/2014/main" id="{0F3027C3-1A11-4095-8EED-804031E11C5C}"/>
              </a:ext>
            </a:extLst>
          </p:cNvPr>
          <p:cNvSpPr/>
          <p:nvPr/>
        </p:nvSpPr>
        <p:spPr>
          <a:xfrm>
            <a:off x="3088321" y="2821360"/>
            <a:ext cx="142538" cy="1473590"/>
          </a:xfrm>
          <a:custGeom>
            <a:avLst/>
            <a:gdLst>
              <a:gd name="connsiteX0" fmla="*/ 156882 w 201706"/>
              <a:gd name="connsiteY0" fmla="*/ 0 h 2102223"/>
              <a:gd name="connsiteX1" fmla="*/ 161364 w 201706"/>
              <a:gd name="connsiteY1" fmla="*/ 15688 h 2102223"/>
              <a:gd name="connsiteX2" fmla="*/ 154641 w 201706"/>
              <a:gd name="connsiteY2" fmla="*/ 123264 h 2102223"/>
              <a:gd name="connsiteX3" fmla="*/ 145676 w 201706"/>
              <a:gd name="connsiteY3" fmla="*/ 127747 h 2102223"/>
              <a:gd name="connsiteX4" fmla="*/ 121023 w 201706"/>
              <a:gd name="connsiteY4" fmla="*/ 141194 h 2102223"/>
              <a:gd name="connsiteX5" fmla="*/ 118782 w 201706"/>
              <a:gd name="connsiteY5" fmla="*/ 152400 h 2102223"/>
              <a:gd name="connsiteX6" fmla="*/ 125506 w 201706"/>
              <a:gd name="connsiteY6" fmla="*/ 242047 h 2102223"/>
              <a:gd name="connsiteX7" fmla="*/ 127747 w 201706"/>
              <a:gd name="connsiteY7" fmla="*/ 253253 h 2102223"/>
              <a:gd name="connsiteX8" fmla="*/ 129988 w 201706"/>
              <a:gd name="connsiteY8" fmla="*/ 271182 h 2102223"/>
              <a:gd name="connsiteX9" fmla="*/ 134470 w 201706"/>
              <a:gd name="connsiteY9" fmla="*/ 389964 h 2102223"/>
              <a:gd name="connsiteX10" fmla="*/ 138953 w 201706"/>
              <a:gd name="connsiteY10" fmla="*/ 414617 h 2102223"/>
              <a:gd name="connsiteX11" fmla="*/ 145676 w 201706"/>
              <a:gd name="connsiteY11" fmla="*/ 434788 h 2102223"/>
              <a:gd name="connsiteX12" fmla="*/ 150159 w 201706"/>
              <a:gd name="connsiteY12" fmla="*/ 452717 h 2102223"/>
              <a:gd name="connsiteX13" fmla="*/ 152400 w 201706"/>
              <a:gd name="connsiteY13" fmla="*/ 470647 h 2102223"/>
              <a:gd name="connsiteX14" fmla="*/ 161364 w 201706"/>
              <a:gd name="connsiteY14" fmla="*/ 504264 h 2102223"/>
              <a:gd name="connsiteX15" fmla="*/ 159123 w 201706"/>
              <a:gd name="connsiteY15" fmla="*/ 679076 h 2102223"/>
              <a:gd name="connsiteX16" fmla="*/ 152400 w 201706"/>
              <a:gd name="connsiteY16" fmla="*/ 690282 h 2102223"/>
              <a:gd name="connsiteX17" fmla="*/ 116541 w 201706"/>
              <a:gd name="connsiteY17" fmla="*/ 721658 h 2102223"/>
              <a:gd name="connsiteX18" fmla="*/ 91888 w 201706"/>
              <a:gd name="connsiteY18" fmla="*/ 737347 h 2102223"/>
              <a:gd name="connsiteX19" fmla="*/ 82923 w 201706"/>
              <a:gd name="connsiteY19" fmla="*/ 748553 h 2102223"/>
              <a:gd name="connsiteX20" fmla="*/ 71717 w 201706"/>
              <a:gd name="connsiteY20" fmla="*/ 759758 h 2102223"/>
              <a:gd name="connsiteX21" fmla="*/ 67235 w 201706"/>
              <a:gd name="connsiteY21" fmla="*/ 768723 h 2102223"/>
              <a:gd name="connsiteX22" fmla="*/ 58270 w 201706"/>
              <a:gd name="connsiteY22" fmla="*/ 779929 h 2102223"/>
              <a:gd name="connsiteX23" fmla="*/ 56029 w 201706"/>
              <a:gd name="connsiteY23" fmla="*/ 795617 h 2102223"/>
              <a:gd name="connsiteX24" fmla="*/ 49306 w 201706"/>
              <a:gd name="connsiteY24" fmla="*/ 806823 h 2102223"/>
              <a:gd name="connsiteX25" fmla="*/ 47064 w 201706"/>
              <a:gd name="connsiteY25" fmla="*/ 849406 h 2102223"/>
              <a:gd name="connsiteX26" fmla="*/ 44823 w 201706"/>
              <a:gd name="connsiteY26" fmla="*/ 865094 h 2102223"/>
              <a:gd name="connsiteX27" fmla="*/ 42582 w 201706"/>
              <a:gd name="connsiteY27" fmla="*/ 918882 h 2102223"/>
              <a:gd name="connsiteX28" fmla="*/ 29135 w 201706"/>
              <a:gd name="connsiteY28" fmla="*/ 995082 h 2102223"/>
              <a:gd name="connsiteX29" fmla="*/ 20170 w 201706"/>
              <a:gd name="connsiteY29" fmla="*/ 1019735 h 2102223"/>
              <a:gd name="connsiteX30" fmla="*/ 8964 w 201706"/>
              <a:gd name="connsiteY30" fmla="*/ 1060076 h 2102223"/>
              <a:gd name="connsiteX31" fmla="*/ 6723 w 201706"/>
              <a:gd name="connsiteY31" fmla="*/ 1073523 h 2102223"/>
              <a:gd name="connsiteX32" fmla="*/ 0 w 201706"/>
              <a:gd name="connsiteY32" fmla="*/ 1098176 h 2102223"/>
              <a:gd name="connsiteX33" fmla="*/ 4482 w 201706"/>
              <a:gd name="connsiteY33" fmla="*/ 1183341 h 2102223"/>
              <a:gd name="connsiteX34" fmla="*/ 11206 w 201706"/>
              <a:gd name="connsiteY34" fmla="*/ 1207994 h 2102223"/>
              <a:gd name="connsiteX35" fmla="*/ 29135 w 201706"/>
              <a:gd name="connsiteY35" fmla="*/ 1335741 h 2102223"/>
              <a:gd name="connsiteX36" fmla="*/ 38100 w 201706"/>
              <a:gd name="connsiteY36" fmla="*/ 1346947 h 2102223"/>
              <a:gd name="connsiteX37" fmla="*/ 40341 w 201706"/>
              <a:gd name="connsiteY37" fmla="*/ 1353670 h 2102223"/>
              <a:gd name="connsiteX38" fmla="*/ 44823 w 201706"/>
              <a:gd name="connsiteY38" fmla="*/ 1362635 h 2102223"/>
              <a:gd name="connsiteX39" fmla="*/ 53788 w 201706"/>
              <a:gd name="connsiteY39" fmla="*/ 1378323 h 2102223"/>
              <a:gd name="connsiteX40" fmla="*/ 64994 w 201706"/>
              <a:gd name="connsiteY40" fmla="*/ 1402976 h 2102223"/>
              <a:gd name="connsiteX41" fmla="*/ 78441 w 201706"/>
              <a:gd name="connsiteY41" fmla="*/ 1425388 h 2102223"/>
              <a:gd name="connsiteX42" fmla="*/ 109817 w 201706"/>
              <a:gd name="connsiteY42" fmla="*/ 1492623 h 2102223"/>
              <a:gd name="connsiteX43" fmla="*/ 165847 w 201706"/>
              <a:gd name="connsiteY43" fmla="*/ 1580029 h 2102223"/>
              <a:gd name="connsiteX44" fmla="*/ 179294 w 201706"/>
              <a:gd name="connsiteY44" fmla="*/ 1609164 h 2102223"/>
              <a:gd name="connsiteX45" fmla="*/ 183776 w 201706"/>
              <a:gd name="connsiteY45" fmla="*/ 1624853 h 2102223"/>
              <a:gd name="connsiteX46" fmla="*/ 192741 w 201706"/>
              <a:gd name="connsiteY46" fmla="*/ 1640541 h 2102223"/>
              <a:gd name="connsiteX47" fmla="*/ 194982 w 201706"/>
              <a:gd name="connsiteY47" fmla="*/ 1667435 h 2102223"/>
              <a:gd name="connsiteX48" fmla="*/ 197223 w 201706"/>
              <a:gd name="connsiteY48" fmla="*/ 1678641 h 2102223"/>
              <a:gd name="connsiteX49" fmla="*/ 199464 w 201706"/>
              <a:gd name="connsiteY49" fmla="*/ 1716741 h 2102223"/>
              <a:gd name="connsiteX50" fmla="*/ 197223 w 201706"/>
              <a:gd name="connsiteY50" fmla="*/ 1748117 h 2102223"/>
              <a:gd name="connsiteX51" fmla="*/ 194982 w 201706"/>
              <a:gd name="connsiteY51" fmla="*/ 1763806 h 2102223"/>
              <a:gd name="connsiteX52" fmla="*/ 186017 w 201706"/>
              <a:gd name="connsiteY52" fmla="*/ 1781735 h 2102223"/>
              <a:gd name="connsiteX53" fmla="*/ 177053 w 201706"/>
              <a:gd name="connsiteY53" fmla="*/ 1801906 h 2102223"/>
              <a:gd name="connsiteX54" fmla="*/ 168088 w 201706"/>
              <a:gd name="connsiteY54" fmla="*/ 1826558 h 2102223"/>
              <a:gd name="connsiteX55" fmla="*/ 165847 w 201706"/>
              <a:gd name="connsiteY55" fmla="*/ 1842247 h 2102223"/>
              <a:gd name="connsiteX56" fmla="*/ 161364 w 201706"/>
              <a:gd name="connsiteY56" fmla="*/ 1857935 h 2102223"/>
              <a:gd name="connsiteX57" fmla="*/ 165847 w 201706"/>
              <a:gd name="connsiteY57" fmla="*/ 1956547 h 2102223"/>
              <a:gd name="connsiteX58" fmla="*/ 186017 w 201706"/>
              <a:gd name="connsiteY58" fmla="*/ 2026023 h 2102223"/>
              <a:gd name="connsiteX59" fmla="*/ 188259 w 201706"/>
              <a:gd name="connsiteY59" fmla="*/ 2039470 h 2102223"/>
              <a:gd name="connsiteX60" fmla="*/ 192741 w 201706"/>
              <a:gd name="connsiteY60" fmla="*/ 2073088 h 2102223"/>
              <a:gd name="connsiteX61" fmla="*/ 197223 w 201706"/>
              <a:gd name="connsiteY61" fmla="*/ 2079811 h 2102223"/>
              <a:gd name="connsiteX62" fmla="*/ 201706 w 201706"/>
              <a:gd name="connsiteY62" fmla="*/ 2102223 h 21022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</a:cxnLst>
            <a:rect l="l" t="t" r="r" b="b"/>
            <a:pathLst>
              <a:path w="201706" h="2102223">
                <a:moveTo>
                  <a:pt x="156882" y="0"/>
                </a:moveTo>
                <a:cubicBezTo>
                  <a:pt x="158376" y="5229"/>
                  <a:pt x="160297" y="10355"/>
                  <a:pt x="161364" y="15688"/>
                </a:cubicBezTo>
                <a:cubicBezTo>
                  <a:pt x="168189" y="49809"/>
                  <a:pt x="159935" y="95472"/>
                  <a:pt x="154641" y="123264"/>
                </a:cubicBezTo>
                <a:cubicBezTo>
                  <a:pt x="154016" y="126546"/>
                  <a:pt x="148729" y="126390"/>
                  <a:pt x="145676" y="127747"/>
                </a:cubicBezTo>
                <a:cubicBezTo>
                  <a:pt x="126224" y="136393"/>
                  <a:pt x="142162" y="127101"/>
                  <a:pt x="121023" y="141194"/>
                </a:cubicBezTo>
                <a:cubicBezTo>
                  <a:pt x="120276" y="144929"/>
                  <a:pt x="118613" y="148594"/>
                  <a:pt x="118782" y="152400"/>
                </a:cubicBezTo>
                <a:cubicBezTo>
                  <a:pt x="120113" y="182337"/>
                  <a:pt x="122853" y="212198"/>
                  <a:pt x="125506" y="242047"/>
                </a:cubicBezTo>
                <a:cubicBezTo>
                  <a:pt x="125843" y="245841"/>
                  <a:pt x="127168" y="249488"/>
                  <a:pt x="127747" y="253253"/>
                </a:cubicBezTo>
                <a:cubicBezTo>
                  <a:pt x="128663" y="259206"/>
                  <a:pt x="129241" y="265206"/>
                  <a:pt x="129988" y="271182"/>
                </a:cubicBezTo>
                <a:cubicBezTo>
                  <a:pt x="131482" y="310776"/>
                  <a:pt x="132491" y="350391"/>
                  <a:pt x="134470" y="389964"/>
                </a:cubicBezTo>
                <a:cubicBezTo>
                  <a:pt x="134799" y="396537"/>
                  <a:pt x="136800" y="407620"/>
                  <a:pt x="138953" y="414617"/>
                </a:cubicBezTo>
                <a:cubicBezTo>
                  <a:pt x="141037" y="421391"/>
                  <a:pt x="143676" y="427989"/>
                  <a:pt x="145676" y="434788"/>
                </a:cubicBezTo>
                <a:cubicBezTo>
                  <a:pt x="147414" y="440698"/>
                  <a:pt x="148665" y="446741"/>
                  <a:pt x="150159" y="452717"/>
                </a:cubicBezTo>
                <a:cubicBezTo>
                  <a:pt x="150906" y="458694"/>
                  <a:pt x="151021" y="464784"/>
                  <a:pt x="152400" y="470647"/>
                </a:cubicBezTo>
                <a:cubicBezTo>
                  <a:pt x="166389" y="530105"/>
                  <a:pt x="154220" y="461399"/>
                  <a:pt x="161364" y="504264"/>
                </a:cubicBezTo>
                <a:cubicBezTo>
                  <a:pt x="164316" y="575079"/>
                  <a:pt x="166456" y="592551"/>
                  <a:pt x="159123" y="679076"/>
                </a:cubicBezTo>
                <a:cubicBezTo>
                  <a:pt x="158755" y="683416"/>
                  <a:pt x="155074" y="686844"/>
                  <a:pt x="152400" y="690282"/>
                </a:cubicBezTo>
                <a:cubicBezTo>
                  <a:pt x="146070" y="698421"/>
                  <a:pt x="116622" y="721606"/>
                  <a:pt x="116541" y="721658"/>
                </a:cubicBezTo>
                <a:lnTo>
                  <a:pt x="91888" y="737347"/>
                </a:lnTo>
                <a:cubicBezTo>
                  <a:pt x="88900" y="741082"/>
                  <a:pt x="86123" y="744997"/>
                  <a:pt x="82923" y="748553"/>
                </a:cubicBezTo>
                <a:cubicBezTo>
                  <a:pt x="79389" y="752479"/>
                  <a:pt x="74960" y="755588"/>
                  <a:pt x="71717" y="759758"/>
                </a:cubicBezTo>
                <a:cubicBezTo>
                  <a:pt x="69666" y="762395"/>
                  <a:pt x="69088" y="765943"/>
                  <a:pt x="67235" y="768723"/>
                </a:cubicBezTo>
                <a:cubicBezTo>
                  <a:pt x="64582" y="772703"/>
                  <a:pt x="61258" y="776194"/>
                  <a:pt x="58270" y="779929"/>
                </a:cubicBezTo>
                <a:cubicBezTo>
                  <a:pt x="57523" y="785158"/>
                  <a:pt x="57699" y="790606"/>
                  <a:pt x="56029" y="795617"/>
                </a:cubicBezTo>
                <a:cubicBezTo>
                  <a:pt x="54652" y="799750"/>
                  <a:pt x="50022" y="802526"/>
                  <a:pt x="49306" y="806823"/>
                </a:cubicBezTo>
                <a:cubicBezTo>
                  <a:pt x="46969" y="820844"/>
                  <a:pt x="48154" y="835234"/>
                  <a:pt x="47064" y="849406"/>
                </a:cubicBezTo>
                <a:cubicBezTo>
                  <a:pt x="46659" y="854673"/>
                  <a:pt x="45570" y="859865"/>
                  <a:pt x="44823" y="865094"/>
                </a:cubicBezTo>
                <a:cubicBezTo>
                  <a:pt x="44076" y="883023"/>
                  <a:pt x="44207" y="901011"/>
                  <a:pt x="42582" y="918882"/>
                </a:cubicBezTo>
                <a:cubicBezTo>
                  <a:pt x="41178" y="934324"/>
                  <a:pt x="34136" y="977223"/>
                  <a:pt x="29135" y="995082"/>
                </a:cubicBezTo>
                <a:cubicBezTo>
                  <a:pt x="26777" y="1003502"/>
                  <a:pt x="22935" y="1011440"/>
                  <a:pt x="20170" y="1019735"/>
                </a:cubicBezTo>
                <a:cubicBezTo>
                  <a:pt x="16608" y="1030421"/>
                  <a:pt x="11444" y="1048502"/>
                  <a:pt x="8964" y="1060076"/>
                </a:cubicBezTo>
                <a:cubicBezTo>
                  <a:pt x="8012" y="1064519"/>
                  <a:pt x="7825" y="1069115"/>
                  <a:pt x="6723" y="1073523"/>
                </a:cubicBezTo>
                <a:cubicBezTo>
                  <a:pt x="-4650" y="1119017"/>
                  <a:pt x="7752" y="1059413"/>
                  <a:pt x="0" y="1098176"/>
                </a:cubicBezTo>
                <a:cubicBezTo>
                  <a:pt x="1494" y="1126564"/>
                  <a:pt x="2020" y="1155020"/>
                  <a:pt x="4482" y="1183341"/>
                </a:cubicBezTo>
                <a:cubicBezTo>
                  <a:pt x="5077" y="1190187"/>
                  <a:pt x="8726" y="1200556"/>
                  <a:pt x="11206" y="1207994"/>
                </a:cubicBezTo>
                <a:cubicBezTo>
                  <a:pt x="17182" y="1250576"/>
                  <a:pt x="20964" y="1293525"/>
                  <a:pt x="29135" y="1335741"/>
                </a:cubicBezTo>
                <a:cubicBezTo>
                  <a:pt x="30044" y="1340437"/>
                  <a:pt x="35565" y="1342891"/>
                  <a:pt x="38100" y="1346947"/>
                </a:cubicBezTo>
                <a:cubicBezTo>
                  <a:pt x="39352" y="1348950"/>
                  <a:pt x="39411" y="1351499"/>
                  <a:pt x="40341" y="1353670"/>
                </a:cubicBezTo>
                <a:cubicBezTo>
                  <a:pt x="41657" y="1356741"/>
                  <a:pt x="43223" y="1359702"/>
                  <a:pt x="44823" y="1362635"/>
                </a:cubicBezTo>
                <a:cubicBezTo>
                  <a:pt x="47707" y="1367923"/>
                  <a:pt x="51094" y="1372936"/>
                  <a:pt x="53788" y="1378323"/>
                </a:cubicBezTo>
                <a:cubicBezTo>
                  <a:pt x="57825" y="1386397"/>
                  <a:pt x="60806" y="1394980"/>
                  <a:pt x="64994" y="1402976"/>
                </a:cubicBezTo>
                <a:cubicBezTo>
                  <a:pt x="69037" y="1410694"/>
                  <a:pt x="74545" y="1417596"/>
                  <a:pt x="78441" y="1425388"/>
                </a:cubicBezTo>
                <a:cubicBezTo>
                  <a:pt x="78777" y="1426061"/>
                  <a:pt x="103144" y="1481946"/>
                  <a:pt x="109817" y="1492623"/>
                </a:cubicBezTo>
                <a:cubicBezTo>
                  <a:pt x="128661" y="1522774"/>
                  <a:pt x="150197" y="1548729"/>
                  <a:pt x="165847" y="1580029"/>
                </a:cubicBezTo>
                <a:cubicBezTo>
                  <a:pt x="170630" y="1589596"/>
                  <a:pt x="175322" y="1599233"/>
                  <a:pt x="179294" y="1609164"/>
                </a:cubicBezTo>
                <a:cubicBezTo>
                  <a:pt x="181314" y="1614214"/>
                  <a:pt x="181634" y="1619854"/>
                  <a:pt x="183776" y="1624853"/>
                </a:cubicBezTo>
                <a:cubicBezTo>
                  <a:pt x="186149" y="1630389"/>
                  <a:pt x="189753" y="1635312"/>
                  <a:pt x="192741" y="1640541"/>
                </a:cubicBezTo>
                <a:cubicBezTo>
                  <a:pt x="193488" y="1649506"/>
                  <a:pt x="193931" y="1658501"/>
                  <a:pt x="194982" y="1667435"/>
                </a:cubicBezTo>
                <a:cubicBezTo>
                  <a:pt x="195427" y="1671218"/>
                  <a:pt x="196878" y="1674847"/>
                  <a:pt x="197223" y="1678641"/>
                </a:cubicBezTo>
                <a:cubicBezTo>
                  <a:pt x="198375" y="1691311"/>
                  <a:pt x="198717" y="1704041"/>
                  <a:pt x="199464" y="1716741"/>
                </a:cubicBezTo>
                <a:cubicBezTo>
                  <a:pt x="198717" y="1727200"/>
                  <a:pt x="198217" y="1737679"/>
                  <a:pt x="197223" y="1748117"/>
                </a:cubicBezTo>
                <a:cubicBezTo>
                  <a:pt x="196722" y="1753376"/>
                  <a:pt x="196653" y="1758794"/>
                  <a:pt x="194982" y="1763806"/>
                </a:cubicBezTo>
                <a:cubicBezTo>
                  <a:pt x="192869" y="1770145"/>
                  <a:pt x="188862" y="1775689"/>
                  <a:pt x="186017" y="1781735"/>
                </a:cubicBezTo>
                <a:cubicBezTo>
                  <a:pt x="182884" y="1788392"/>
                  <a:pt x="180041" y="1795182"/>
                  <a:pt x="177053" y="1801906"/>
                </a:cubicBezTo>
                <a:cubicBezTo>
                  <a:pt x="169254" y="1840903"/>
                  <a:pt x="182536" y="1779603"/>
                  <a:pt x="168088" y="1826558"/>
                </a:cubicBezTo>
                <a:cubicBezTo>
                  <a:pt x="166534" y="1831607"/>
                  <a:pt x="166954" y="1837082"/>
                  <a:pt x="165847" y="1842247"/>
                </a:cubicBezTo>
                <a:cubicBezTo>
                  <a:pt x="164707" y="1847565"/>
                  <a:pt x="162858" y="1852706"/>
                  <a:pt x="161364" y="1857935"/>
                </a:cubicBezTo>
                <a:cubicBezTo>
                  <a:pt x="162858" y="1890806"/>
                  <a:pt x="162269" y="1923837"/>
                  <a:pt x="165847" y="1956547"/>
                </a:cubicBezTo>
                <a:cubicBezTo>
                  <a:pt x="168452" y="1980367"/>
                  <a:pt x="177877" y="2003637"/>
                  <a:pt x="186017" y="2026023"/>
                </a:cubicBezTo>
                <a:cubicBezTo>
                  <a:pt x="186764" y="2030505"/>
                  <a:pt x="187695" y="2034961"/>
                  <a:pt x="188259" y="2039470"/>
                </a:cubicBezTo>
                <a:cubicBezTo>
                  <a:pt x="188660" y="2042675"/>
                  <a:pt x="190154" y="2066188"/>
                  <a:pt x="192741" y="2073088"/>
                </a:cubicBezTo>
                <a:cubicBezTo>
                  <a:pt x="193687" y="2075610"/>
                  <a:pt x="195729" y="2077570"/>
                  <a:pt x="197223" y="2079811"/>
                </a:cubicBezTo>
                <a:cubicBezTo>
                  <a:pt x="199798" y="2097839"/>
                  <a:pt x="197793" y="2090489"/>
                  <a:pt x="201706" y="2102223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Freeform 1"/>
          <p:cNvSpPr/>
          <p:nvPr/>
        </p:nvSpPr>
        <p:spPr>
          <a:xfrm>
            <a:off x="3660775" y="2824923"/>
            <a:ext cx="200162" cy="1466850"/>
          </a:xfrm>
          <a:custGeom>
            <a:avLst/>
            <a:gdLst>
              <a:gd name="connsiteX0" fmla="*/ 130175 w 200162"/>
              <a:gd name="connsiteY0" fmla="*/ 0 h 1466850"/>
              <a:gd name="connsiteX1" fmla="*/ 133350 w 200162"/>
              <a:gd name="connsiteY1" fmla="*/ 19050 h 1466850"/>
              <a:gd name="connsiteX2" fmla="*/ 146050 w 200162"/>
              <a:gd name="connsiteY2" fmla="*/ 38100 h 1466850"/>
              <a:gd name="connsiteX3" fmla="*/ 152400 w 200162"/>
              <a:gd name="connsiteY3" fmla="*/ 57150 h 1466850"/>
              <a:gd name="connsiteX4" fmla="*/ 155575 w 200162"/>
              <a:gd name="connsiteY4" fmla="*/ 66675 h 1466850"/>
              <a:gd name="connsiteX5" fmla="*/ 161925 w 200162"/>
              <a:gd name="connsiteY5" fmla="*/ 101600 h 1466850"/>
              <a:gd name="connsiteX6" fmla="*/ 171450 w 200162"/>
              <a:gd name="connsiteY6" fmla="*/ 133350 h 1466850"/>
              <a:gd name="connsiteX7" fmla="*/ 177800 w 200162"/>
              <a:gd name="connsiteY7" fmla="*/ 161925 h 1466850"/>
              <a:gd name="connsiteX8" fmla="*/ 184150 w 200162"/>
              <a:gd name="connsiteY8" fmla="*/ 180975 h 1466850"/>
              <a:gd name="connsiteX9" fmla="*/ 190500 w 200162"/>
              <a:gd name="connsiteY9" fmla="*/ 212725 h 1466850"/>
              <a:gd name="connsiteX10" fmla="*/ 184150 w 200162"/>
              <a:gd name="connsiteY10" fmla="*/ 266700 h 1466850"/>
              <a:gd name="connsiteX11" fmla="*/ 177800 w 200162"/>
              <a:gd name="connsiteY11" fmla="*/ 276225 h 1466850"/>
              <a:gd name="connsiteX12" fmla="*/ 168275 w 200162"/>
              <a:gd name="connsiteY12" fmla="*/ 285750 h 1466850"/>
              <a:gd name="connsiteX13" fmla="*/ 155575 w 200162"/>
              <a:gd name="connsiteY13" fmla="*/ 304800 h 1466850"/>
              <a:gd name="connsiteX14" fmla="*/ 149225 w 200162"/>
              <a:gd name="connsiteY14" fmla="*/ 314325 h 1466850"/>
              <a:gd name="connsiteX15" fmla="*/ 142875 w 200162"/>
              <a:gd name="connsiteY15" fmla="*/ 333375 h 1466850"/>
              <a:gd name="connsiteX16" fmla="*/ 133350 w 200162"/>
              <a:gd name="connsiteY16" fmla="*/ 374650 h 1466850"/>
              <a:gd name="connsiteX17" fmla="*/ 130175 w 200162"/>
              <a:gd name="connsiteY17" fmla="*/ 384175 h 1466850"/>
              <a:gd name="connsiteX18" fmla="*/ 120650 w 200162"/>
              <a:gd name="connsiteY18" fmla="*/ 393700 h 1466850"/>
              <a:gd name="connsiteX19" fmla="*/ 117475 w 200162"/>
              <a:gd name="connsiteY19" fmla="*/ 403225 h 1466850"/>
              <a:gd name="connsiteX20" fmla="*/ 92075 w 200162"/>
              <a:gd name="connsiteY20" fmla="*/ 431800 h 1466850"/>
              <a:gd name="connsiteX21" fmla="*/ 82550 w 200162"/>
              <a:gd name="connsiteY21" fmla="*/ 434975 h 1466850"/>
              <a:gd name="connsiteX22" fmla="*/ 73025 w 200162"/>
              <a:gd name="connsiteY22" fmla="*/ 441325 h 1466850"/>
              <a:gd name="connsiteX23" fmla="*/ 60325 w 200162"/>
              <a:gd name="connsiteY23" fmla="*/ 444500 h 1466850"/>
              <a:gd name="connsiteX24" fmla="*/ 41275 w 200162"/>
              <a:gd name="connsiteY24" fmla="*/ 450850 h 1466850"/>
              <a:gd name="connsiteX25" fmla="*/ 31750 w 200162"/>
              <a:gd name="connsiteY25" fmla="*/ 454025 h 1466850"/>
              <a:gd name="connsiteX26" fmla="*/ 22225 w 200162"/>
              <a:gd name="connsiteY26" fmla="*/ 460375 h 1466850"/>
              <a:gd name="connsiteX27" fmla="*/ 9525 w 200162"/>
              <a:gd name="connsiteY27" fmla="*/ 479425 h 1466850"/>
              <a:gd name="connsiteX28" fmla="*/ 3175 w 200162"/>
              <a:gd name="connsiteY28" fmla="*/ 488950 h 1466850"/>
              <a:gd name="connsiteX29" fmla="*/ 0 w 200162"/>
              <a:gd name="connsiteY29" fmla="*/ 498475 h 1466850"/>
              <a:gd name="connsiteX30" fmla="*/ 3175 w 200162"/>
              <a:gd name="connsiteY30" fmla="*/ 600075 h 1466850"/>
              <a:gd name="connsiteX31" fmla="*/ 6350 w 200162"/>
              <a:gd name="connsiteY31" fmla="*/ 615950 h 1466850"/>
              <a:gd name="connsiteX32" fmla="*/ 9525 w 200162"/>
              <a:gd name="connsiteY32" fmla="*/ 625475 h 1466850"/>
              <a:gd name="connsiteX33" fmla="*/ 19050 w 200162"/>
              <a:gd name="connsiteY33" fmla="*/ 628650 h 1466850"/>
              <a:gd name="connsiteX34" fmla="*/ 88900 w 200162"/>
              <a:gd name="connsiteY34" fmla="*/ 631825 h 1466850"/>
              <a:gd name="connsiteX35" fmla="*/ 101600 w 200162"/>
              <a:gd name="connsiteY35" fmla="*/ 641350 h 1466850"/>
              <a:gd name="connsiteX36" fmla="*/ 111125 w 200162"/>
              <a:gd name="connsiteY36" fmla="*/ 650875 h 1466850"/>
              <a:gd name="connsiteX37" fmla="*/ 120650 w 200162"/>
              <a:gd name="connsiteY37" fmla="*/ 654050 h 1466850"/>
              <a:gd name="connsiteX38" fmla="*/ 130175 w 200162"/>
              <a:gd name="connsiteY38" fmla="*/ 660400 h 1466850"/>
              <a:gd name="connsiteX39" fmla="*/ 136525 w 200162"/>
              <a:gd name="connsiteY39" fmla="*/ 701675 h 1466850"/>
              <a:gd name="connsiteX40" fmla="*/ 139700 w 200162"/>
              <a:gd name="connsiteY40" fmla="*/ 720725 h 1466850"/>
              <a:gd name="connsiteX41" fmla="*/ 165100 w 200162"/>
              <a:gd name="connsiteY41" fmla="*/ 749300 h 1466850"/>
              <a:gd name="connsiteX42" fmla="*/ 174625 w 200162"/>
              <a:gd name="connsiteY42" fmla="*/ 758825 h 1466850"/>
              <a:gd name="connsiteX43" fmla="*/ 190500 w 200162"/>
              <a:gd name="connsiteY43" fmla="*/ 781050 h 1466850"/>
              <a:gd name="connsiteX44" fmla="*/ 193675 w 200162"/>
              <a:gd name="connsiteY44" fmla="*/ 790575 h 1466850"/>
              <a:gd name="connsiteX45" fmla="*/ 200025 w 200162"/>
              <a:gd name="connsiteY45" fmla="*/ 800100 h 1466850"/>
              <a:gd name="connsiteX46" fmla="*/ 193675 w 200162"/>
              <a:gd name="connsiteY46" fmla="*/ 854075 h 1466850"/>
              <a:gd name="connsiteX47" fmla="*/ 187325 w 200162"/>
              <a:gd name="connsiteY47" fmla="*/ 863600 h 1466850"/>
              <a:gd name="connsiteX48" fmla="*/ 177800 w 200162"/>
              <a:gd name="connsiteY48" fmla="*/ 873125 h 1466850"/>
              <a:gd name="connsiteX49" fmla="*/ 174625 w 200162"/>
              <a:gd name="connsiteY49" fmla="*/ 882650 h 1466850"/>
              <a:gd name="connsiteX50" fmla="*/ 168275 w 200162"/>
              <a:gd name="connsiteY50" fmla="*/ 895350 h 1466850"/>
              <a:gd name="connsiteX51" fmla="*/ 171450 w 200162"/>
              <a:gd name="connsiteY51" fmla="*/ 968375 h 1466850"/>
              <a:gd name="connsiteX52" fmla="*/ 174625 w 200162"/>
              <a:gd name="connsiteY52" fmla="*/ 977900 h 1466850"/>
              <a:gd name="connsiteX53" fmla="*/ 180975 w 200162"/>
              <a:gd name="connsiteY53" fmla="*/ 987425 h 1466850"/>
              <a:gd name="connsiteX54" fmla="*/ 193675 w 200162"/>
              <a:gd name="connsiteY54" fmla="*/ 1003300 h 1466850"/>
              <a:gd name="connsiteX55" fmla="*/ 193675 w 200162"/>
              <a:gd name="connsiteY55" fmla="*/ 1038225 h 1466850"/>
              <a:gd name="connsiteX56" fmla="*/ 184150 w 200162"/>
              <a:gd name="connsiteY56" fmla="*/ 1063625 h 1466850"/>
              <a:gd name="connsiteX57" fmla="*/ 174625 w 200162"/>
              <a:gd name="connsiteY57" fmla="*/ 1069975 h 1466850"/>
              <a:gd name="connsiteX58" fmla="*/ 155575 w 200162"/>
              <a:gd name="connsiteY58" fmla="*/ 1089025 h 1466850"/>
              <a:gd name="connsiteX59" fmla="*/ 142875 w 200162"/>
              <a:gd name="connsiteY59" fmla="*/ 1108075 h 1466850"/>
              <a:gd name="connsiteX60" fmla="*/ 136525 w 200162"/>
              <a:gd name="connsiteY60" fmla="*/ 1120775 h 1466850"/>
              <a:gd name="connsiteX61" fmla="*/ 127000 w 200162"/>
              <a:gd name="connsiteY61" fmla="*/ 1127125 h 1466850"/>
              <a:gd name="connsiteX62" fmla="*/ 117475 w 200162"/>
              <a:gd name="connsiteY62" fmla="*/ 1146175 h 1466850"/>
              <a:gd name="connsiteX63" fmla="*/ 114300 w 200162"/>
              <a:gd name="connsiteY63" fmla="*/ 1155700 h 1466850"/>
              <a:gd name="connsiteX64" fmla="*/ 107950 w 200162"/>
              <a:gd name="connsiteY64" fmla="*/ 1168400 h 1466850"/>
              <a:gd name="connsiteX65" fmla="*/ 104775 w 200162"/>
              <a:gd name="connsiteY65" fmla="*/ 1181100 h 1466850"/>
              <a:gd name="connsiteX66" fmla="*/ 98425 w 200162"/>
              <a:gd name="connsiteY66" fmla="*/ 1190625 h 1466850"/>
              <a:gd name="connsiteX67" fmla="*/ 92075 w 200162"/>
              <a:gd name="connsiteY67" fmla="*/ 1203325 h 1466850"/>
              <a:gd name="connsiteX68" fmla="*/ 85725 w 200162"/>
              <a:gd name="connsiteY68" fmla="*/ 1225550 h 1466850"/>
              <a:gd name="connsiteX69" fmla="*/ 82550 w 200162"/>
              <a:gd name="connsiteY69" fmla="*/ 1235075 h 1466850"/>
              <a:gd name="connsiteX70" fmla="*/ 73025 w 200162"/>
              <a:gd name="connsiteY70" fmla="*/ 1266825 h 1466850"/>
              <a:gd name="connsiteX71" fmla="*/ 53975 w 200162"/>
              <a:gd name="connsiteY71" fmla="*/ 1282700 h 1466850"/>
              <a:gd name="connsiteX72" fmla="*/ 34925 w 200162"/>
              <a:gd name="connsiteY72" fmla="*/ 1289050 h 1466850"/>
              <a:gd name="connsiteX73" fmla="*/ 15875 w 200162"/>
              <a:gd name="connsiteY73" fmla="*/ 1301750 h 1466850"/>
              <a:gd name="connsiteX74" fmla="*/ 19050 w 200162"/>
              <a:gd name="connsiteY74" fmla="*/ 1381125 h 1466850"/>
              <a:gd name="connsiteX75" fmla="*/ 22225 w 200162"/>
              <a:gd name="connsiteY75" fmla="*/ 1390650 h 1466850"/>
              <a:gd name="connsiteX76" fmla="*/ 38100 w 200162"/>
              <a:gd name="connsiteY76" fmla="*/ 1409700 h 1466850"/>
              <a:gd name="connsiteX77" fmla="*/ 44450 w 200162"/>
              <a:gd name="connsiteY77" fmla="*/ 1428750 h 1466850"/>
              <a:gd name="connsiteX78" fmla="*/ 41275 w 200162"/>
              <a:gd name="connsiteY78" fmla="*/ 1466850 h 1466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</a:cxnLst>
            <a:rect l="l" t="t" r="r" b="b"/>
            <a:pathLst>
              <a:path w="200162" h="1466850">
                <a:moveTo>
                  <a:pt x="130175" y="0"/>
                </a:moveTo>
                <a:cubicBezTo>
                  <a:pt x="131233" y="6350"/>
                  <a:pt x="130874" y="13108"/>
                  <a:pt x="133350" y="19050"/>
                </a:cubicBezTo>
                <a:cubicBezTo>
                  <a:pt x="136285" y="26095"/>
                  <a:pt x="143637" y="30860"/>
                  <a:pt x="146050" y="38100"/>
                </a:cubicBezTo>
                <a:lnTo>
                  <a:pt x="152400" y="57150"/>
                </a:lnTo>
                <a:cubicBezTo>
                  <a:pt x="153458" y="60325"/>
                  <a:pt x="155025" y="63374"/>
                  <a:pt x="155575" y="66675"/>
                </a:cubicBezTo>
                <a:cubicBezTo>
                  <a:pt x="157873" y="80461"/>
                  <a:pt x="158967" y="88287"/>
                  <a:pt x="161925" y="101600"/>
                </a:cubicBezTo>
                <a:cubicBezTo>
                  <a:pt x="167876" y="128379"/>
                  <a:pt x="161952" y="98526"/>
                  <a:pt x="171450" y="133350"/>
                </a:cubicBezTo>
                <a:cubicBezTo>
                  <a:pt x="180514" y="166583"/>
                  <a:pt x="169247" y="133414"/>
                  <a:pt x="177800" y="161925"/>
                </a:cubicBezTo>
                <a:cubicBezTo>
                  <a:pt x="179723" y="168336"/>
                  <a:pt x="182837" y="174411"/>
                  <a:pt x="184150" y="180975"/>
                </a:cubicBezTo>
                <a:lnTo>
                  <a:pt x="190500" y="212725"/>
                </a:lnTo>
                <a:cubicBezTo>
                  <a:pt x="189998" y="219748"/>
                  <a:pt x="191366" y="252267"/>
                  <a:pt x="184150" y="266700"/>
                </a:cubicBezTo>
                <a:cubicBezTo>
                  <a:pt x="182443" y="270113"/>
                  <a:pt x="180243" y="273294"/>
                  <a:pt x="177800" y="276225"/>
                </a:cubicBezTo>
                <a:cubicBezTo>
                  <a:pt x="174925" y="279674"/>
                  <a:pt x="171032" y="282206"/>
                  <a:pt x="168275" y="285750"/>
                </a:cubicBezTo>
                <a:cubicBezTo>
                  <a:pt x="163590" y="291774"/>
                  <a:pt x="159808" y="298450"/>
                  <a:pt x="155575" y="304800"/>
                </a:cubicBezTo>
                <a:cubicBezTo>
                  <a:pt x="153458" y="307975"/>
                  <a:pt x="150432" y="310705"/>
                  <a:pt x="149225" y="314325"/>
                </a:cubicBezTo>
                <a:lnTo>
                  <a:pt x="142875" y="333375"/>
                </a:lnTo>
                <a:cubicBezTo>
                  <a:pt x="138753" y="362226"/>
                  <a:pt x="142067" y="348500"/>
                  <a:pt x="133350" y="374650"/>
                </a:cubicBezTo>
                <a:cubicBezTo>
                  <a:pt x="132292" y="377825"/>
                  <a:pt x="132542" y="381808"/>
                  <a:pt x="130175" y="384175"/>
                </a:cubicBezTo>
                <a:lnTo>
                  <a:pt x="120650" y="393700"/>
                </a:lnTo>
                <a:cubicBezTo>
                  <a:pt x="119592" y="396875"/>
                  <a:pt x="118972" y="400232"/>
                  <a:pt x="117475" y="403225"/>
                </a:cubicBezTo>
                <a:cubicBezTo>
                  <a:pt x="113240" y="411696"/>
                  <a:pt x="97124" y="430117"/>
                  <a:pt x="92075" y="431800"/>
                </a:cubicBezTo>
                <a:cubicBezTo>
                  <a:pt x="88900" y="432858"/>
                  <a:pt x="85543" y="433478"/>
                  <a:pt x="82550" y="434975"/>
                </a:cubicBezTo>
                <a:cubicBezTo>
                  <a:pt x="79137" y="436682"/>
                  <a:pt x="76532" y="439822"/>
                  <a:pt x="73025" y="441325"/>
                </a:cubicBezTo>
                <a:cubicBezTo>
                  <a:pt x="69014" y="443044"/>
                  <a:pt x="64505" y="443246"/>
                  <a:pt x="60325" y="444500"/>
                </a:cubicBezTo>
                <a:cubicBezTo>
                  <a:pt x="53914" y="446423"/>
                  <a:pt x="47625" y="448733"/>
                  <a:pt x="41275" y="450850"/>
                </a:cubicBezTo>
                <a:cubicBezTo>
                  <a:pt x="38100" y="451908"/>
                  <a:pt x="34535" y="452169"/>
                  <a:pt x="31750" y="454025"/>
                </a:cubicBezTo>
                <a:lnTo>
                  <a:pt x="22225" y="460375"/>
                </a:lnTo>
                <a:lnTo>
                  <a:pt x="9525" y="479425"/>
                </a:lnTo>
                <a:cubicBezTo>
                  <a:pt x="7408" y="482600"/>
                  <a:pt x="4382" y="485330"/>
                  <a:pt x="3175" y="488950"/>
                </a:cubicBezTo>
                <a:lnTo>
                  <a:pt x="0" y="498475"/>
                </a:lnTo>
                <a:cubicBezTo>
                  <a:pt x="1058" y="532342"/>
                  <a:pt x="1346" y="566241"/>
                  <a:pt x="3175" y="600075"/>
                </a:cubicBezTo>
                <a:cubicBezTo>
                  <a:pt x="3466" y="605464"/>
                  <a:pt x="5041" y="610715"/>
                  <a:pt x="6350" y="615950"/>
                </a:cubicBezTo>
                <a:cubicBezTo>
                  <a:pt x="7162" y="619197"/>
                  <a:pt x="7158" y="623108"/>
                  <a:pt x="9525" y="625475"/>
                </a:cubicBezTo>
                <a:cubicBezTo>
                  <a:pt x="11892" y="627842"/>
                  <a:pt x="15714" y="628383"/>
                  <a:pt x="19050" y="628650"/>
                </a:cubicBezTo>
                <a:cubicBezTo>
                  <a:pt x="42283" y="630509"/>
                  <a:pt x="65617" y="630767"/>
                  <a:pt x="88900" y="631825"/>
                </a:cubicBezTo>
                <a:cubicBezTo>
                  <a:pt x="93133" y="635000"/>
                  <a:pt x="97582" y="637906"/>
                  <a:pt x="101600" y="641350"/>
                </a:cubicBezTo>
                <a:cubicBezTo>
                  <a:pt x="105009" y="644272"/>
                  <a:pt x="107389" y="648384"/>
                  <a:pt x="111125" y="650875"/>
                </a:cubicBezTo>
                <a:cubicBezTo>
                  <a:pt x="113910" y="652731"/>
                  <a:pt x="117657" y="652553"/>
                  <a:pt x="120650" y="654050"/>
                </a:cubicBezTo>
                <a:cubicBezTo>
                  <a:pt x="124063" y="655757"/>
                  <a:pt x="127000" y="658283"/>
                  <a:pt x="130175" y="660400"/>
                </a:cubicBezTo>
                <a:cubicBezTo>
                  <a:pt x="138095" y="707918"/>
                  <a:pt x="128354" y="648565"/>
                  <a:pt x="136525" y="701675"/>
                </a:cubicBezTo>
                <a:cubicBezTo>
                  <a:pt x="137504" y="708038"/>
                  <a:pt x="137664" y="714618"/>
                  <a:pt x="139700" y="720725"/>
                </a:cubicBezTo>
                <a:cubicBezTo>
                  <a:pt x="142533" y="729224"/>
                  <a:pt x="163352" y="747552"/>
                  <a:pt x="165100" y="749300"/>
                </a:cubicBezTo>
                <a:cubicBezTo>
                  <a:pt x="168275" y="752475"/>
                  <a:pt x="172134" y="755089"/>
                  <a:pt x="174625" y="758825"/>
                </a:cubicBezTo>
                <a:cubicBezTo>
                  <a:pt x="183910" y="772753"/>
                  <a:pt x="178685" y="765297"/>
                  <a:pt x="190500" y="781050"/>
                </a:cubicBezTo>
                <a:cubicBezTo>
                  <a:pt x="191558" y="784225"/>
                  <a:pt x="192178" y="787582"/>
                  <a:pt x="193675" y="790575"/>
                </a:cubicBezTo>
                <a:cubicBezTo>
                  <a:pt x="195382" y="793988"/>
                  <a:pt x="199801" y="796291"/>
                  <a:pt x="200025" y="800100"/>
                </a:cubicBezTo>
                <a:cubicBezTo>
                  <a:pt x="200342" y="805486"/>
                  <a:pt x="200707" y="840011"/>
                  <a:pt x="193675" y="854075"/>
                </a:cubicBezTo>
                <a:cubicBezTo>
                  <a:pt x="191968" y="857488"/>
                  <a:pt x="189768" y="860669"/>
                  <a:pt x="187325" y="863600"/>
                </a:cubicBezTo>
                <a:cubicBezTo>
                  <a:pt x="184450" y="867049"/>
                  <a:pt x="180975" y="869950"/>
                  <a:pt x="177800" y="873125"/>
                </a:cubicBezTo>
                <a:cubicBezTo>
                  <a:pt x="176742" y="876300"/>
                  <a:pt x="175943" y="879574"/>
                  <a:pt x="174625" y="882650"/>
                </a:cubicBezTo>
                <a:cubicBezTo>
                  <a:pt x="172761" y="887000"/>
                  <a:pt x="168450" y="890620"/>
                  <a:pt x="168275" y="895350"/>
                </a:cubicBezTo>
                <a:cubicBezTo>
                  <a:pt x="167373" y="919698"/>
                  <a:pt x="169581" y="944082"/>
                  <a:pt x="171450" y="968375"/>
                </a:cubicBezTo>
                <a:cubicBezTo>
                  <a:pt x="171707" y="971712"/>
                  <a:pt x="173128" y="974907"/>
                  <a:pt x="174625" y="977900"/>
                </a:cubicBezTo>
                <a:cubicBezTo>
                  <a:pt x="176332" y="981313"/>
                  <a:pt x="179268" y="984012"/>
                  <a:pt x="180975" y="987425"/>
                </a:cubicBezTo>
                <a:cubicBezTo>
                  <a:pt x="188643" y="1002761"/>
                  <a:pt x="177618" y="992596"/>
                  <a:pt x="193675" y="1003300"/>
                </a:cubicBezTo>
                <a:cubicBezTo>
                  <a:pt x="199326" y="1020253"/>
                  <a:pt x="197832" y="1011205"/>
                  <a:pt x="193675" y="1038225"/>
                </a:cubicBezTo>
                <a:cubicBezTo>
                  <a:pt x="192023" y="1048964"/>
                  <a:pt x="191887" y="1055888"/>
                  <a:pt x="184150" y="1063625"/>
                </a:cubicBezTo>
                <a:cubicBezTo>
                  <a:pt x="181452" y="1066323"/>
                  <a:pt x="177800" y="1067858"/>
                  <a:pt x="174625" y="1069975"/>
                </a:cubicBezTo>
                <a:cubicBezTo>
                  <a:pt x="153980" y="1100942"/>
                  <a:pt x="187080" y="1053581"/>
                  <a:pt x="155575" y="1089025"/>
                </a:cubicBezTo>
                <a:cubicBezTo>
                  <a:pt x="150505" y="1094729"/>
                  <a:pt x="147108" y="1101725"/>
                  <a:pt x="142875" y="1108075"/>
                </a:cubicBezTo>
                <a:cubicBezTo>
                  <a:pt x="140250" y="1112013"/>
                  <a:pt x="139555" y="1117139"/>
                  <a:pt x="136525" y="1120775"/>
                </a:cubicBezTo>
                <a:cubicBezTo>
                  <a:pt x="134082" y="1123706"/>
                  <a:pt x="130175" y="1125008"/>
                  <a:pt x="127000" y="1127125"/>
                </a:cubicBezTo>
                <a:cubicBezTo>
                  <a:pt x="119020" y="1151066"/>
                  <a:pt x="129785" y="1121556"/>
                  <a:pt x="117475" y="1146175"/>
                </a:cubicBezTo>
                <a:cubicBezTo>
                  <a:pt x="115978" y="1149168"/>
                  <a:pt x="115618" y="1152624"/>
                  <a:pt x="114300" y="1155700"/>
                </a:cubicBezTo>
                <a:cubicBezTo>
                  <a:pt x="112436" y="1160050"/>
                  <a:pt x="109612" y="1163968"/>
                  <a:pt x="107950" y="1168400"/>
                </a:cubicBezTo>
                <a:cubicBezTo>
                  <a:pt x="106418" y="1172486"/>
                  <a:pt x="106494" y="1177089"/>
                  <a:pt x="104775" y="1181100"/>
                </a:cubicBezTo>
                <a:cubicBezTo>
                  <a:pt x="103272" y="1184607"/>
                  <a:pt x="100318" y="1187312"/>
                  <a:pt x="98425" y="1190625"/>
                </a:cubicBezTo>
                <a:cubicBezTo>
                  <a:pt x="96077" y="1194734"/>
                  <a:pt x="93939" y="1198975"/>
                  <a:pt x="92075" y="1203325"/>
                </a:cubicBezTo>
                <a:cubicBezTo>
                  <a:pt x="88812" y="1210938"/>
                  <a:pt x="88027" y="1217494"/>
                  <a:pt x="85725" y="1225550"/>
                </a:cubicBezTo>
                <a:cubicBezTo>
                  <a:pt x="84806" y="1228768"/>
                  <a:pt x="83362" y="1231828"/>
                  <a:pt x="82550" y="1235075"/>
                </a:cubicBezTo>
                <a:cubicBezTo>
                  <a:pt x="79435" y="1247535"/>
                  <a:pt x="80135" y="1255448"/>
                  <a:pt x="73025" y="1266825"/>
                </a:cubicBezTo>
                <a:cubicBezTo>
                  <a:pt x="70149" y="1271426"/>
                  <a:pt x="59292" y="1280337"/>
                  <a:pt x="53975" y="1282700"/>
                </a:cubicBezTo>
                <a:cubicBezTo>
                  <a:pt x="47858" y="1285418"/>
                  <a:pt x="40494" y="1285337"/>
                  <a:pt x="34925" y="1289050"/>
                </a:cubicBezTo>
                <a:lnTo>
                  <a:pt x="15875" y="1301750"/>
                </a:lnTo>
                <a:cubicBezTo>
                  <a:pt x="6577" y="1329645"/>
                  <a:pt x="3526" y="1334554"/>
                  <a:pt x="19050" y="1381125"/>
                </a:cubicBezTo>
                <a:cubicBezTo>
                  <a:pt x="20108" y="1384300"/>
                  <a:pt x="20728" y="1387657"/>
                  <a:pt x="22225" y="1390650"/>
                </a:cubicBezTo>
                <a:cubicBezTo>
                  <a:pt x="26645" y="1399491"/>
                  <a:pt x="31078" y="1402678"/>
                  <a:pt x="38100" y="1409700"/>
                </a:cubicBezTo>
                <a:cubicBezTo>
                  <a:pt x="40217" y="1416050"/>
                  <a:pt x="45189" y="1422097"/>
                  <a:pt x="44450" y="1428750"/>
                </a:cubicBezTo>
                <a:cubicBezTo>
                  <a:pt x="40924" y="1460481"/>
                  <a:pt x="41275" y="1447741"/>
                  <a:pt x="41275" y="1466850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reeform 2"/>
          <p:cNvSpPr/>
          <p:nvPr/>
        </p:nvSpPr>
        <p:spPr>
          <a:xfrm>
            <a:off x="5162550" y="2820116"/>
            <a:ext cx="422275" cy="1460500"/>
          </a:xfrm>
          <a:custGeom>
            <a:avLst/>
            <a:gdLst>
              <a:gd name="connsiteX0" fmla="*/ 422275 w 422275"/>
              <a:gd name="connsiteY0" fmla="*/ 0 h 1460500"/>
              <a:gd name="connsiteX1" fmla="*/ 419100 w 422275"/>
              <a:gd name="connsiteY1" fmla="*/ 53975 h 1460500"/>
              <a:gd name="connsiteX2" fmla="*/ 415925 w 422275"/>
              <a:gd name="connsiteY2" fmla="*/ 69850 h 1460500"/>
              <a:gd name="connsiteX3" fmla="*/ 400050 w 422275"/>
              <a:gd name="connsiteY3" fmla="*/ 111125 h 1460500"/>
              <a:gd name="connsiteX4" fmla="*/ 387350 w 422275"/>
              <a:gd name="connsiteY4" fmla="*/ 130175 h 1460500"/>
              <a:gd name="connsiteX5" fmla="*/ 355600 w 422275"/>
              <a:gd name="connsiteY5" fmla="*/ 149225 h 1460500"/>
              <a:gd name="connsiteX6" fmla="*/ 346075 w 422275"/>
              <a:gd name="connsiteY6" fmla="*/ 155575 h 1460500"/>
              <a:gd name="connsiteX7" fmla="*/ 333375 w 422275"/>
              <a:gd name="connsiteY7" fmla="*/ 161925 h 1460500"/>
              <a:gd name="connsiteX8" fmla="*/ 320675 w 422275"/>
              <a:gd name="connsiteY8" fmla="*/ 171450 h 1460500"/>
              <a:gd name="connsiteX9" fmla="*/ 311150 w 422275"/>
              <a:gd name="connsiteY9" fmla="*/ 174625 h 1460500"/>
              <a:gd name="connsiteX10" fmla="*/ 292100 w 422275"/>
              <a:gd name="connsiteY10" fmla="*/ 187325 h 1460500"/>
              <a:gd name="connsiteX11" fmla="*/ 285750 w 422275"/>
              <a:gd name="connsiteY11" fmla="*/ 196850 h 1460500"/>
              <a:gd name="connsiteX12" fmla="*/ 269875 w 422275"/>
              <a:gd name="connsiteY12" fmla="*/ 215900 h 1460500"/>
              <a:gd name="connsiteX13" fmla="*/ 273050 w 422275"/>
              <a:gd name="connsiteY13" fmla="*/ 263525 h 1460500"/>
              <a:gd name="connsiteX14" fmla="*/ 279400 w 422275"/>
              <a:gd name="connsiteY14" fmla="*/ 282575 h 1460500"/>
              <a:gd name="connsiteX15" fmla="*/ 282575 w 422275"/>
              <a:gd name="connsiteY15" fmla="*/ 292100 h 1460500"/>
              <a:gd name="connsiteX16" fmla="*/ 285750 w 422275"/>
              <a:gd name="connsiteY16" fmla="*/ 355600 h 1460500"/>
              <a:gd name="connsiteX17" fmla="*/ 288925 w 422275"/>
              <a:gd name="connsiteY17" fmla="*/ 396875 h 1460500"/>
              <a:gd name="connsiteX18" fmla="*/ 285750 w 422275"/>
              <a:gd name="connsiteY18" fmla="*/ 469900 h 1460500"/>
              <a:gd name="connsiteX19" fmla="*/ 273050 w 422275"/>
              <a:gd name="connsiteY19" fmla="*/ 498475 h 1460500"/>
              <a:gd name="connsiteX20" fmla="*/ 263525 w 422275"/>
              <a:gd name="connsiteY20" fmla="*/ 508000 h 1460500"/>
              <a:gd name="connsiteX21" fmla="*/ 250825 w 422275"/>
              <a:gd name="connsiteY21" fmla="*/ 527050 h 1460500"/>
              <a:gd name="connsiteX22" fmla="*/ 244475 w 422275"/>
              <a:gd name="connsiteY22" fmla="*/ 568325 h 1460500"/>
              <a:gd name="connsiteX23" fmla="*/ 241300 w 422275"/>
              <a:gd name="connsiteY23" fmla="*/ 577850 h 1460500"/>
              <a:gd name="connsiteX24" fmla="*/ 238125 w 422275"/>
              <a:gd name="connsiteY24" fmla="*/ 596900 h 1460500"/>
              <a:gd name="connsiteX25" fmla="*/ 231775 w 422275"/>
              <a:gd name="connsiteY25" fmla="*/ 606425 h 1460500"/>
              <a:gd name="connsiteX26" fmla="*/ 225425 w 422275"/>
              <a:gd name="connsiteY26" fmla="*/ 625475 h 1460500"/>
              <a:gd name="connsiteX27" fmla="*/ 222250 w 422275"/>
              <a:gd name="connsiteY27" fmla="*/ 635000 h 1460500"/>
              <a:gd name="connsiteX28" fmla="*/ 219075 w 422275"/>
              <a:gd name="connsiteY28" fmla="*/ 682625 h 1460500"/>
              <a:gd name="connsiteX29" fmla="*/ 212725 w 422275"/>
              <a:gd name="connsiteY29" fmla="*/ 704850 h 1460500"/>
              <a:gd name="connsiteX30" fmla="*/ 209550 w 422275"/>
              <a:gd name="connsiteY30" fmla="*/ 733425 h 1460500"/>
              <a:gd name="connsiteX31" fmla="*/ 200025 w 422275"/>
              <a:gd name="connsiteY31" fmla="*/ 889000 h 1460500"/>
              <a:gd name="connsiteX32" fmla="*/ 196850 w 422275"/>
              <a:gd name="connsiteY32" fmla="*/ 904875 h 1460500"/>
              <a:gd name="connsiteX33" fmla="*/ 193675 w 422275"/>
              <a:gd name="connsiteY33" fmla="*/ 923925 h 1460500"/>
              <a:gd name="connsiteX34" fmla="*/ 180975 w 422275"/>
              <a:gd name="connsiteY34" fmla="*/ 952500 h 1460500"/>
              <a:gd name="connsiteX35" fmla="*/ 171450 w 422275"/>
              <a:gd name="connsiteY35" fmla="*/ 958850 h 1460500"/>
              <a:gd name="connsiteX36" fmla="*/ 165100 w 422275"/>
              <a:gd name="connsiteY36" fmla="*/ 968375 h 1460500"/>
              <a:gd name="connsiteX37" fmla="*/ 161925 w 422275"/>
              <a:gd name="connsiteY37" fmla="*/ 977900 h 1460500"/>
              <a:gd name="connsiteX38" fmla="*/ 142875 w 422275"/>
              <a:gd name="connsiteY38" fmla="*/ 996950 h 1460500"/>
              <a:gd name="connsiteX39" fmla="*/ 120650 w 422275"/>
              <a:gd name="connsiteY39" fmla="*/ 1022350 h 1460500"/>
              <a:gd name="connsiteX40" fmla="*/ 107950 w 422275"/>
              <a:gd name="connsiteY40" fmla="*/ 1044575 h 1460500"/>
              <a:gd name="connsiteX41" fmla="*/ 104775 w 422275"/>
              <a:gd name="connsiteY41" fmla="*/ 1054100 h 1460500"/>
              <a:gd name="connsiteX42" fmla="*/ 88900 w 422275"/>
              <a:gd name="connsiteY42" fmla="*/ 1082675 h 1460500"/>
              <a:gd name="connsiteX43" fmla="*/ 85725 w 422275"/>
              <a:gd name="connsiteY43" fmla="*/ 1114425 h 1460500"/>
              <a:gd name="connsiteX44" fmla="*/ 82550 w 422275"/>
              <a:gd name="connsiteY44" fmla="*/ 1123950 h 1460500"/>
              <a:gd name="connsiteX45" fmla="*/ 60325 w 422275"/>
              <a:gd name="connsiteY45" fmla="*/ 1146175 h 1460500"/>
              <a:gd name="connsiteX46" fmla="*/ 50800 w 422275"/>
              <a:gd name="connsiteY46" fmla="*/ 1165225 h 1460500"/>
              <a:gd name="connsiteX47" fmla="*/ 44450 w 422275"/>
              <a:gd name="connsiteY47" fmla="*/ 1174750 h 1460500"/>
              <a:gd name="connsiteX48" fmla="*/ 38100 w 422275"/>
              <a:gd name="connsiteY48" fmla="*/ 1196975 h 1460500"/>
              <a:gd name="connsiteX49" fmla="*/ 31750 w 422275"/>
              <a:gd name="connsiteY49" fmla="*/ 1206500 h 1460500"/>
              <a:gd name="connsiteX50" fmla="*/ 28575 w 422275"/>
              <a:gd name="connsiteY50" fmla="*/ 1216025 h 1460500"/>
              <a:gd name="connsiteX51" fmla="*/ 15875 w 422275"/>
              <a:gd name="connsiteY51" fmla="*/ 1235075 h 1460500"/>
              <a:gd name="connsiteX52" fmla="*/ 9525 w 422275"/>
              <a:gd name="connsiteY52" fmla="*/ 1244600 h 1460500"/>
              <a:gd name="connsiteX53" fmla="*/ 6350 w 422275"/>
              <a:gd name="connsiteY53" fmla="*/ 1260475 h 1460500"/>
              <a:gd name="connsiteX54" fmla="*/ 0 w 422275"/>
              <a:gd name="connsiteY54" fmla="*/ 1279525 h 1460500"/>
              <a:gd name="connsiteX55" fmla="*/ 6350 w 422275"/>
              <a:gd name="connsiteY55" fmla="*/ 1327150 h 1460500"/>
              <a:gd name="connsiteX56" fmla="*/ 12700 w 422275"/>
              <a:gd name="connsiteY56" fmla="*/ 1355725 h 1460500"/>
              <a:gd name="connsiteX57" fmla="*/ 22225 w 422275"/>
              <a:gd name="connsiteY57" fmla="*/ 1384300 h 1460500"/>
              <a:gd name="connsiteX58" fmla="*/ 25400 w 422275"/>
              <a:gd name="connsiteY58" fmla="*/ 1393825 h 1460500"/>
              <a:gd name="connsiteX59" fmla="*/ 28575 w 422275"/>
              <a:gd name="connsiteY59" fmla="*/ 1409700 h 1460500"/>
              <a:gd name="connsiteX60" fmla="*/ 25400 w 422275"/>
              <a:gd name="connsiteY60" fmla="*/ 1447800 h 1460500"/>
              <a:gd name="connsiteX61" fmla="*/ 22225 w 422275"/>
              <a:gd name="connsiteY61" fmla="*/ 1460500 h 1460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422275" h="1460500">
                <a:moveTo>
                  <a:pt x="422275" y="0"/>
                </a:moveTo>
                <a:cubicBezTo>
                  <a:pt x="421217" y="17992"/>
                  <a:pt x="420732" y="36026"/>
                  <a:pt x="419100" y="53975"/>
                </a:cubicBezTo>
                <a:cubicBezTo>
                  <a:pt x="418611" y="59349"/>
                  <a:pt x="417408" y="64661"/>
                  <a:pt x="415925" y="69850"/>
                </a:cubicBezTo>
                <a:cubicBezTo>
                  <a:pt x="412090" y="83272"/>
                  <a:pt x="407502" y="98705"/>
                  <a:pt x="400050" y="111125"/>
                </a:cubicBezTo>
                <a:cubicBezTo>
                  <a:pt x="396123" y="117669"/>
                  <a:pt x="393700" y="125942"/>
                  <a:pt x="387350" y="130175"/>
                </a:cubicBezTo>
                <a:cubicBezTo>
                  <a:pt x="340748" y="161243"/>
                  <a:pt x="389771" y="129699"/>
                  <a:pt x="355600" y="149225"/>
                </a:cubicBezTo>
                <a:cubicBezTo>
                  <a:pt x="352287" y="151118"/>
                  <a:pt x="349388" y="153682"/>
                  <a:pt x="346075" y="155575"/>
                </a:cubicBezTo>
                <a:cubicBezTo>
                  <a:pt x="341966" y="157923"/>
                  <a:pt x="337389" y="159417"/>
                  <a:pt x="333375" y="161925"/>
                </a:cubicBezTo>
                <a:cubicBezTo>
                  <a:pt x="328888" y="164730"/>
                  <a:pt x="325269" y="168825"/>
                  <a:pt x="320675" y="171450"/>
                </a:cubicBezTo>
                <a:cubicBezTo>
                  <a:pt x="317769" y="173110"/>
                  <a:pt x="314076" y="173000"/>
                  <a:pt x="311150" y="174625"/>
                </a:cubicBezTo>
                <a:cubicBezTo>
                  <a:pt x="304479" y="178331"/>
                  <a:pt x="292100" y="187325"/>
                  <a:pt x="292100" y="187325"/>
                </a:cubicBezTo>
                <a:cubicBezTo>
                  <a:pt x="289983" y="190500"/>
                  <a:pt x="288193" y="193919"/>
                  <a:pt x="285750" y="196850"/>
                </a:cubicBezTo>
                <a:cubicBezTo>
                  <a:pt x="265378" y="221296"/>
                  <a:pt x="285641" y="192251"/>
                  <a:pt x="269875" y="215900"/>
                </a:cubicBezTo>
                <a:cubicBezTo>
                  <a:pt x="270933" y="231775"/>
                  <a:pt x="270800" y="247775"/>
                  <a:pt x="273050" y="263525"/>
                </a:cubicBezTo>
                <a:cubicBezTo>
                  <a:pt x="273997" y="270151"/>
                  <a:pt x="277283" y="276225"/>
                  <a:pt x="279400" y="282575"/>
                </a:cubicBezTo>
                <a:lnTo>
                  <a:pt x="282575" y="292100"/>
                </a:lnTo>
                <a:cubicBezTo>
                  <a:pt x="283633" y="313267"/>
                  <a:pt x="284468" y="334446"/>
                  <a:pt x="285750" y="355600"/>
                </a:cubicBezTo>
                <a:cubicBezTo>
                  <a:pt x="286585" y="369374"/>
                  <a:pt x="288925" y="383076"/>
                  <a:pt x="288925" y="396875"/>
                </a:cubicBezTo>
                <a:cubicBezTo>
                  <a:pt x="288925" y="421240"/>
                  <a:pt x="288257" y="445665"/>
                  <a:pt x="285750" y="469900"/>
                </a:cubicBezTo>
                <a:cubicBezTo>
                  <a:pt x="284769" y="479384"/>
                  <a:pt x="279364" y="490898"/>
                  <a:pt x="273050" y="498475"/>
                </a:cubicBezTo>
                <a:cubicBezTo>
                  <a:pt x="270175" y="501924"/>
                  <a:pt x="266282" y="504456"/>
                  <a:pt x="263525" y="508000"/>
                </a:cubicBezTo>
                <a:cubicBezTo>
                  <a:pt x="258840" y="514024"/>
                  <a:pt x="250825" y="527050"/>
                  <a:pt x="250825" y="527050"/>
                </a:cubicBezTo>
                <a:cubicBezTo>
                  <a:pt x="249812" y="534140"/>
                  <a:pt x="246237" y="560395"/>
                  <a:pt x="244475" y="568325"/>
                </a:cubicBezTo>
                <a:cubicBezTo>
                  <a:pt x="243749" y="571592"/>
                  <a:pt x="242026" y="574583"/>
                  <a:pt x="241300" y="577850"/>
                </a:cubicBezTo>
                <a:cubicBezTo>
                  <a:pt x="239903" y="584134"/>
                  <a:pt x="240161" y="590793"/>
                  <a:pt x="238125" y="596900"/>
                </a:cubicBezTo>
                <a:cubicBezTo>
                  <a:pt x="236918" y="600520"/>
                  <a:pt x="233325" y="602938"/>
                  <a:pt x="231775" y="606425"/>
                </a:cubicBezTo>
                <a:cubicBezTo>
                  <a:pt x="229057" y="612542"/>
                  <a:pt x="227542" y="619125"/>
                  <a:pt x="225425" y="625475"/>
                </a:cubicBezTo>
                <a:lnTo>
                  <a:pt x="222250" y="635000"/>
                </a:lnTo>
                <a:cubicBezTo>
                  <a:pt x="221192" y="650875"/>
                  <a:pt x="220741" y="666802"/>
                  <a:pt x="219075" y="682625"/>
                </a:cubicBezTo>
                <a:cubicBezTo>
                  <a:pt x="218462" y="688452"/>
                  <a:pt x="214693" y="698947"/>
                  <a:pt x="212725" y="704850"/>
                </a:cubicBezTo>
                <a:cubicBezTo>
                  <a:pt x="211667" y="714375"/>
                  <a:pt x="209898" y="723848"/>
                  <a:pt x="209550" y="733425"/>
                </a:cubicBezTo>
                <a:cubicBezTo>
                  <a:pt x="203974" y="886767"/>
                  <a:pt x="233568" y="838686"/>
                  <a:pt x="200025" y="889000"/>
                </a:cubicBezTo>
                <a:cubicBezTo>
                  <a:pt x="198967" y="894292"/>
                  <a:pt x="197815" y="899566"/>
                  <a:pt x="196850" y="904875"/>
                </a:cubicBezTo>
                <a:cubicBezTo>
                  <a:pt x="195698" y="911209"/>
                  <a:pt x="195236" y="917680"/>
                  <a:pt x="193675" y="923925"/>
                </a:cubicBezTo>
                <a:cubicBezTo>
                  <a:pt x="191579" y="932309"/>
                  <a:pt x="187925" y="945550"/>
                  <a:pt x="180975" y="952500"/>
                </a:cubicBezTo>
                <a:cubicBezTo>
                  <a:pt x="178277" y="955198"/>
                  <a:pt x="174625" y="956733"/>
                  <a:pt x="171450" y="958850"/>
                </a:cubicBezTo>
                <a:cubicBezTo>
                  <a:pt x="169333" y="962025"/>
                  <a:pt x="166807" y="964962"/>
                  <a:pt x="165100" y="968375"/>
                </a:cubicBezTo>
                <a:cubicBezTo>
                  <a:pt x="163603" y="971368"/>
                  <a:pt x="163980" y="975258"/>
                  <a:pt x="161925" y="977900"/>
                </a:cubicBezTo>
                <a:cubicBezTo>
                  <a:pt x="156412" y="984989"/>
                  <a:pt x="147856" y="989478"/>
                  <a:pt x="142875" y="996950"/>
                </a:cubicBezTo>
                <a:cubicBezTo>
                  <a:pt x="128058" y="1019175"/>
                  <a:pt x="136525" y="1011767"/>
                  <a:pt x="120650" y="1022350"/>
                </a:cubicBezTo>
                <a:cubicBezTo>
                  <a:pt x="113935" y="1049210"/>
                  <a:pt x="123083" y="1021876"/>
                  <a:pt x="107950" y="1044575"/>
                </a:cubicBezTo>
                <a:cubicBezTo>
                  <a:pt x="106094" y="1047360"/>
                  <a:pt x="106400" y="1051174"/>
                  <a:pt x="104775" y="1054100"/>
                </a:cubicBezTo>
                <a:cubicBezTo>
                  <a:pt x="86579" y="1086852"/>
                  <a:pt x="96084" y="1061122"/>
                  <a:pt x="88900" y="1082675"/>
                </a:cubicBezTo>
                <a:cubicBezTo>
                  <a:pt x="87842" y="1093258"/>
                  <a:pt x="87342" y="1103913"/>
                  <a:pt x="85725" y="1114425"/>
                </a:cubicBezTo>
                <a:cubicBezTo>
                  <a:pt x="85216" y="1117733"/>
                  <a:pt x="84641" y="1121337"/>
                  <a:pt x="82550" y="1123950"/>
                </a:cubicBezTo>
                <a:cubicBezTo>
                  <a:pt x="76005" y="1132131"/>
                  <a:pt x="66137" y="1137458"/>
                  <a:pt x="60325" y="1146175"/>
                </a:cubicBezTo>
                <a:cubicBezTo>
                  <a:pt x="42127" y="1173472"/>
                  <a:pt x="63945" y="1138935"/>
                  <a:pt x="50800" y="1165225"/>
                </a:cubicBezTo>
                <a:cubicBezTo>
                  <a:pt x="49093" y="1168638"/>
                  <a:pt x="46157" y="1171337"/>
                  <a:pt x="44450" y="1174750"/>
                </a:cubicBezTo>
                <a:cubicBezTo>
                  <a:pt x="38271" y="1187107"/>
                  <a:pt x="44204" y="1182733"/>
                  <a:pt x="38100" y="1196975"/>
                </a:cubicBezTo>
                <a:cubicBezTo>
                  <a:pt x="36597" y="1200482"/>
                  <a:pt x="33457" y="1203087"/>
                  <a:pt x="31750" y="1206500"/>
                </a:cubicBezTo>
                <a:cubicBezTo>
                  <a:pt x="30253" y="1209493"/>
                  <a:pt x="30200" y="1213099"/>
                  <a:pt x="28575" y="1216025"/>
                </a:cubicBezTo>
                <a:cubicBezTo>
                  <a:pt x="24869" y="1222696"/>
                  <a:pt x="20108" y="1228725"/>
                  <a:pt x="15875" y="1235075"/>
                </a:cubicBezTo>
                <a:lnTo>
                  <a:pt x="9525" y="1244600"/>
                </a:lnTo>
                <a:cubicBezTo>
                  <a:pt x="8467" y="1249892"/>
                  <a:pt x="7770" y="1255269"/>
                  <a:pt x="6350" y="1260475"/>
                </a:cubicBezTo>
                <a:cubicBezTo>
                  <a:pt x="4589" y="1266933"/>
                  <a:pt x="0" y="1279525"/>
                  <a:pt x="0" y="1279525"/>
                </a:cubicBezTo>
                <a:cubicBezTo>
                  <a:pt x="2876" y="1305406"/>
                  <a:pt x="2278" y="1304755"/>
                  <a:pt x="6350" y="1327150"/>
                </a:cubicBezTo>
                <a:cubicBezTo>
                  <a:pt x="7744" y="1334819"/>
                  <a:pt x="10348" y="1347885"/>
                  <a:pt x="12700" y="1355725"/>
                </a:cubicBezTo>
                <a:cubicBezTo>
                  <a:pt x="15585" y="1365342"/>
                  <a:pt x="19050" y="1374775"/>
                  <a:pt x="22225" y="1384300"/>
                </a:cubicBezTo>
                <a:cubicBezTo>
                  <a:pt x="23283" y="1387475"/>
                  <a:pt x="24744" y="1390543"/>
                  <a:pt x="25400" y="1393825"/>
                </a:cubicBezTo>
                <a:lnTo>
                  <a:pt x="28575" y="1409700"/>
                </a:lnTo>
                <a:cubicBezTo>
                  <a:pt x="27517" y="1422400"/>
                  <a:pt x="26981" y="1435154"/>
                  <a:pt x="25400" y="1447800"/>
                </a:cubicBezTo>
                <a:cubicBezTo>
                  <a:pt x="24859" y="1452130"/>
                  <a:pt x="22225" y="1460500"/>
                  <a:pt x="22225" y="1460500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reeform 3"/>
          <p:cNvSpPr/>
          <p:nvPr/>
        </p:nvSpPr>
        <p:spPr>
          <a:xfrm>
            <a:off x="5390419" y="2816941"/>
            <a:ext cx="400781" cy="1457325"/>
          </a:xfrm>
          <a:custGeom>
            <a:avLst/>
            <a:gdLst>
              <a:gd name="connsiteX0" fmla="*/ 400781 w 400781"/>
              <a:gd name="connsiteY0" fmla="*/ 0 h 1457325"/>
              <a:gd name="connsiteX1" fmla="*/ 397606 w 400781"/>
              <a:gd name="connsiteY1" fmla="*/ 15875 h 1457325"/>
              <a:gd name="connsiteX2" fmla="*/ 378556 w 400781"/>
              <a:gd name="connsiteY2" fmla="*/ 34925 h 1457325"/>
              <a:gd name="connsiteX3" fmla="*/ 369031 w 400781"/>
              <a:gd name="connsiteY3" fmla="*/ 44450 h 1457325"/>
              <a:gd name="connsiteX4" fmla="*/ 353156 w 400781"/>
              <a:gd name="connsiteY4" fmla="*/ 60325 h 1457325"/>
              <a:gd name="connsiteX5" fmla="*/ 330931 w 400781"/>
              <a:gd name="connsiteY5" fmla="*/ 88900 h 1457325"/>
              <a:gd name="connsiteX6" fmla="*/ 321406 w 400781"/>
              <a:gd name="connsiteY6" fmla="*/ 107950 h 1457325"/>
              <a:gd name="connsiteX7" fmla="*/ 311881 w 400781"/>
              <a:gd name="connsiteY7" fmla="*/ 117475 h 1457325"/>
              <a:gd name="connsiteX8" fmla="*/ 305531 w 400781"/>
              <a:gd name="connsiteY8" fmla="*/ 130175 h 1457325"/>
              <a:gd name="connsiteX9" fmla="*/ 299181 w 400781"/>
              <a:gd name="connsiteY9" fmla="*/ 139700 h 1457325"/>
              <a:gd name="connsiteX10" fmla="*/ 296006 w 400781"/>
              <a:gd name="connsiteY10" fmla="*/ 149225 h 1457325"/>
              <a:gd name="connsiteX11" fmla="*/ 289656 w 400781"/>
              <a:gd name="connsiteY11" fmla="*/ 158750 h 1457325"/>
              <a:gd name="connsiteX12" fmla="*/ 286481 w 400781"/>
              <a:gd name="connsiteY12" fmla="*/ 168275 h 1457325"/>
              <a:gd name="connsiteX13" fmla="*/ 280131 w 400781"/>
              <a:gd name="connsiteY13" fmla="*/ 180975 h 1457325"/>
              <a:gd name="connsiteX14" fmla="*/ 283306 w 400781"/>
              <a:gd name="connsiteY14" fmla="*/ 238125 h 1457325"/>
              <a:gd name="connsiteX15" fmla="*/ 286481 w 400781"/>
              <a:gd name="connsiteY15" fmla="*/ 320675 h 1457325"/>
              <a:gd name="connsiteX16" fmla="*/ 292831 w 400781"/>
              <a:gd name="connsiteY16" fmla="*/ 352425 h 1457325"/>
              <a:gd name="connsiteX17" fmla="*/ 299181 w 400781"/>
              <a:gd name="connsiteY17" fmla="*/ 387350 h 1457325"/>
              <a:gd name="connsiteX18" fmla="*/ 302356 w 400781"/>
              <a:gd name="connsiteY18" fmla="*/ 403225 h 1457325"/>
              <a:gd name="connsiteX19" fmla="*/ 308706 w 400781"/>
              <a:gd name="connsiteY19" fmla="*/ 428625 h 1457325"/>
              <a:gd name="connsiteX20" fmla="*/ 305531 w 400781"/>
              <a:gd name="connsiteY20" fmla="*/ 482600 h 1457325"/>
              <a:gd name="connsiteX21" fmla="*/ 296006 w 400781"/>
              <a:gd name="connsiteY21" fmla="*/ 514350 h 1457325"/>
              <a:gd name="connsiteX22" fmla="*/ 289656 w 400781"/>
              <a:gd name="connsiteY22" fmla="*/ 542925 h 1457325"/>
              <a:gd name="connsiteX23" fmla="*/ 286481 w 400781"/>
              <a:gd name="connsiteY23" fmla="*/ 561975 h 1457325"/>
              <a:gd name="connsiteX24" fmla="*/ 280131 w 400781"/>
              <a:gd name="connsiteY24" fmla="*/ 581025 h 1457325"/>
              <a:gd name="connsiteX25" fmla="*/ 276956 w 400781"/>
              <a:gd name="connsiteY25" fmla="*/ 609600 h 1457325"/>
              <a:gd name="connsiteX26" fmla="*/ 283306 w 400781"/>
              <a:gd name="connsiteY26" fmla="*/ 736600 h 1457325"/>
              <a:gd name="connsiteX27" fmla="*/ 280131 w 400781"/>
              <a:gd name="connsiteY27" fmla="*/ 812800 h 1457325"/>
              <a:gd name="connsiteX28" fmla="*/ 264256 w 400781"/>
              <a:gd name="connsiteY28" fmla="*/ 844550 h 1457325"/>
              <a:gd name="connsiteX29" fmla="*/ 257906 w 400781"/>
              <a:gd name="connsiteY29" fmla="*/ 854075 h 1457325"/>
              <a:gd name="connsiteX30" fmla="*/ 248381 w 400781"/>
              <a:gd name="connsiteY30" fmla="*/ 873125 h 1457325"/>
              <a:gd name="connsiteX31" fmla="*/ 245206 w 400781"/>
              <a:gd name="connsiteY31" fmla="*/ 885825 h 1457325"/>
              <a:gd name="connsiteX32" fmla="*/ 251556 w 400781"/>
              <a:gd name="connsiteY32" fmla="*/ 914400 h 1457325"/>
              <a:gd name="connsiteX33" fmla="*/ 264256 w 400781"/>
              <a:gd name="connsiteY33" fmla="*/ 939800 h 1457325"/>
              <a:gd name="connsiteX34" fmla="*/ 261081 w 400781"/>
              <a:gd name="connsiteY34" fmla="*/ 990600 h 1457325"/>
              <a:gd name="connsiteX35" fmla="*/ 257906 w 400781"/>
              <a:gd name="connsiteY35" fmla="*/ 1003300 h 1457325"/>
              <a:gd name="connsiteX36" fmla="*/ 245206 w 400781"/>
              <a:gd name="connsiteY36" fmla="*/ 1031875 h 1457325"/>
              <a:gd name="connsiteX37" fmla="*/ 226156 w 400781"/>
              <a:gd name="connsiteY37" fmla="*/ 1060450 h 1457325"/>
              <a:gd name="connsiteX38" fmla="*/ 219806 w 400781"/>
              <a:gd name="connsiteY38" fmla="*/ 1069975 h 1457325"/>
              <a:gd name="connsiteX39" fmla="*/ 216631 w 400781"/>
              <a:gd name="connsiteY39" fmla="*/ 1127125 h 1457325"/>
              <a:gd name="connsiteX40" fmla="*/ 210281 w 400781"/>
              <a:gd name="connsiteY40" fmla="*/ 1139825 h 1457325"/>
              <a:gd name="connsiteX41" fmla="*/ 178531 w 400781"/>
              <a:gd name="connsiteY41" fmla="*/ 1158875 h 1457325"/>
              <a:gd name="connsiteX42" fmla="*/ 162656 w 400781"/>
              <a:gd name="connsiteY42" fmla="*/ 1177925 h 1457325"/>
              <a:gd name="connsiteX43" fmla="*/ 140431 w 400781"/>
              <a:gd name="connsiteY43" fmla="*/ 1209675 h 1457325"/>
              <a:gd name="connsiteX44" fmla="*/ 127731 w 400781"/>
              <a:gd name="connsiteY44" fmla="*/ 1228725 h 1457325"/>
              <a:gd name="connsiteX45" fmla="*/ 121381 w 400781"/>
              <a:gd name="connsiteY45" fmla="*/ 1238250 h 1457325"/>
              <a:gd name="connsiteX46" fmla="*/ 118206 w 400781"/>
              <a:gd name="connsiteY46" fmla="*/ 1247775 h 1457325"/>
              <a:gd name="connsiteX47" fmla="*/ 105506 w 400781"/>
              <a:gd name="connsiteY47" fmla="*/ 1266825 h 1457325"/>
              <a:gd name="connsiteX48" fmla="*/ 99156 w 400781"/>
              <a:gd name="connsiteY48" fmla="*/ 1285875 h 1457325"/>
              <a:gd name="connsiteX49" fmla="*/ 83281 w 400781"/>
              <a:gd name="connsiteY49" fmla="*/ 1304925 h 1457325"/>
              <a:gd name="connsiteX50" fmla="*/ 73756 w 400781"/>
              <a:gd name="connsiteY50" fmla="*/ 1323975 h 1457325"/>
              <a:gd name="connsiteX51" fmla="*/ 64231 w 400781"/>
              <a:gd name="connsiteY51" fmla="*/ 1330325 h 1457325"/>
              <a:gd name="connsiteX52" fmla="*/ 51531 w 400781"/>
              <a:gd name="connsiteY52" fmla="*/ 1352550 h 1457325"/>
              <a:gd name="connsiteX53" fmla="*/ 38831 w 400781"/>
              <a:gd name="connsiteY53" fmla="*/ 1371600 h 1457325"/>
              <a:gd name="connsiteX54" fmla="*/ 26131 w 400781"/>
              <a:gd name="connsiteY54" fmla="*/ 1384300 h 1457325"/>
              <a:gd name="connsiteX55" fmla="*/ 10256 w 400781"/>
              <a:gd name="connsiteY55" fmla="*/ 1403350 h 1457325"/>
              <a:gd name="connsiteX56" fmla="*/ 7081 w 400781"/>
              <a:gd name="connsiteY56" fmla="*/ 1412875 h 1457325"/>
              <a:gd name="connsiteX57" fmla="*/ 731 w 400781"/>
              <a:gd name="connsiteY57" fmla="*/ 1422400 h 1457325"/>
              <a:gd name="connsiteX58" fmla="*/ 731 w 400781"/>
              <a:gd name="connsiteY58" fmla="*/ 1457325 h 14573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</a:cxnLst>
            <a:rect l="l" t="t" r="r" b="b"/>
            <a:pathLst>
              <a:path w="400781" h="1457325">
                <a:moveTo>
                  <a:pt x="400781" y="0"/>
                </a:moveTo>
                <a:cubicBezTo>
                  <a:pt x="399723" y="5292"/>
                  <a:pt x="399501" y="10822"/>
                  <a:pt x="397606" y="15875"/>
                </a:cubicBezTo>
                <a:cubicBezTo>
                  <a:pt x="393635" y="26465"/>
                  <a:pt x="386940" y="27739"/>
                  <a:pt x="378556" y="34925"/>
                </a:cubicBezTo>
                <a:cubicBezTo>
                  <a:pt x="375147" y="37847"/>
                  <a:pt x="371906" y="41001"/>
                  <a:pt x="369031" y="44450"/>
                </a:cubicBezTo>
                <a:cubicBezTo>
                  <a:pt x="355802" y="60325"/>
                  <a:pt x="370618" y="48683"/>
                  <a:pt x="353156" y="60325"/>
                </a:cubicBezTo>
                <a:cubicBezTo>
                  <a:pt x="321058" y="108473"/>
                  <a:pt x="355800" y="59057"/>
                  <a:pt x="330931" y="88900"/>
                </a:cubicBezTo>
                <a:cubicBezTo>
                  <a:pt x="305952" y="118875"/>
                  <a:pt x="340499" y="79311"/>
                  <a:pt x="321406" y="107950"/>
                </a:cubicBezTo>
                <a:cubicBezTo>
                  <a:pt x="318915" y="111686"/>
                  <a:pt x="314491" y="113821"/>
                  <a:pt x="311881" y="117475"/>
                </a:cubicBezTo>
                <a:cubicBezTo>
                  <a:pt x="309130" y="121326"/>
                  <a:pt x="307879" y="126066"/>
                  <a:pt x="305531" y="130175"/>
                </a:cubicBezTo>
                <a:cubicBezTo>
                  <a:pt x="303638" y="133488"/>
                  <a:pt x="300888" y="136287"/>
                  <a:pt x="299181" y="139700"/>
                </a:cubicBezTo>
                <a:cubicBezTo>
                  <a:pt x="297684" y="142693"/>
                  <a:pt x="297503" y="146232"/>
                  <a:pt x="296006" y="149225"/>
                </a:cubicBezTo>
                <a:cubicBezTo>
                  <a:pt x="294299" y="152638"/>
                  <a:pt x="291363" y="155337"/>
                  <a:pt x="289656" y="158750"/>
                </a:cubicBezTo>
                <a:cubicBezTo>
                  <a:pt x="288159" y="161743"/>
                  <a:pt x="287799" y="165199"/>
                  <a:pt x="286481" y="168275"/>
                </a:cubicBezTo>
                <a:cubicBezTo>
                  <a:pt x="284617" y="172625"/>
                  <a:pt x="282248" y="176742"/>
                  <a:pt x="280131" y="180975"/>
                </a:cubicBezTo>
                <a:cubicBezTo>
                  <a:pt x="281189" y="200025"/>
                  <a:pt x="282440" y="219065"/>
                  <a:pt x="283306" y="238125"/>
                </a:cubicBezTo>
                <a:cubicBezTo>
                  <a:pt x="284556" y="265634"/>
                  <a:pt x="284194" y="293233"/>
                  <a:pt x="286481" y="320675"/>
                </a:cubicBezTo>
                <a:cubicBezTo>
                  <a:pt x="287377" y="331431"/>
                  <a:pt x="290812" y="341823"/>
                  <a:pt x="292831" y="352425"/>
                </a:cubicBezTo>
                <a:cubicBezTo>
                  <a:pt x="295045" y="364049"/>
                  <a:pt x="297000" y="375720"/>
                  <a:pt x="299181" y="387350"/>
                </a:cubicBezTo>
                <a:cubicBezTo>
                  <a:pt x="300176" y="392654"/>
                  <a:pt x="301047" y="397990"/>
                  <a:pt x="302356" y="403225"/>
                </a:cubicBezTo>
                <a:lnTo>
                  <a:pt x="308706" y="428625"/>
                </a:lnTo>
                <a:cubicBezTo>
                  <a:pt x="307648" y="446617"/>
                  <a:pt x="307240" y="464658"/>
                  <a:pt x="305531" y="482600"/>
                </a:cubicBezTo>
                <a:cubicBezTo>
                  <a:pt x="304671" y="491629"/>
                  <a:pt x="297695" y="506751"/>
                  <a:pt x="296006" y="514350"/>
                </a:cubicBezTo>
                <a:cubicBezTo>
                  <a:pt x="293889" y="523875"/>
                  <a:pt x="291570" y="533357"/>
                  <a:pt x="289656" y="542925"/>
                </a:cubicBezTo>
                <a:cubicBezTo>
                  <a:pt x="288393" y="549238"/>
                  <a:pt x="288042" y="555730"/>
                  <a:pt x="286481" y="561975"/>
                </a:cubicBezTo>
                <a:cubicBezTo>
                  <a:pt x="284858" y="568469"/>
                  <a:pt x="280131" y="581025"/>
                  <a:pt x="280131" y="581025"/>
                </a:cubicBezTo>
                <a:cubicBezTo>
                  <a:pt x="279073" y="590550"/>
                  <a:pt x="276760" y="600018"/>
                  <a:pt x="276956" y="609600"/>
                </a:cubicBezTo>
                <a:cubicBezTo>
                  <a:pt x="277821" y="651977"/>
                  <a:pt x="283306" y="736600"/>
                  <a:pt x="283306" y="736600"/>
                </a:cubicBezTo>
                <a:cubicBezTo>
                  <a:pt x="282248" y="762000"/>
                  <a:pt x="281942" y="787443"/>
                  <a:pt x="280131" y="812800"/>
                </a:cubicBezTo>
                <a:cubicBezTo>
                  <a:pt x="279126" y="826873"/>
                  <a:pt x="272344" y="832417"/>
                  <a:pt x="264256" y="844550"/>
                </a:cubicBezTo>
                <a:cubicBezTo>
                  <a:pt x="262139" y="847725"/>
                  <a:pt x="259113" y="850455"/>
                  <a:pt x="257906" y="854075"/>
                </a:cubicBezTo>
                <a:cubicBezTo>
                  <a:pt x="253524" y="867220"/>
                  <a:pt x="256587" y="860815"/>
                  <a:pt x="248381" y="873125"/>
                </a:cubicBezTo>
                <a:cubicBezTo>
                  <a:pt x="247323" y="877358"/>
                  <a:pt x="245206" y="881461"/>
                  <a:pt x="245206" y="885825"/>
                </a:cubicBezTo>
                <a:cubicBezTo>
                  <a:pt x="245206" y="891962"/>
                  <a:pt x="248282" y="907197"/>
                  <a:pt x="251556" y="914400"/>
                </a:cubicBezTo>
                <a:cubicBezTo>
                  <a:pt x="255473" y="923018"/>
                  <a:pt x="264256" y="939800"/>
                  <a:pt x="264256" y="939800"/>
                </a:cubicBezTo>
                <a:cubicBezTo>
                  <a:pt x="263198" y="956733"/>
                  <a:pt x="262769" y="973718"/>
                  <a:pt x="261081" y="990600"/>
                </a:cubicBezTo>
                <a:cubicBezTo>
                  <a:pt x="260647" y="994942"/>
                  <a:pt x="259286" y="999160"/>
                  <a:pt x="257906" y="1003300"/>
                </a:cubicBezTo>
                <a:cubicBezTo>
                  <a:pt x="255518" y="1010465"/>
                  <a:pt x="249355" y="1024960"/>
                  <a:pt x="245206" y="1031875"/>
                </a:cubicBezTo>
                <a:cubicBezTo>
                  <a:pt x="239316" y="1041691"/>
                  <a:pt x="232506" y="1050925"/>
                  <a:pt x="226156" y="1060450"/>
                </a:cubicBezTo>
                <a:lnTo>
                  <a:pt x="219806" y="1069975"/>
                </a:lnTo>
                <a:cubicBezTo>
                  <a:pt x="218748" y="1089025"/>
                  <a:pt x="219209" y="1108221"/>
                  <a:pt x="216631" y="1127125"/>
                </a:cubicBezTo>
                <a:cubicBezTo>
                  <a:pt x="215992" y="1131815"/>
                  <a:pt x="213628" y="1136478"/>
                  <a:pt x="210281" y="1139825"/>
                </a:cubicBezTo>
                <a:cubicBezTo>
                  <a:pt x="190499" y="1159607"/>
                  <a:pt x="196069" y="1146348"/>
                  <a:pt x="178531" y="1158875"/>
                </a:cubicBezTo>
                <a:cubicBezTo>
                  <a:pt x="169884" y="1165052"/>
                  <a:pt x="168458" y="1169803"/>
                  <a:pt x="162656" y="1177925"/>
                </a:cubicBezTo>
                <a:cubicBezTo>
                  <a:pt x="139149" y="1210834"/>
                  <a:pt x="169627" y="1165881"/>
                  <a:pt x="140431" y="1209675"/>
                </a:cubicBezTo>
                <a:lnTo>
                  <a:pt x="127731" y="1228725"/>
                </a:lnTo>
                <a:cubicBezTo>
                  <a:pt x="125614" y="1231900"/>
                  <a:pt x="122588" y="1234630"/>
                  <a:pt x="121381" y="1238250"/>
                </a:cubicBezTo>
                <a:cubicBezTo>
                  <a:pt x="120323" y="1241425"/>
                  <a:pt x="119831" y="1244849"/>
                  <a:pt x="118206" y="1247775"/>
                </a:cubicBezTo>
                <a:cubicBezTo>
                  <a:pt x="114500" y="1254446"/>
                  <a:pt x="107919" y="1259585"/>
                  <a:pt x="105506" y="1266825"/>
                </a:cubicBezTo>
                <a:cubicBezTo>
                  <a:pt x="103389" y="1273175"/>
                  <a:pt x="103889" y="1281142"/>
                  <a:pt x="99156" y="1285875"/>
                </a:cubicBezTo>
                <a:cubicBezTo>
                  <a:pt x="92134" y="1292897"/>
                  <a:pt x="87701" y="1296084"/>
                  <a:pt x="83281" y="1304925"/>
                </a:cubicBezTo>
                <a:cubicBezTo>
                  <a:pt x="78116" y="1315254"/>
                  <a:pt x="82855" y="1314876"/>
                  <a:pt x="73756" y="1323975"/>
                </a:cubicBezTo>
                <a:cubicBezTo>
                  <a:pt x="71058" y="1326673"/>
                  <a:pt x="67406" y="1328208"/>
                  <a:pt x="64231" y="1330325"/>
                </a:cubicBezTo>
                <a:cubicBezTo>
                  <a:pt x="58677" y="1352541"/>
                  <a:pt x="65469" y="1334630"/>
                  <a:pt x="51531" y="1352550"/>
                </a:cubicBezTo>
                <a:cubicBezTo>
                  <a:pt x="46846" y="1358574"/>
                  <a:pt x="44227" y="1366204"/>
                  <a:pt x="38831" y="1371600"/>
                </a:cubicBezTo>
                <a:cubicBezTo>
                  <a:pt x="34598" y="1375833"/>
                  <a:pt x="30027" y="1379754"/>
                  <a:pt x="26131" y="1384300"/>
                </a:cubicBezTo>
                <a:cubicBezTo>
                  <a:pt x="-391" y="1415242"/>
                  <a:pt x="43285" y="1370321"/>
                  <a:pt x="10256" y="1403350"/>
                </a:cubicBezTo>
                <a:cubicBezTo>
                  <a:pt x="9198" y="1406525"/>
                  <a:pt x="8578" y="1409882"/>
                  <a:pt x="7081" y="1412875"/>
                </a:cubicBezTo>
                <a:cubicBezTo>
                  <a:pt x="5374" y="1416288"/>
                  <a:pt x="1271" y="1418622"/>
                  <a:pt x="731" y="1422400"/>
                </a:cubicBezTo>
                <a:cubicBezTo>
                  <a:pt x="-915" y="1433925"/>
                  <a:pt x="731" y="1445683"/>
                  <a:pt x="731" y="1457325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7244870"/>
              </p:ext>
            </p:extLst>
          </p:nvPr>
        </p:nvGraphicFramePr>
        <p:xfrm>
          <a:off x="8965484" y="739897"/>
          <a:ext cx="3047294" cy="27825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9" r:id="rId11" imgW="2686252" imgH="2453009" progId="Prism9.Document">
                  <p:embed/>
                </p:oleObj>
              </mc:Choice>
              <mc:Fallback>
                <p:oleObj name="Prism 9" r:id="rId11" imgW="2686252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965484" y="739897"/>
                        <a:ext cx="3047294" cy="27825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B39AA4A9-E297-4FAB-8F74-E18506A2214B}"/>
              </a:ext>
            </a:extLst>
          </p:cNvPr>
          <p:cNvSpPr txBox="1"/>
          <p:nvPr/>
        </p:nvSpPr>
        <p:spPr>
          <a:xfrm rot="18680067">
            <a:off x="7834197" y="3822581"/>
            <a:ext cx="23801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 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7DAF91DD-4054-446E-BBE2-24D50122F8A2}"/>
              </a:ext>
            </a:extLst>
          </p:cNvPr>
          <p:cNvSpPr txBox="1"/>
          <p:nvPr/>
        </p:nvSpPr>
        <p:spPr>
          <a:xfrm rot="18680067">
            <a:off x="8077899" y="3967303"/>
            <a:ext cx="27658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bbistati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0656F4B1-C620-469C-BE7E-F138361FF136}"/>
              </a:ext>
            </a:extLst>
          </p:cNvPr>
          <p:cNvSpPr txBox="1"/>
          <p:nvPr/>
        </p:nvSpPr>
        <p:spPr>
          <a:xfrm rot="18654558">
            <a:off x="9845367" y="3724180"/>
            <a:ext cx="22451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1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bbistati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4B1B9706-269D-4DE1-AD24-794C9F9BC775}"/>
              </a:ext>
            </a:extLst>
          </p:cNvPr>
          <p:cNvSpPr txBox="1"/>
          <p:nvPr/>
        </p:nvSpPr>
        <p:spPr>
          <a:xfrm rot="18680067">
            <a:off x="9135332" y="3724182"/>
            <a:ext cx="22902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sgRNA1, 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9753487" y="1364710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sym typeface="Symbol" panose="05050102010706020507" pitchFamily="18" charset="2"/>
              </a:rPr>
              <a:t>***</a:t>
            </a:r>
            <a:endParaRPr lang="en-US" dirty="0"/>
          </a:p>
        </p:txBody>
      </p:sp>
      <p:sp>
        <p:nvSpPr>
          <p:cNvPr id="46" name="Rectangle 45"/>
          <p:cNvSpPr/>
          <p:nvPr/>
        </p:nvSpPr>
        <p:spPr>
          <a:xfrm>
            <a:off x="10715054" y="995378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sym typeface="Symbol" panose="05050102010706020507" pitchFamily="18" charset="2"/>
              </a:rPr>
              <a:t>***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698280" y="5429899"/>
            <a:ext cx="1085799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nhibition of NM-II reverses the accelerated wound healing in P-cadherin deficient IEC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nolayers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d P-cadherin knockout HCA-7 cell monolayers were wounded and allowed to migrate in the presence of either vehicle, or the NM-II inhibitor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blebbistati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(50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). Representative pictures of wounded monolayers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and quantification of wound closure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are shown. Mean ± SE (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 = 4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;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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0.005, Scale bar, 100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 The results are representative of two </a:t>
            </a:r>
            <a:r>
              <a:rPr lang="en-US" sz="1600" smtClean="0">
                <a:latin typeface="Arial" panose="020B0604020202020204" pitchFamily="34" charset="0"/>
                <a:cs typeface="Arial" panose="020B0604020202020204" pitchFamily="34" charset="0"/>
              </a:rPr>
              <a:t>independent experiment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 Box 26"/>
          <p:cNvSpPr txBox="1">
            <a:spLocks noChangeAspect="1" noChangeArrowheads="1"/>
          </p:cNvSpPr>
          <p:nvPr/>
        </p:nvSpPr>
        <p:spPr bwMode="auto">
          <a:xfrm>
            <a:off x="354788" y="44090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</a:p>
        </p:txBody>
      </p:sp>
      <p:sp>
        <p:nvSpPr>
          <p:cNvPr id="52" name="Text Box 26"/>
          <p:cNvSpPr txBox="1">
            <a:spLocks noChangeAspect="1" noChangeArrowheads="1"/>
          </p:cNvSpPr>
          <p:nvPr/>
        </p:nvSpPr>
        <p:spPr bwMode="auto">
          <a:xfrm>
            <a:off x="8852524" y="44090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A645033B-5819-47EA-83EE-23E6E51E464B}"/>
              </a:ext>
            </a:extLst>
          </p:cNvPr>
          <p:cNvSpPr txBox="1"/>
          <p:nvPr/>
        </p:nvSpPr>
        <p:spPr>
          <a:xfrm rot="16200000">
            <a:off x="7625441" y="1767407"/>
            <a:ext cx="24613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Wound closure (%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 rot="60000" flipV="1">
            <a:off x="9822622" y="1705414"/>
            <a:ext cx="416014" cy="1161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rot="60000" flipV="1">
            <a:off x="10772505" y="1333528"/>
            <a:ext cx="416014" cy="1161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Freeform 14"/>
          <p:cNvSpPr/>
          <p:nvPr/>
        </p:nvSpPr>
        <p:spPr>
          <a:xfrm>
            <a:off x="6886575" y="2820116"/>
            <a:ext cx="311944" cy="1447800"/>
          </a:xfrm>
          <a:custGeom>
            <a:avLst/>
            <a:gdLst>
              <a:gd name="connsiteX0" fmla="*/ 295275 w 311944"/>
              <a:gd name="connsiteY0" fmla="*/ 0 h 1447800"/>
              <a:gd name="connsiteX1" fmla="*/ 307181 w 311944"/>
              <a:gd name="connsiteY1" fmla="*/ 9525 h 1447800"/>
              <a:gd name="connsiteX2" fmla="*/ 311944 w 311944"/>
              <a:gd name="connsiteY2" fmla="*/ 28575 h 1447800"/>
              <a:gd name="connsiteX3" fmla="*/ 297656 w 311944"/>
              <a:gd name="connsiteY3" fmla="*/ 80963 h 1447800"/>
              <a:gd name="connsiteX4" fmla="*/ 292894 w 311944"/>
              <a:gd name="connsiteY4" fmla="*/ 88106 h 1447800"/>
              <a:gd name="connsiteX5" fmla="*/ 278606 w 311944"/>
              <a:gd name="connsiteY5" fmla="*/ 102394 h 1447800"/>
              <a:gd name="connsiteX6" fmla="*/ 271463 w 311944"/>
              <a:gd name="connsiteY6" fmla="*/ 109538 h 1447800"/>
              <a:gd name="connsiteX7" fmla="*/ 269081 w 311944"/>
              <a:gd name="connsiteY7" fmla="*/ 116681 h 1447800"/>
              <a:gd name="connsiteX8" fmla="*/ 264319 w 311944"/>
              <a:gd name="connsiteY8" fmla="*/ 123825 h 1447800"/>
              <a:gd name="connsiteX9" fmla="*/ 261938 w 311944"/>
              <a:gd name="connsiteY9" fmla="*/ 135731 h 1447800"/>
              <a:gd name="connsiteX10" fmla="*/ 257175 w 311944"/>
              <a:gd name="connsiteY10" fmla="*/ 230981 h 1447800"/>
              <a:gd name="connsiteX11" fmla="*/ 254794 w 311944"/>
              <a:gd name="connsiteY11" fmla="*/ 247650 h 1447800"/>
              <a:gd name="connsiteX12" fmla="*/ 247650 w 311944"/>
              <a:gd name="connsiteY12" fmla="*/ 264319 h 1447800"/>
              <a:gd name="connsiteX13" fmla="*/ 240506 w 311944"/>
              <a:gd name="connsiteY13" fmla="*/ 269081 h 1447800"/>
              <a:gd name="connsiteX14" fmla="*/ 238125 w 311944"/>
              <a:gd name="connsiteY14" fmla="*/ 276225 h 1447800"/>
              <a:gd name="connsiteX15" fmla="*/ 228600 w 311944"/>
              <a:gd name="connsiteY15" fmla="*/ 290513 h 1447800"/>
              <a:gd name="connsiteX16" fmla="*/ 219075 w 311944"/>
              <a:gd name="connsiteY16" fmla="*/ 311944 h 1447800"/>
              <a:gd name="connsiteX17" fmla="*/ 216694 w 311944"/>
              <a:gd name="connsiteY17" fmla="*/ 326231 h 1447800"/>
              <a:gd name="connsiteX18" fmla="*/ 214313 w 311944"/>
              <a:gd name="connsiteY18" fmla="*/ 333375 h 1447800"/>
              <a:gd name="connsiteX19" fmla="*/ 216694 w 311944"/>
              <a:gd name="connsiteY19" fmla="*/ 361950 h 1447800"/>
              <a:gd name="connsiteX20" fmla="*/ 226219 w 311944"/>
              <a:gd name="connsiteY20" fmla="*/ 376238 h 1447800"/>
              <a:gd name="connsiteX21" fmla="*/ 228600 w 311944"/>
              <a:gd name="connsiteY21" fmla="*/ 385763 h 1447800"/>
              <a:gd name="connsiteX22" fmla="*/ 233363 w 311944"/>
              <a:gd name="connsiteY22" fmla="*/ 392906 h 1447800"/>
              <a:gd name="connsiteX23" fmla="*/ 228600 w 311944"/>
              <a:gd name="connsiteY23" fmla="*/ 419100 h 1447800"/>
              <a:gd name="connsiteX24" fmla="*/ 221456 w 311944"/>
              <a:gd name="connsiteY24" fmla="*/ 426244 h 1447800"/>
              <a:gd name="connsiteX25" fmla="*/ 211931 w 311944"/>
              <a:gd name="connsiteY25" fmla="*/ 440531 h 1447800"/>
              <a:gd name="connsiteX26" fmla="*/ 207169 w 311944"/>
              <a:gd name="connsiteY26" fmla="*/ 447675 h 1447800"/>
              <a:gd name="connsiteX27" fmla="*/ 200025 w 311944"/>
              <a:gd name="connsiteY27" fmla="*/ 464344 h 1447800"/>
              <a:gd name="connsiteX28" fmla="*/ 197644 w 311944"/>
              <a:gd name="connsiteY28" fmla="*/ 473869 h 1447800"/>
              <a:gd name="connsiteX29" fmla="*/ 192881 w 311944"/>
              <a:gd name="connsiteY29" fmla="*/ 490538 h 1447800"/>
              <a:gd name="connsiteX30" fmla="*/ 197644 w 311944"/>
              <a:gd name="connsiteY30" fmla="*/ 514350 h 1447800"/>
              <a:gd name="connsiteX31" fmla="*/ 204788 w 311944"/>
              <a:gd name="connsiteY31" fmla="*/ 521494 h 1447800"/>
              <a:gd name="connsiteX32" fmla="*/ 214313 w 311944"/>
              <a:gd name="connsiteY32" fmla="*/ 535781 h 1447800"/>
              <a:gd name="connsiteX33" fmla="*/ 219075 w 311944"/>
              <a:gd name="connsiteY33" fmla="*/ 542925 h 1447800"/>
              <a:gd name="connsiteX34" fmla="*/ 226219 w 311944"/>
              <a:gd name="connsiteY34" fmla="*/ 557213 h 1447800"/>
              <a:gd name="connsiteX35" fmla="*/ 230981 w 311944"/>
              <a:gd name="connsiteY35" fmla="*/ 592931 h 1447800"/>
              <a:gd name="connsiteX36" fmla="*/ 238125 w 311944"/>
              <a:gd name="connsiteY36" fmla="*/ 607219 h 1447800"/>
              <a:gd name="connsiteX37" fmla="*/ 240506 w 311944"/>
              <a:gd name="connsiteY37" fmla="*/ 614363 h 1447800"/>
              <a:gd name="connsiteX38" fmla="*/ 235744 w 311944"/>
              <a:gd name="connsiteY38" fmla="*/ 657225 h 1447800"/>
              <a:gd name="connsiteX39" fmla="*/ 230981 w 311944"/>
              <a:gd name="connsiteY39" fmla="*/ 671513 h 1447800"/>
              <a:gd name="connsiteX40" fmla="*/ 226219 w 311944"/>
              <a:gd name="connsiteY40" fmla="*/ 678656 h 1447800"/>
              <a:gd name="connsiteX41" fmla="*/ 223838 w 311944"/>
              <a:gd name="connsiteY41" fmla="*/ 685800 h 1447800"/>
              <a:gd name="connsiteX42" fmla="*/ 221456 w 311944"/>
              <a:gd name="connsiteY42" fmla="*/ 700088 h 1447800"/>
              <a:gd name="connsiteX43" fmla="*/ 216694 w 311944"/>
              <a:gd name="connsiteY43" fmla="*/ 711994 h 1447800"/>
              <a:gd name="connsiteX44" fmla="*/ 211931 w 311944"/>
              <a:gd name="connsiteY44" fmla="*/ 735806 h 1447800"/>
              <a:gd name="connsiteX45" fmla="*/ 209550 w 311944"/>
              <a:gd name="connsiteY45" fmla="*/ 742950 h 1447800"/>
              <a:gd name="connsiteX46" fmla="*/ 200025 w 311944"/>
              <a:gd name="connsiteY46" fmla="*/ 757238 h 1447800"/>
              <a:gd name="connsiteX47" fmla="*/ 195263 w 311944"/>
              <a:gd name="connsiteY47" fmla="*/ 764381 h 1447800"/>
              <a:gd name="connsiteX48" fmla="*/ 188119 w 311944"/>
              <a:gd name="connsiteY48" fmla="*/ 771525 h 1447800"/>
              <a:gd name="connsiteX49" fmla="*/ 180975 w 311944"/>
              <a:gd name="connsiteY49" fmla="*/ 785813 h 1447800"/>
              <a:gd name="connsiteX50" fmla="*/ 176213 w 311944"/>
              <a:gd name="connsiteY50" fmla="*/ 800100 h 1447800"/>
              <a:gd name="connsiteX51" fmla="*/ 173831 w 311944"/>
              <a:gd name="connsiteY51" fmla="*/ 807244 h 1447800"/>
              <a:gd name="connsiteX52" fmla="*/ 166688 w 311944"/>
              <a:gd name="connsiteY52" fmla="*/ 831056 h 1447800"/>
              <a:gd name="connsiteX53" fmla="*/ 164306 w 311944"/>
              <a:gd name="connsiteY53" fmla="*/ 850106 h 1447800"/>
              <a:gd name="connsiteX54" fmla="*/ 161925 w 311944"/>
              <a:gd name="connsiteY54" fmla="*/ 866775 h 1447800"/>
              <a:gd name="connsiteX55" fmla="*/ 157163 w 311944"/>
              <a:gd name="connsiteY55" fmla="*/ 904875 h 1447800"/>
              <a:gd name="connsiteX56" fmla="*/ 150019 w 311944"/>
              <a:gd name="connsiteY56" fmla="*/ 935831 h 1447800"/>
              <a:gd name="connsiteX57" fmla="*/ 152400 w 311944"/>
              <a:gd name="connsiteY57" fmla="*/ 1000125 h 1447800"/>
              <a:gd name="connsiteX58" fmla="*/ 157163 w 311944"/>
              <a:gd name="connsiteY58" fmla="*/ 1014413 h 1447800"/>
              <a:gd name="connsiteX59" fmla="*/ 159544 w 311944"/>
              <a:gd name="connsiteY59" fmla="*/ 1021556 h 1447800"/>
              <a:gd name="connsiteX60" fmla="*/ 161925 w 311944"/>
              <a:gd name="connsiteY60" fmla="*/ 1028700 h 1447800"/>
              <a:gd name="connsiteX61" fmla="*/ 166688 w 311944"/>
              <a:gd name="connsiteY61" fmla="*/ 1038225 h 1447800"/>
              <a:gd name="connsiteX62" fmla="*/ 176213 w 311944"/>
              <a:gd name="connsiteY62" fmla="*/ 1059656 h 1447800"/>
              <a:gd name="connsiteX63" fmla="*/ 183356 w 311944"/>
              <a:gd name="connsiteY63" fmla="*/ 1085850 h 1447800"/>
              <a:gd name="connsiteX64" fmla="*/ 188119 w 311944"/>
              <a:gd name="connsiteY64" fmla="*/ 1104900 h 1447800"/>
              <a:gd name="connsiteX65" fmla="*/ 188119 w 311944"/>
              <a:gd name="connsiteY65" fmla="*/ 1152525 h 1447800"/>
              <a:gd name="connsiteX66" fmla="*/ 183356 w 311944"/>
              <a:gd name="connsiteY66" fmla="*/ 1159669 h 1447800"/>
              <a:gd name="connsiteX67" fmla="*/ 176213 w 311944"/>
              <a:gd name="connsiteY67" fmla="*/ 1162050 h 1447800"/>
              <a:gd name="connsiteX68" fmla="*/ 164306 w 311944"/>
              <a:gd name="connsiteY68" fmla="*/ 1173956 h 1447800"/>
              <a:gd name="connsiteX69" fmla="*/ 159544 w 311944"/>
              <a:gd name="connsiteY69" fmla="*/ 1188244 h 1447800"/>
              <a:gd name="connsiteX70" fmla="*/ 145256 w 311944"/>
              <a:gd name="connsiteY70" fmla="*/ 1209675 h 1447800"/>
              <a:gd name="connsiteX71" fmla="*/ 140494 w 311944"/>
              <a:gd name="connsiteY71" fmla="*/ 1216819 h 1447800"/>
              <a:gd name="connsiteX72" fmla="*/ 138113 w 311944"/>
              <a:gd name="connsiteY72" fmla="*/ 1223963 h 1447800"/>
              <a:gd name="connsiteX73" fmla="*/ 128588 w 311944"/>
              <a:gd name="connsiteY73" fmla="*/ 1238250 h 1447800"/>
              <a:gd name="connsiteX74" fmla="*/ 126206 w 311944"/>
              <a:gd name="connsiteY74" fmla="*/ 1245394 h 1447800"/>
              <a:gd name="connsiteX75" fmla="*/ 119063 w 311944"/>
              <a:gd name="connsiteY75" fmla="*/ 1250156 h 1447800"/>
              <a:gd name="connsiteX76" fmla="*/ 116681 w 311944"/>
              <a:gd name="connsiteY76" fmla="*/ 1259681 h 1447800"/>
              <a:gd name="connsiteX77" fmla="*/ 111919 w 311944"/>
              <a:gd name="connsiteY77" fmla="*/ 1281113 h 1447800"/>
              <a:gd name="connsiteX78" fmla="*/ 107156 w 311944"/>
              <a:gd name="connsiteY78" fmla="*/ 1288256 h 1447800"/>
              <a:gd name="connsiteX79" fmla="*/ 102394 w 311944"/>
              <a:gd name="connsiteY79" fmla="*/ 1302544 h 1447800"/>
              <a:gd name="connsiteX80" fmla="*/ 88106 w 311944"/>
              <a:gd name="connsiteY80" fmla="*/ 1316831 h 1447800"/>
              <a:gd name="connsiteX81" fmla="*/ 73819 w 311944"/>
              <a:gd name="connsiteY81" fmla="*/ 1326356 h 1447800"/>
              <a:gd name="connsiteX82" fmla="*/ 66675 w 311944"/>
              <a:gd name="connsiteY82" fmla="*/ 1328738 h 1447800"/>
              <a:gd name="connsiteX83" fmla="*/ 59531 w 311944"/>
              <a:gd name="connsiteY83" fmla="*/ 1333500 h 1447800"/>
              <a:gd name="connsiteX84" fmla="*/ 50006 w 311944"/>
              <a:gd name="connsiteY84" fmla="*/ 1338263 h 1447800"/>
              <a:gd name="connsiteX85" fmla="*/ 42863 w 311944"/>
              <a:gd name="connsiteY85" fmla="*/ 1388269 h 1447800"/>
              <a:gd name="connsiteX86" fmla="*/ 30956 w 311944"/>
              <a:gd name="connsiteY86" fmla="*/ 1400175 h 1447800"/>
              <a:gd name="connsiteX87" fmla="*/ 16669 w 311944"/>
              <a:gd name="connsiteY87" fmla="*/ 1412081 h 1447800"/>
              <a:gd name="connsiteX88" fmla="*/ 11906 w 311944"/>
              <a:gd name="connsiteY88" fmla="*/ 1426369 h 1447800"/>
              <a:gd name="connsiteX89" fmla="*/ 9525 w 311944"/>
              <a:gd name="connsiteY89" fmla="*/ 1433513 h 1447800"/>
              <a:gd name="connsiteX90" fmla="*/ 0 w 311944"/>
              <a:gd name="connsiteY90" fmla="*/ 1447800 h 1447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</a:cxnLst>
            <a:rect l="l" t="t" r="r" b="b"/>
            <a:pathLst>
              <a:path w="311944" h="1447800">
                <a:moveTo>
                  <a:pt x="295275" y="0"/>
                </a:moveTo>
                <a:cubicBezTo>
                  <a:pt x="299244" y="3175"/>
                  <a:pt x="303873" y="5666"/>
                  <a:pt x="307181" y="9525"/>
                </a:cubicBezTo>
                <a:cubicBezTo>
                  <a:pt x="309093" y="11755"/>
                  <a:pt x="311893" y="28320"/>
                  <a:pt x="311944" y="28575"/>
                </a:cubicBezTo>
                <a:cubicBezTo>
                  <a:pt x="306471" y="72354"/>
                  <a:pt x="314280" y="56026"/>
                  <a:pt x="297656" y="80963"/>
                </a:cubicBezTo>
                <a:cubicBezTo>
                  <a:pt x="296069" y="83344"/>
                  <a:pt x="294917" y="86083"/>
                  <a:pt x="292894" y="88106"/>
                </a:cubicBezTo>
                <a:lnTo>
                  <a:pt x="278606" y="102394"/>
                </a:lnTo>
                <a:lnTo>
                  <a:pt x="271463" y="109538"/>
                </a:lnTo>
                <a:cubicBezTo>
                  <a:pt x="270669" y="111919"/>
                  <a:pt x="270204" y="114436"/>
                  <a:pt x="269081" y="116681"/>
                </a:cubicBezTo>
                <a:cubicBezTo>
                  <a:pt x="267801" y="119241"/>
                  <a:pt x="265324" y="121145"/>
                  <a:pt x="264319" y="123825"/>
                </a:cubicBezTo>
                <a:cubicBezTo>
                  <a:pt x="262898" y="127615"/>
                  <a:pt x="262732" y="131762"/>
                  <a:pt x="261938" y="135731"/>
                </a:cubicBezTo>
                <a:cubicBezTo>
                  <a:pt x="260350" y="167481"/>
                  <a:pt x="259200" y="199256"/>
                  <a:pt x="257175" y="230981"/>
                </a:cubicBezTo>
                <a:cubicBezTo>
                  <a:pt x="256817" y="236582"/>
                  <a:pt x="255798" y="242128"/>
                  <a:pt x="254794" y="247650"/>
                </a:cubicBezTo>
                <a:cubicBezTo>
                  <a:pt x="253580" y="254330"/>
                  <a:pt x="252601" y="259368"/>
                  <a:pt x="247650" y="264319"/>
                </a:cubicBezTo>
                <a:cubicBezTo>
                  <a:pt x="245626" y="266343"/>
                  <a:pt x="242887" y="267494"/>
                  <a:pt x="240506" y="269081"/>
                </a:cubicBezTo>
                <a:cubicBezTo>
                  <a:pt x="239712" y="271462"/>
                  <a:pt x="239344" y="274031"/>
                  <a:pt x="238125" y="276225"/>
                </a:cubicBezTo>
                <a:cubicBezTo>
                  <a:pt x="235345" y="281229"/>
                  <a:pt x="228600" y="290513"/>
                  <a:pt x="228600" y="290513"/>
                </a:cubicBezTo>
                <a:cubicBezTo>
                  <a:pt x="222933" y="307515"/>
                  <a:pt x="226623" y="300623"/>
                  <a:pt x="219075" y="311944"/>
                </a:cubicBezTo>
                <a:cubicBezTo>
                  <a:pt x="218281" y="316706"/>
                  <a:pt x="217741" y="321518"/>
                  <a:pt x="216694" y="326231"/>
                </a:cubicBezTo>
                <a:cubicBezTo>
                  <a:pt x="216150" y="328681"/>
                  <a:pt x="214313" y="330865"/>
                  <a:pt x="214313" y="333375"/>
                </a:cubicBezTo>
                <a:cubicBezTo>
                  <a:pt x="214313" y="342933"/>
                  <a:pt x="214136" y="352741"/>
                  <a:pt x="216694" y="361950"/>
                </a:cubicBezTo>
                <a:cubicBezTo>
                  <a:pt x="218226" y="367465"/>
                  <a:pt x="226219" y="376238"/>
                  <a:pt x="226219" y="376238"/>
                </a:cubicBezTo>
                <a:cubicBezTo>
                  <a:pt x="227013" y="379413"/>
                  <a:pt x="227311" y="382755"/>
                  <a:pt x="228600" y="385763"/>
                </a:cubicBezTo>
                <a:cubicBezTo>
                  <a:pt x="229727" y="388393"/>
                  <a:pt x="233104" y="390056"/>
                  <a:pt x="233363" y="392906"/>
                </a:cubicBezTo>
                <a:cubicBezTo>
                  <a:pt x="233415" y="393481"/>
                  <a:pt x="231927" y="414109"/>
                  <a:pt x="228600" y="419100"/>
                </a:cubicBezTo>
                <a:cubicBezTo>
                  <a:pt x="226732" y="421902"/>
                  <a:pt x="223524" y="423586"/>
                  <a:pt x="221456" y="426244"/>
                </a:cubicBezTo>
                <a:cubicBezTo>
                  <a:pt x="217942" y="430762"/>
                  <a:pt x="215106" y="435769"/>
                  <a:pt x="211931" y="440531"/>
                </a:cubicBezTo>
                <a:cubicBezTo>
                  <a:pt x="210344" y="442912"/>
                  <a:pt x="208074" y="444960"/>
                  <a:pt x="207169" y="447675"/>
                </a:cubicBezTo>
                <a:cubicBezTo>
                  <a:pt x="203666" y="458187"/>
                  <a:pt x="205911" y="452574"/>
                  <a:pt x="200025" y="464344"/>
                </a:cubicBezTo>
                <a:cubicBezTo>
                  <a:pt x="199231" y="467519"/>
                  <a:pt x="198543" y="470722"/>
                  <a:pt x="197644" y="473869"/>
                </a:cubicBezTo>
                <a:cubicBezTo>
                  <a:pt x="190801" y="497823"/>
                  <a:pt x="200341" y="460709"/>
                  <a:pt x="192881" y="490538"/>
                </a:cubicBezTo>
                <a:cubicBezTo>
                  <a:pt x="193082" y="491946"/>
                  <a:pt x="194623" y="509818"/>
                  <a:pt x="197644" y="514350"/>
                </a:cubicBezTo>
                <a:cubicBezTo>
                  <a:pt x="199512" y="517152"/>
                  <a:pt x="202720" y="518836"/>
                  <a:pt x="204788" y="521494"/>
                </a:cubicBezTo>
                <a:cubicBezTo>
                  <a:pt x="208302" y="526012"/>
                  <a:pt x="211138" y="531019"/>
                  <a:pt x="214313" y="535781"/>
                </a:cubicBezTo>
                <a:cubicBezTo>
                  <a:pt x="215900" y="538162"/>
                  <a:pt x="218170" y="540210"/>
                  <a:pt x="219075" y="542925"/>
                </a:cubicBezTo>
                <a:cubicBezTo>
                  <a:pt x="222361" y="552784"/>
                  <a:pt x="220064" y="547981"/>
                  <a:pt x="226219" y="557213"/>
                </a:cubicBezTo>
                <a:cubicBezTo>
                  <a:pt x="232303" y="575465"/>
                  <a:pt x="225801" y="554082"/>
                  <a:pt x="230981" y="592931"/>
                </a:cubicBezTo>
                <a:cubicBezTo>
                  <a:pt x="232069" y="601090"/>
                  <a:pt x="234478" y="599924"/>
                  <a:pt x="238125" y="607219"/>
                </a:cubicBezTo>
                <a:cubicBezTo>
                  <a:pt x="239247" y="609464"/>
                  <a:pt x="239712" y="611982"/>
                  <a:pt x="240506" y="614363"/>
                </a:cubicBezTo>
                <a:cubicBezTo>
                  <a:pt x="239680" y="624272"/>
                  <a:pt x="238708" y="645369"/>
                  <a:pt x="235744" y="657225"/>
                </a:cubicBezTo>
                <a:cubicBezTo>
                  <a:pt x="234526" y="662095"/>
                  <a:pt x="233766" y="667336"/>
                  <a:pt x="230981" y="671513"/>
                </a:cubicBezTo>
                <a:lnTo>
                  <a:pt x="226219" y="678656"/>
                </a:lnTo>
                <a:cubicBezTo>
                  <a:pt x="225425" y="681037"/>
                  <a:pt x="224383" y="683350"/>
                  <a:pt x="223838" y="685800"/>
                </a:cubicBezTo>
                <a:cubicBezTo>
                  <a:pt x="222791" y="690513"/>
                  <a:pt x="222726" y="695430"/>
                  <a:pt x="221456" y="700088"/>
                </a:cubicBezTo>
                <a:cubicBezTo>
                  <a:pt x="220331" y="704212"/>
                  <a:pt x="217795" y="707864"/>
                  <a:pt x="216694" y="711994"/>
                </a:cubicBezTo>
                <a:cubicBezTo>
                  <a:pt x="214608" y="719815"/>
                  <a:pt x="214490" y="728127"/>
                  <a:pt x="211931" y="735806"/>
                </a:cubicBezTo>
                <a:cubicBezTo>
                  <a:pt x="211137" y="738187"/>
                  <a:pt x="210769" y="740756"/>
                  <a:pt x="209550" y="742950"/>
                </a:cubicBezTo>
                <a:cubicBezTo>
                  <a:pt x="206770" y="747954"/>
                  <a:pt x="203200" y="752475"/>
                  <a:pt x="200025" y="757238"/>
                </a:cubicBezTo>
                <a:cubicBezTo>
                  <a:pt x="198438" y="759619"/>
                  <a:pt x="197286" y="762358"/>
                  <a:pt x="195263" y="764381"/>
                </a:cubicBezTo>
                <a:lnTo>
                  <a:pt x="188119" y="771525"/>
                </a:lnTo>
                <a:cubicBezTo>
                  <a:pt x="179437" y="797574"/>
                  <a:pt x="193283" y="758121"/>
                  <a:pt x="180975" y="785813"/>
                </a:cubicBezTo>
                <a:cubicBezTo>
                  <a:pt x="178936" y="790400"/>
                  <a:pt x="177800" y="795338"/>
                  <a:pt x="176213" y="800100"/>
                </a:cubicBezTo>
                <a:lnTo>
                  <a:pt x="173831" y="807244"/>
                </a:lnTo>
                <a:cubicBezTo>
                  <a:pt x="171241" y="815012"/>
                  <a:pt x="168043" y="822928"/>
                  <a:pt x="166688" y="831056"/>
                </a:cubicBezTo>
                <a:cubicBezTo>
                  <a:pt x="165636" y="837368"/>
                  <a:pt x="165152" y="843763"/>
                  <a:pt x="164306" y="850106"/>
                </a:cubicBezTo>
                <a:cubicBezTo>
                  <a:pt x="163564" y="855669"/>
                  <a:pt x="162651" y="861209"/>
                  <a:pt x="161925" y="866775"/>
                </a:cubicBezTo>
                <a:cubicBezTo>
                  <a:pt x="160270" y="879466"/>
                  <a:pt x="159109" y="892225"/>
                  <a:pt x="157163" y="904875"/>
                </a:cubicBezTo>
                <a:cubicBezTo>
                  <a:pt x="154161" y="924390"/>
                  <a:pt x="154261" y="923104"/>
                  <a:pt x="150019" y="935831"/>
                </a:cubicBezTo>
                <a:cubicBezTo>
                  <a:pt x="150813" y="957262"/>
                  <a:pt x="150458" y="978767"/>
                  <a:pt x="152400" y="1000125"/>
                </a:cubicBezTo>
                <a:cubicBezTo>
                  <a:pt x="152855" y="1005125"/>
                  <a:pt x="155575" y="1009650"/>
                  <a:pt x="157163" y="1014413"/>
                </a:cubicBezTo>
                <a:lnTo>
                  <a:pt x="159544" y="1021556"/>
                </a:lnTo>
                <a:cubicBezTo>
                  <a:pt x="160338" y="1023937"/>
                  <a:pt x="160802" y="1026455"/>
                  <a:pt x="161925" y="1028700"/>
                </a:cubicBezTo>
                <a:cubicBezTo>
                  <a:pt x="163513" y="1031875"/>
                  <a:pt x="165370" y="1034929"/>
                  <a:pt x="166688" y="1038225"/>
                </a:cubicBezTo>
                <a:cubicBezTo>
                  <a:pt x="175189" y="1059479"/>
                  <a:pt x="167049" y="1045913"/>
                  <a:pt x="176213" y="1059656"/>
                </a:cubicBezTo>
                <a:cubicBezTo>
                  <a:pt x="182011" y="1088649"/>
                  <a:pt x="174298" y="1052638"/>
                  <a:pt x="183356" y="1085850"/>
                </a:cubicBezTo>
                <a:cubicBezTo>
                  <a:pt x="191979" y="1117465"/>
                  <a:pt x="180893" y="1083220"/>
                  <a:pt x="188119" y="1104900"/>
                </a:cubicBezTo>
                <a:cubicBezTo>
                  <a:pt x="191015" y="1125178"/>
                  <a:pt x="192678" y="1128209"/>
                  <a:pt x="188119" y="1152525"/>
                </a:cubicBezTo>
                <a:cubicBezTo>
                  <a:pt x="187592" y="1155338"/>
                  <a:pt x="185591" y="1157881"/>
                  <a:pt x="183356" y="1159669"/>
                </a:cubicBezTo>
                <a:cubicBezTo>
                  <a:pt x="181396" y="1161237"/>
                  <a:pt x="178594" y="1161256"/>
                  <a:pt x="176213" y="1162050"/>
                </a:cubicBezTo>
                <a:cubicBezTo>
                  <a:pt x="169698" y="1166394"/>
                  <a:pt x="167647" y="1166438"/>
                  <a:pt x="164306" y="1173956"/>
                </a:cubicBezTo>
                <a:cubicBezTo>
                  <a:pt x="162267" y="1178544"/>
                  <a:pt x="162329" y="1184067"/>
                  <a:pt x="159544" y="1188244"/>
                </a:cubicBezTo>
                <a:lnTo>
                  <a:pt x="145256" y="1209675"/>
                </a:lnTo>
                <a:cubicBezTo>
                  <a:pt x="143669" y="1212056"/>
                  <a:pt x="141399" y="1214104"/>
                  <a:pt x="140494" y="1216819"/>
                </a:cubicBezTo>
                <a:cubicBezTo>
                  <a:pt x="139700" y="1219200"/>
                  <a:pt x="139332" y="1221769"/>
                  <a:pt x="138113" y="1223963"/>
                </a:cubicBezTo>
                <a:cubicBezTo>
                  <a:pt x="135333" y="1228966"/>
                  <a:pt x="130398" y="1232820"/>
                  <a:pt x="128588" y="1238250"/>
                </a:cubicBezTo>
                <a:cubicBezTo>
                  <a:pt x="127794" y="1240631"/>
                  <a:pt x="127774" y="1243434"/>
                  <a:pt x="126206" y="1245394"/>
                </a:cubicBezTo>
                <a:cubicBezTo>
                  <a:pt x="124418" y="1247629"/>
                  <a:pt x="121444" y="1248569"/>
                  <a:pt x="119063" y="1250156"/>
                </a:cubicBezTo>
                <a:cubicBezTo>
                  <a:pt x="118269" y="1253331"/>
                  <a:pt x="117323" y="1256472"/>
                  <a:pt x="116681" y="1259681"/>
                </a:cubicBezTo>
                <a:cubicBezTo>
                  <a:pt x="115462" y="1265775"/>
                  <a:pt x="115008" y="1274935"/>
                  <a:pt x="111919" y="1281113"/>
                </a:cubicBezTo>
                <a:cubicBezTo>
                  <a:pt x="110639" y="1283673"/>
                  <a:pt x="108744" y="1285875"/>
                  <a:pt x="107156" y="1288256"/>
                </a:cubicBezTo>
                <a:cubicBezTo>
                  <a:pt x="105569" y="1293019"/>
                  <a:pt x="105944" y="1298994"/>
                  <a:pt x="102394" y="1302544"/>
                </a:cubicBezTo>
                <a:cubicBezTo>
                  <a:pt x="97631" y="1307306"/>
                  <a:pt x="93710" y="1313095"/>
                  <a:pt x="88106" y="1316831"/>
                </a:cubicBezTo>
                <a:cubicBezTo>
                  <a:pt x="83344" y="1320006"/>
                  <a:pt x="79249" y="1324546"/>
                  <a:pt x="73819" y="1326356"/>
                </a:cubicBezTo>
                <a:cubicBezTo>
                  <a:pt x="71438" y="1327150"/>
                  <a:pt x="68920" y="1327615"/>
                  <a:pt x="66675" y="1328738"/>
                </a:cubicBezTo>
                <a:cubicBezTo>
                  <a:pt x="64115" y="1330018"/>
                  <a:pt x="62016" y="1332080"/>
                  <a:pt x="59531" y="1333500"/>
                </a:cubicBezTo>
                <a:cubicBezTo>
                  <a:pt x="56449" y="1335261"/>
                  <a:pt x="53181" y="1336675"/>
                  <a:pt x="50006" y="1338263"/>
                </a:cubicBezTo>
                <a:cubicBezTo>
                  <a:pt x="36290" y="1358836"/>
                  <a:pt x="50483" y="1334928"/>
                  <a:pt x="42863" y="1388269"/>
                </a:cubicBezTo>
                <a:cubicBezTo>
                  <a:pt x="41919" y="1394877"/>
                  <a:pt x="35075" y="1396742"/>
                  <a:pt x="30956" y="1400175"/>
                </a:cubicBezTo>
                <a:cubicBezTo>
                  <a:pt x="12622" y="1415454"/>
                  <a:pt x="34406" y="1400258"/>
                  <a:pt x="16669" y="1412081"/>
                </a:cubicBezTo>
                <a:lnTo>
                  <a:pt x="11906" y="1426369"/>
                </a:lnTo>
                <a:cubicBezTo>
                  <a:pt x="11112" y="1428750"/>
                  <a:pt x="10917" y="1431424"/>
                  <a:pt x="9525" y="1433513"/>
                </a:cubicBezTo>
                <a:lnTo>
                  <a:pt x="0" y="1447800"/>
                </a:ln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 18"/>
          <p:cNvSpPr/>
          <p:nvPr/>
        </p:nvSpPr>
        <p:spPr>
          <a:xfrm>
            <a:off x="7805738" y="2811002"/>
            <a:ext cx="162670" cy="1471631"/>
          </a:xfrm>
          <a:custGeom>
            <a:avLst/>
            <a:gdLst>
              <a:gd name="connsiteX0" fmla="*/ 161925 w 162670"/>
              <a:gd name="connsiteY0" fmla="*/ 0 h 1457325"/>
              <a:gd name="connsiteX1" fmla="*/ 161925 w 162670"/>
              <a:gd name="connsiteY1" fmla="*/ 23813 h 1457325"/>
              <a:gd name="connsiteX2" fmla="*/ 154781 w 162670"/>
              <a:gd name="connsiteY2" fmla="*/ 80963 h 1457325"/>
              <a:gd name="connsiteX3" fmla="*/ 147637 w 162670"/>
              <a:gd name="connsiteY3" fmla="*/ 97632 h 1457325"/>
              <a:gd name="connsiteX4" fmla="*/ 140493 w 162670"/>
              <a:gd name="connsiteY4" fmla="*/ 161925 h 1457325"/>
              <a:gd name="connsiteX5" fmla="*/ 138112 w 162670"/>
              <a:gd name="connsiteY5" fmla="*/ 169069 h 1457325"/>
              <a:gd name="connsiteX6" fmla="*/ 135731 w 162670"/>
              <a:gd name="connsiteY6" fmla="*/ 178594 h 1457325"/>
              <a:gd name="connsiteX7" fmla="*/ 126206 w 162670"/>
              <a:gd name="connsiteY7" fmla="*/ 192882 h 1457325"/>
              <a:gd name="connsiteX8" fmla="*/ 116681 w 162670"/>
              <a:gd name="connsiteY8" fmla="*/ 207169 h 1457325"/>
              <a:gd name="connsiteX9" fmla="*/ 109537 w 162670"/>
              <a:gd name="connsiteY9" fmla="*/ 354807 h 1457325"/>
              <a:gd name="connsiteX10" fmla="*/ 107156 w 162670"/>
              <a:gd name="connsiteY10" fmla="*/ 371475 h 1457325"/>
              <a:gd name="connsiteX11" fmla="*/ 109537 w 162670"/>
              <a:gd name="connsiteY11" fmla="*/ 502444 h 1457325"/>
              <a:gd name="connsiteX12" fmla="*/ 111918 w 162670"/>
              <a:gd name="connsiteY12" fmla="*/ 511969 h 1457325"/>
              <a:gd name="connsiteX13" fmla="*/ 119062 w 162670"/>
              <a:gd name="connsiteY13" fmla="*/ 519113 h 1457325"/>
              <a:gd name="connsiteX14" fmla="*/ 123825 w 162670"/>
              <a:gd name="connsiteY14" fmla="*/ 526257 h 1457325"/>
              <a:gd name="connsiteX15" fmla="*/ 121443 w 162670"/>
              <a:gd name="connsiteY15" fmla="*/ 561975 h 1457325"/>
              <a:gd name="connsiteX16" fmla="*/ 119062 w 162670"/>
              <a:gd name="connsiteY16" fmla="*/ 576263 h 1457325"/>
              <a:gd name="connsiteX17" fmla="*/ 111918 w 162670"/>
              <a:gd name="connsiteY17" fmla="*/ 583407 h 1457325"/>
              <a:gd name="connsiteX18" fmla="*/ 107156 w 162670"/>
              <a:gd name="connsiteY18" fmla="*/ 590550 h 1457325"/>
              <a:gd name="connsiteX19" fmla="*/ 90487 w 162670"/>
              <a:gd name="connsiteY19" fmla="*/ 607219 h 1457325"/>
              <a:gd name="connsiteX20" fmla="*/ 80962 w 162670"/>
              <a:gd name="connsiteY20" fmla="*/ 621507 h 1457325"/>
              <a:gd name="connsiteX21" fmla="*/ 76200 w 162670"/>
              <a:gd name="connsiteY21" fmla="*/ 628650 h 1457325"/>
              <a:gd name="connsiteX22" fmla="*/ 64293 w 162670"/>
              <a:gd name="connsiteY22" fmla="*/ 647700 h 1457325"/>
              <a:gd name="connsiteX23" fmla="*/ 59531 w 162670"/>
              <a:gd name="connsiteY23" fmla="*/ 654844 h 1457325"/>
              <a:gd name="connsiteX24" fmla="*/ 54768 w 162670"/>
              <a:gd name="connsiteY24" fmla="*/ 669132 h 1457325"/>
              <a:gd name="connsiteX25" fmla="*/ 52387 w 162670"/>
              <a:gd name="connsiteY25" fmla="*/ 676275 h 1457325"/>
              <a:gd name="connsiteX26" fmla="*/ 47625 w 162670"/>
              <a:gd name="connsiteY26" fmla="*/ 704850 h 1457325"/>
              <a:gd name="connsiteX27" fmla="*/ 45243 w 162670"/>
              <a:gd name="connsiteY27" fmla="*/ 716757 h 1457325"/>
              <a:gd name="connsiteX28" fmla="*/ 40481 w 162670"/>
              <a:gd name="connsiteY28" fmla="*/ 731044 h 1457325"/>
              <a:gd name="connsiteX29" fmla="*/ 35718 w 162670"/>
              <a:gd name="connsiteY29" fmla="*/ 745332 h 1457325"/>
              <a:gd name="connsiteX30" fmla="*/ 33337 w 162670"/>
              <a:gd name="connsiteY30" fmla="*/ 752475 h 1457325"/>
              <a:gd name="connsiteX31" fmla="*/ 30956 w 162670"/>
              <a:gd name="connsiteY31" fmla="*/ 778669 h 1457325"/>
              <a:gd name="connsiteX32" fmla="*/ 33337 w 162670"/>
              <a:gd name="connsiteY32" fmla="*/ 828675 h 1457325"/>
              <a:gd name="connsiteX33" fmla="*/ 30956 w 162670"/>
              <a:gd name="connsiteY33" fmla="*/ 852488 h 1457325"/>
              <a:gd name="connsiteX34" fmla="*/ 23812 w 162670"/>
              <a:gd name="connsiteY34" fmla="*/ 881063 h 1457325"/>
              <a:gd name="connsiteX35" fmla="*/ 19050 w 162670"/>
              <a:gd name="connsiteY35" fmla="*/ 912019 h 1457325"/>
              <a:gd name="connsiteX36" fmla="*/ 14287 w 162670"/>
              <a:gd name="connsiteY36" fmla="*/ 926307 h 1457325"/>
              <a:gd name="connsiteX37" fmla="*/ 11906 w 162670"/>
              <a:gd name="connsiteY37" fmla="*/ 933450 h 1457325"/>
              <a:gd name="connsiteX38" fmla="*/ 7143 w 162670"/>
              <a:gd name="connsiteY38" fmla="*/ 942975 h 1457325"/>
              <a:gd name="connsiteX39" fmla="*/ 4762 w 162670"/>
              <a:gd name="connsiteY39" fmla="*/ 959644 h 1457325"/>
              <a:gd name="connsiteX40" fmla="*/ 0 w 162670"/>
              <a:gd name="connsiteY40" fmla="*/ 973932 h 1457325"/>
              <a:gd name="connsiteX41" fmla="*/ 2381 w 162670"/>
              <a:gd name="connsiteY41" fmla="*/ 1026319 h 1457325"/>
              <a:gd name="connsiteX42" fmla="*/ 4762 w 162670"/>
              <a:gd name="connsiteY42" fmla="*/ 1038225 h 1457325"/>
              <a:gd name="connsiteX43" fmla="*/ 7143 w 162670"/>
              <a:gd name="connsiteY43" fmla="*/ 1092994 h 1457325"/>
              <a:gd name="connsiteX44" fmla="*/ 9525 w 162670"/>
              <a:gd name="connsiteY44" fmla="*/ 1102519 h 1457325"/>
              <a:gd name="connsiteX45" fmla="*/ 14287 w 162670"/>
              <a:gd name="connsiteY45" fmla="*/ 1121569 h 1457325"/>
              <a:gd name="connsiteX46" fmla="*/ 28575 w 162670"/>
              <a:gd name="connsiteY46" fmla="*/ 1135857 h 1457325"/>
              <a:gd name="connsiteX47" fmla="*/ 38100 w 162670"/>
              <a:gd name="connsiteY47" fmla="*/ 1150144 h 1457325"/>
              <a:gd name="connsiteX48" fmla="*/ 45243 w 162670"/>
              <a:gd name="connsiteY48" fmla="*/ 1166813 h 1457325"/>
              <a:gd name="connsiteX49" fmla="*/ 57150 w 162670"/>
              <a:gd name="connsiteY49" fmla="*/ 1185863 h 1457325"/>
              <a:gd name="connsiteX50" fmla="*/ 59531 w 162670"/>
              <a:gd name="connsiteY50" fmla="*/ 1197769 h 1457325"/>
              <a:gd name="connsiteX51" fmla="*/ 64293 w 162670"/>
              <a:gd name="connsiteY51" fmla="*/ 1212057 h 1457325"/>
              <a:gd name="connsiteX52" fmla="*/ 57150 w 162670"/>
              <a:gd name="connsiteY52" fmla="*/ 1247775 h 1457325"/>
              <a:gd name="connsiteX53" fmla="*/ 47625 w 162670"/>
              <a:gd name="connsiteY53" fmla="*/ 1262063 h 1457325"/>
              <a:gd name="connsiteX54" fmla="*/ 42862 w 162670"/>
              <a:gd name="connsiteY54" fmla="*/ 1269207 h 1457325"/>
              <a:gd name="connsiteX55" fmla="*/ 42862 w 162670"/>
              <a:gd name="connsiteY55" fmla="*/ 1300163 h 1457325"/>
              <a:gd name="connsiteX56" fmla="*/ 50006 w 162670"/>
              <a:gd name="connsiteY56" fmla="*/ 1328738 h 1457325"/>
              <a:gd name="connsiteX57" fmla="*/ 54768 w 162670"/>
              <a:gd name="connsiteY57" fmla="*/ 1338263 h 1457325"/>
              <a:gd name="connsiteX58" fmla="*/ 59531 w 162670"/>
              <a:gd name="connsiteY58" fmla="*/ 1373982 h 1457325"/>
              <a:gd name="connsiteX59" fmla="*/ 61912 w 162670"/>
              <a:gd name="connsiteY59" fmla="*/ 1381125 h 1457325"/>
              <a:gd name="connsiteX60" fmla="*/ 64293 w 162670"/>
              <a:gd name="connsiteY60" fmla="*/ 1400175 h 1457325"/>
              <a:gd name="connsiteX61" fmla="*/ 69056 w 162670"/>
              <a:gd name="connsiteY61" fmla="*/ 1419225 h 1457325"/>
              <a:gd name="connsiteX62" fmla="*/ 69056 w 162670"/>
              <a:gd name="connsiteY62" fmla="*/ 1457325 h 14573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</a:cxnLst>
            <a:rect l="l" t="t" r="r" b="b"/>
            <a:pathLst>
              <a:path w="162670" h="1457325">
                <a:moveTo>
                  <a:pt x="161925" y="0"/>
                </a:moveTo>
                <a:cubicBezTo>
                  <a:pt x="155573" y="31753"/>
                  <a:pt x="161925" y="-7938"/>
                  <a:pt x="161925" y="23813"/>
                </a:cubicBezTo>
                <a:cubicBezTo>
                  <a:pt x="161925" y="103595"/>
                  <a:pt x="166079" y="50831"/>
                  <a:pt x="154781" y="80963"/>
                </a:cubicBezTo>
                <a:cubicBezTo>
                  <a:pt x="148192" y="98535"/>
                  <a:pt x="157288" y="83156"/>
                  <a:pt x="147637" y="97632"/>
                </a:cubicBezTo>
                <a:cubicBezTo>
                  <a:pt x="138885" y="123889"/>
                  <a:pt x="147949" y="94819"/>
                  <a:pt x="140493" y="161925"/>
                </a:cubicBezTo>
                <a:cubicBezTo>
                  <a:pt x="140216" y="164420"/>
                  <a:pt x="138802" y="166655"/>
                  <a:pt x="138112" y="169069"/>
                </a:cubicBezTo>
                <a:cubicBezTo>
                  <a:pt x="137213" y="172216"/>
                  <a:pt x="137195" y="175667"/>
                  <a:pt x="135731" y="178594"/>
                </a:cubicBezTo>
                <a:cubicBezTo>
                  <a:pt x="133171" y="183714"/>
                  <a:pt x="128016" y="187452"/>
                  <a:pt x="126206" y="192882"/>
                </a:cubicBezTo>
                <a:cubicBezTo>
                  <a:pt x="122760" y="203220"/>
                  <a:pt x="125600" y="198250"/>
                  <a:pt x="116681" y="207169"/>
                </a:cubicBezTo>
                <a:cubicBezTo>
                  <a:pt x="105230" y="264430"/>
                  <a:pt x="116594" y="204271"/>
                  <a:pt x="109537" y="354807"/>
                </a:cubicBezTo>
                <a:cubicBezTo>
                  <a:pt x="109274" y="360413"/>
                  <a:pt x="107950" y="365919"/>
                  <a:pt x="107156" y="371475"/>
                </a:cubicBezTo>
                <a:cubicBezTo>
                  <a:pt x="107950" y="415131"/>
                  <a:pt x="108058" y="458806"/>
                  <a:pt x="109537" y="502444"/>
                </a:cubicBezTo>
                <a:cubicBezTo>
                  <a:pt x="109648" y="505715"/>
                  <a:pt x="110294" y="509127"/>
                  <a:pt x="111918" y="511969"/>
                </a:cubicBezTo>
                <a:cubicBezTo>
                  <a:pt x="113589" y="514893"/>
                  <a:pt x="116906" y="516526"/>
                  <a:pt x="119062" y="519113"/>
                </a:cubicBezTo>
                <a:cubicBezTo>
                  <a:pt x="120894" y="521312"/>
                  <a:pt x="122237" y="523876"/>
                  <a:pt x="123825" y="526257"/>
                </a:cubicBezTo>
                <a:cubicBezTo>
                  <a:pt x="123031" y="538163"/>
                  <a:pt x="122574" y="550096"/>
                  <a:pt x="121443" y="561975"/>
                </a:cubicBezTo>
                <a:cubicBezTo>
                  <a:pt x="120985" y="566782"/>
                  <a:pt x="121023" y="571851"/>
                  <a:pt x="119062" y="576263"/>
                </a:cubicBezTo>
                <a:cubicBezTo>
                  <a:pt x="117694" y="579340"/>
                  <a:pt x="114074" y="580820"/>
                  <a:pt x="111918" y="583407"/>
                </a:cubicBezTo>
                <a:cubicBezTo>
                  <a:pt x="110086" y="585605"/>
                  <a:pt x="109070" y="588423"/>
                  <a:pt x="107156" y="590550"/>
                </a:cubicBezTo>
                <a:cubicBezTo>
                  <a:pt x="101899" y="596391"/>
                  <a:pt x="94846" y="600681"/>
                  <a:pt x="90487" y="607219"/>
                </a:cubicBezTo>
                <a:lnTo>
                  <a:pt x="80962" y="621507"/>
                </a:lnTo>
                <a:cubicBezTo>
                  <a:pt x="79375" y="623888"/>
                  <a:pt x="77917" y="626361"/>
                  <a:pt x="76200" y="628650"/>
                </a:cubicBezTo>
                <a:cubicBezTo>
                  <a:pt x="62545" y="646856"/>
                  <a:pt x="74749" y="629401"/>
                  <a:pt x="64293" y="647700"/>
                </a:cubicBezTo>
                <a:cubicBezTo>
                  <a:pt x="62873" y="650185"/>
                  <a:pt x="60693" y="652229"/>
                  <a:pt x="59531" y="654844"/>
                </a:cubicBezTo>
                <a:cubicBezTo>
                  <a:pt x="57492" y="659432"/>
                  <a:pt x="56356" y="664369"/>
                  <a:pt x="54768" y="669132"/>
                </a:cubicBezTo>
                <a:lnTo>
                  <a:pt x="52387" y="676275"/>
                </a:lnTo>
                <a:cubicBezTo>
                  <a:pt x="50800" y="685800"/>
                  <a:pt x="49303" y="695341"/>
                  <a:pt x="47625" y="704850"/>
                </a:cubicBezTo>
                <a:cubicBezTo>
                  <a:pt x="46922" y="708836"/>
                  <a:pt x="46308" y="712852"/>
                  <a:pt x="45243" y="716757"/>
                </a:cubicBezTo>
                <a:cubicBezTo>
                  <a:pt x="43922" y="721600"/>
                  <a:pt x="42068" y="726282"/>
                  <a:pt x="40481" y="731044"/>
                </a:cubicBezTo>
                <a:lnTo>
                  <a:pt x="35718" y="745332"/>
                </a:lnTo>
                <a:lnTo>
                  <a:pt x="33337" y="752475"/>
                </a:lnTo>
                <a:cubicBezTo>
                  <a:pt x="32543" y="761206"/>
                  <a:pt x="30956" y="769902"/>
                  <a:pt x="30956" y="778669"/>
                </a:cubicBezTo>
                <a:cubicBezTo>
                  <a:pt x="30956" y="795357"/>
                  <a:pt x="33337" y="811987"/>
                  <a:pt x="33337" y="828675"/>
                </a:cubicBezTo>
                <a:cubicBezTo>
                  <a:pt x="33337" y="836652"/>
                  <a:pt x="32010" y="844581"/>
                  <a:pt x="30956" y="852488"/>
                </a:cubicBezTo>
                <a:cubicBezTo>
                  <a:pt x="29660" y="862206"/>
                  <a:pt x="26902" y="871791"/>
                  <a:pt x="23812" y="881063"/>
                </a:cubicBezTo>
                <a:cubicBezTo>
                  <a:pt x="23309" y="884587"/>
                  <a:pt x="20151" y="907614"/>
                  <a:pt x="19050" y="912019"/>
                </a:cubicBezTo>
                <a:cubicBezTo>
                  <a:pt x="17832" y="916889"/>
                  <a:pt x="15875" y="921544"/>
                  <a:pt x="14287" y="926307"/>
                </a:cubicBezTo>
                <a:cubicBezTo>
                  <a:pt x="13493" y="928688"/>
                  <a:pt x="13029" y="931205"/>
                  <a:pt x="11906" y="933450"/>
                </a:cubicBezTo>
                <a:lnTo>
                  <a:pt x="7143" y="942975"/>
                </a:lnTo>
                <a:cubicBezTo>
                  <a:pt x="6349" y="948531"/>
                  <a:pt x="6024" y="954175"/>
                  <a:pt x="4762" y="959644"/>
                </a:cubicBezTo>
                <a:cubicBezTo>
                  <a:pt x="3633" y="964536"/>
                  <a:pt x="0" y="973932"/>
                  <a:pt x="0" y="973932"/>
                </a:cubicBezTo>
                <a:cubicBezTo>
                  <a:pt x="794" y="991394"/>
                  <a:pt x="1090" y="1008886"/>
                  <a:pt x="2381" y="1026319"/>
                </a:cubicBezTo>
                <a:cubicBezTo>
                  <a:pt x="2680" y="1030355"/>
                  <a:pt x="4474" y="1034188"/>
                  <a:pt x="4762" y="1038225"/>
                </a:cubicBezTo>
                <a:cubicBezTo>
                  <a:pt x="6064" y="1056452"/>
                  <a:pt x="5793" y="1074770"/>
                  <a:pt x="7143" y="1092994"/>
                </a:cubicBezTo>
                <a:cubicBezTo>
                  <a:pt x="7385" y="1096258"/>
                  <a:pt x="8815" y="1099324"/>
                  <a:pt x="9525" y="1102519"/>
                </a:cubicBezTo>
                <a:cubicBezTo>
                  <a:pt x="9697" y="1103292"/>
                  <a:pt x="12302" y="1119016"/>
                  <a:pt x="14287" y="1121569"/>
                </a:cubicBezTo>
                <a:cubicBezTo>
                  <a:pt x="18422" y="1126886"/>
                  <a:pt x="24839" y="1130253"/>
                  <a:pt x="28575" y="1135857"/>
                </a:cubicBezTo>
                <a:lnTo>
                  <a:pt x="38100" y="1150144"/>
                </a:lnTo>
                <a:cubicBezTo>
                  <a:pt x="45758" y="1173122"/>
                  <a:pt x="33483" y="1137413"/>
                  <a:pt x="45243" y="1166813"/>
                </a:cubicBezTo>
                <a:cubicBezTo>
                  <a:pt x="52456" y="1184845"/>
                  <a:pt x="44948" y="1177728"/>
                  <a:pt x="57150" y="1185863"/>
                </a:cubicBezTo>
                <a:cubicBezTo>
                  <a:pt x="57944" y="1189832"/>
                  <a:pt x="58466" y="1193864"/>
                  <a:pt x="59531" y="1197769"/>
                </a:cubicBezTo>
                <a:cubicBezTo>
                  <a:pt x="60852" y="1202612"/>
                  <a:pt x="64293" y="1212057"/>
                  <a:pt x="64293" y="1212057"/>
                </a:cubicBezTo>
                <a:cubicBezTo>
                  <a:pt x="62357" y="1233358"/>
                  <a:pt x="65522" y="1233821"/>
                  <a:pt x="57150" y="1247775"/>
                </a:cubicBezTo>
                <a:cubicBezTo>
                  <a:pt x="54205" y="1252683"/>
                  <a:pt x="50800" y="1257300"/>
                  <a:pt x="47625" y="1262063"/>
                </a:cubicBezTo>
                <a:lnTo>
                  <a:pt x="42862" y="1269207"/>
                </a:lnTo>
                <a:cubicBezTo>
                  <a:pt x="38109" y="1283466"/>
                  <a:pt x="39753" y="1275288"/>
                  <a:pt x="42862" y="1300163"/>
                </a:cubicBezTo>
                <a:cubicBezTo>
                  <a:pt x="43992" y="1309202"/>
                  <a:pt x="45875" y="1320476"/>
                  <a:pt x="50006" y="1328738"/>
                </a:cubicBezTo>
                <a:lnTo>
                  <a:pt x="54768" y="1338263"/>
                </a:lnTo>
                <a:cubicBezTo>
                  <a:pt x="55914" y="1348572"/>
                  <a:pt x="57157" y="1363299"/>
                  <a:pt x="59531" y="1373982"/>
                </a:cubicBezTo>
                <a:cubicBezTo>
                  <a:pt x="60075" y="1376432"/>
                  <a:pt x="61118" y="1378744"/>
                  <a:pt x="61912" y="1381125"/>
                </a:cubicBezTo>
                <a:cubicBezTo>
                  <a:pt x="62706" y="1387475"/>
                  <a:pt x="63114" y="1393885"/>
                  <a:pt x="64293" y="1400175"/>
                </a:cubicBezTo>
                <a:cubicBezTo>
                  <a:pt x="65499" y="1406608"/>
                  <a:pt x="68512" y="1412702"/>
                  <a:pt x="69056" y="1419225"/>
                </a:cubicBezTo>
                <a:cubicBezTo>
                  <a:pt x="70111" y="1431881"/>
                  <a:pt x="69056" y="1444625"/>
                  <a:pt x="69056" y="1457325"/>
                </a:cubicBezTo>
              </a:path>
            </a:pathLst>
          </a:custGeom>
          <a:noFill/>
          <a:ln w="254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7" name="Straight Connector 56"/>
          <p:cNvCxnSpPr/>
          <p:nvPr/>
        </p:nvCxnSpPr>
        <p:spPr>
          <a:xfrm>
            <a:off x="8192264" y="4157762"/>
            <a:ext cx="187429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0304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13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Arial</vt:lpstr>
      <vt:lpstr>Calibri</vt:lpstr>
      <vt:lpstr>Calibri Light</vt:lpstr>
      <vt:lpstr>Symbol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yden Naydenov</dc:creator>
  <cp:lastModifiedBy>Ivanov, Andrei</cp:lastModifiedBy>
  <cp:revision>26</cp:revision>
  <cp:lastPrinted>2022-03-29T14:21:09Z</cp:lastPrinted>
  <dcterms:created xsi:type="dcterms:W3CDTF">2022-02-14T04:49:12Z</dcterms:created>
  <dcterms:modified xsi:type="dcterms:W3CDTF">2022-04-20T13:19:02Z</dcterms:modified>
</cp:coreProperties>
</file>